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25"/>
  </p:handoutMasterIdLst>
  <p:sldIdLst>
    <p:sldId id="299" r:id="rId2"/>
    <p:sldId id="301" r:id="rId3"/>
    <p:sldId id="272" r:id="rId4"/>
    <p:sldId id="271" r:id="rId5"/>
    <p:sldId id="269" r:id="rId6"/>
    <p:sldId id="279" r:id="rId7"/>
    <p:sldId id="297" r:id="rId8"/>
    <p:sldId id="304" r:id="rId9"/>
    <p:sldId id="282" r:id="rId10"/>
    <p:sldId id="286" r:id="rId11"/>
    <p:sldId id="283" r:id="rId12"/>
    <p:sldId id="288" r:id="rId13"/>
    <p:sldId id="281" r:id="rId14"/>
    <p:sldId id="287" r:id="rId15"/>
    <p:sldId id="284" r:id="rId16"/>
    <p:sldId id="289" r:id="rId17"/>
    <p:sldId id="285" r:id="rId18"/>
    <p:sldId id="290" r:id="rId19"/>
    <p:sldId id="293" r:id="rId20"/>
    <p:sldId id="298" r:id="rId21"/>
    <p:sldId id="291" r:id="rId22"/>
    <p:sldId id="292" r:id="rId23"/>
    <p:sldId id="305" r:id="rId2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40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0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8" d="100"/>
          <a:sy n="88" d="100"/>
        </p:scale>
        <p:origin x="3822" y="6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D4887E-62C6-4AA5-A375-02A373B963DC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EB1871-BE94-41F6-B6F5-F2DD678EF49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063900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7524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000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712692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32478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78026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5639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4400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4199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25919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5489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01756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72983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074755-19DB-4A16-8356-498190883142}" type="datetimeFigureOut">
              <a:rPr lang="en-US" smtClean="0"/>
              <a:t>6/2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CF507A-7814-4B8E-8106-6D9206DD7FA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14769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g"/><Relationship Id="rId3" Type="http://schemas.openxmlformats.org/officeDocument/2006/relationships/image" Target="../media/image7.jpeg"/><Relationship Id="rId7" Type="http://schemas.openxmlformats.org/officeDocument/2006/relationships/image" Target="../media/image11.pn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image" Target="../media/image14.jpeg"/><Relationship Id="rId7" Type="http://schemas.openxmlformats.org/officeDocument/2006/relationships/image" Target="../media/image17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hyperlink" Target="http://bioinformatics.psb.ugent.be/webtools/Venn/" TargetMode="External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5"/>
          <p:cNvSpPr>
            <a:spLocks noChangeArrowheads="1"/>
          </p:cNvSpPr>
          <p:nvPr/>
        </p:nvSpPr>
        <p:spPr bwMode="auto">
          <a:xfrm>
            <a:off x="1056826" y="1208998"/>
            <a:ext cx="323807" cy="126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825" b="1" dirty="0">
                <a:solidFill>
                  <a:srgbClr val="000000"/>
                </a:solidFill>
                <a:cs typeface="Arial" panose="020B0604020202020204" pitchFamily="34" charset="0"/>
              </a:rPr>
              <a:t>MCF-7</a:t>
            </a:r>
            <a:endParaRPr lang="en-US" altLang="en-US" sz="825" dirty="0">
              <a:cs typeface="Arial" panose="020B0604020202020204" pitchFamily="34" charset="0"/>
            </a:endParaRPr>
          </a:p>
        </p:txBody>
      </p:sp>
      <p:sp>
        <p:nvSpPr>
          <p:cNvPr id="4" name="Rectangle 86"/>
          <p:cNvSpPr>
            <a:spLocks noChangeArrowheads="1"/>
          </p:cNvSpPr>
          <p:nvPr/>
        </p:nvSpPr>
        <p:spPr bwMode="auto">
          <a:xfrm>
            <a:off x="3309300" y="1208998"/>
            <a:ext cx="655629" cy="126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825" b="1" dirty="0">
                <a:solidFill>
                  <a:srgbClr val="000000"/>
                </a:solidFill>
                <a:cs typeface="Arial" panose="020B0604020202020204" pitchFamily="34" charset="0"/>
              </a:rPr>
              <a:t>MDA-MB-231</a:t>
            </a:r>
            <a:endParaRPr lang="en-US" altLang="en-US" sz="825" dirty="0">
              <a:cs typeface="Arial" panose="020B0604020202020204" pitchFamily="34" charset="0"/>
            </a:endParaRP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159551" y="2817655"/>
            <a:ext cx="468077" cy="126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825" b="1" dirty="0">
                <a:solidFill>
                  <a:srgbClr val="000000"/>
                </a:solidFill>
                <a:cs typeface="Arial" panose="020B0604020202020204" pitchFamily="34" charset="0"/>
              </a:rPr>
              <a:t>HCC1806</a:t>
            </a:r>
            <a:endParaRPr lang="en-US" altLang="en-US" sz="825" dirty="0">
              <a:cs typeface="Arial" panose="020B0604020202020204" pitchFamily="34" charset="0"/>
            </a:endParaRPr>
          </a:p>
        </p:txBody>
      </p:sp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5397110" y="1208998"/>
            <a:ext cx="655629" cy="126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825" b="1" dirty="0">
                <a:solidFill>
                  <a:srgbClr val="000000"/>
                </a:solidFill>
                <a:cs typeface="Arial" panose="020B0604020202020204" pitchFamily="34" charset="0"/>
              </a:rPr>
              <a:t>MDA-MB-468</a:t>
            </a:r>
            <a:endParaRPr lang="en-US" altLang="en-US" sz="825" dirty="0">
              <a:cs typeface="Arial" panose="020B0604020202020204" pitchFamily="34" charset="0"/>
            </a:endParaRPr>
          </a:p>
        </p:txBody>
      </p:sp>
      <p:sp>
        <p:nvSpPr>
          <p:cNvPr id="7" name="Rectangle 78"/>
          <p:cNvSpPr>
            <a:spLocks noChangeArrowheads="1"/>
          </p:cNvSpPr>
          <p:nvPr/>
        </p:nvSpPr>
        <p:spPr bwMode="auto">
          <a:xfrm>
            <a:off x="3321649" y="2817655"/>
            <a:ext cx="294953" cy="126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825" b="1" dirty="0">
                <a:solidFill>
                  <a:srgbClr val="000000"/>
                </a:solidFill>
                <a:cs typeface="Arial" panose="020B0604020202020204" pitchFamily="34" charset="0"/>
              </a:rPr>
              <a:t>BT-20</a:t>
            </a:r>
            <a:endParaRPr lang="en-US" altLang="en-US" sz="825" dirty="0"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66616" y="111697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846255" y="1116978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69216" y="1116978"/>
            <a:ext cx="2362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66616" y="2724556"/>
            <a:ext cx="28245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D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846255" y="2743873"/>
            <a:ext cx="23623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E</a:t>
            </a:r>
          </a:p>
        </p:txBody>
      </p:sp>
      <p:sp>
        <p:nvSpPr>
          <p:cNvPr id="16" name="Rectangle 6"/>
          <p:cNvSpPr>
            <a:spLocks noChangeArrowheads="1"/>
          </p:cNvSpPr>
          <p:nvPr/>
        </p:nvSpPr>
        <p:spPr bwMode="auto">
          <a:xfrm>
            <a:off x="1045369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8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7" name="Rectangle 7"/>
          <p:cNvSpPr>
            <a:spLocks noChangeArrowheads="1"/>
          </p:cNvSpPr>
          <p:nvPr/>
        </p:nvSpPr>
        <p:spPr bwMode="auto">
          <a:xfrm>
            <a:off x="1218010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8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8" name="Rectangle 8"/>
          <p:cNvSpPr>
            <a:spLocks noChangeArrowheads="1"/>
          </p:cNvSpPr>
          <p:nvPr/>
        </p:nvSpPr>
        <p:spPr bwMode="auto">
          <a:xfrm>
            <a:off x="1390650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7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9" name="Rectangle 9"/>
          <p:cNvSpPr>
            <a:spLocks noChangeArrowheads="1"/>
          </p:cNvSpPr>
          <p:nvPr/>
        </p:nvSpPr>
        <p:spPr bwMode="auto">
          <a:xfrm>
            <a:off x="1562100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7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0" name="Rectangle 10"/>
          <p:cNvSpPr>
            <a:spLocks noChangeArrowheads="1"/>
          </p:cNvSpPr>
          <p:nvPr/>
        </p:nvSpPr>
        <p:spPr bwMode="auto">
          <a:xfrm>
            <a:off x="1734741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6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1" name="Rectangle 11"/>
          <p:cNvSpPr>
            <a:spLocks noChangeArrowheads="1"/>
          </p:cNvSpPr>
          <p:nvPr/>
        </p:nvSpPr>
        <p:spPr bwMode="auto">
          <a:xfrm>
            <a:off x="1907381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6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2" name="Rectangle 12"/>
          <p:cNvSpPr>
            <a:spLocks noChangeArrowheads="1"/>
          </p:cNvSpPr>
          <p:nvPr/>
        </p:nvSpPr>
        <p:spPr bwMode="auto">
          <a:xfrm>
            <a:off x="2080022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5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3" name="Rectangle 13"/>
          <p:cNvSpPr>
            <a:spLocks noChangeArrowheads="1"/>
          </p:cNvSpPr>
          <p:nvPr/>
        </p:nvSpPr>
        <p:spPr bwMode="auto">
          <a:xfrm>
            <a:off x="2251472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5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4" name="Rectangle 14"/>
          <p:cNvSpPr>
            <a:spLocks noChangeArrowheads="1"/>
          </p:cNvSpPr>
          <p:nvPr/>
        </p:nvSpPr>
        <p:spPr bwMode="auto">
          <a:xfrm>
            <a:off x="2424113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4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5" name="Rectangle 15"/>
          <p:cNvSpPr>
            <a:spLocks noChangeArrowheads="1"/>
          </p:cNvSpPr>
          <p:nvPr/>
        </p:nvSpPr>
        <p:spPr bwMode="auto">
          <a:xfrm>
            <a:off x="2596754" y="2523064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4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6" name="Freeform 16"/>
          <p:cNvSpPr>
            <a:spLocks noEditPoints="1"/>
          </p:cNvSpPr>
          <p:nvPr/>
        </p:nvSpPr>
        <p:spPr bwMode="auto">
          <a:xfrm>
            <a:off x="1107282" y="2477820"/>
            <a:ext cx="1560910" cy="30956"/>
          </a:xfrm>
          <a:custGeom>
            <a:avLst/>
            <a:gdLst>
              <a:gd name="T0" fmla="*/ 0 w 1311"/>
              <a:gd name="T1" fmla="*/ 0 h 26"/>
              <a:gd name="T2" fmla="*/ 1311 w 1311"/>
              <a:gd name="T3" fmla="*/ 0 h 26"/>
              <a:gd name="T4" fmla="*/ 4 w 1311"/>
              <a:gd name="T5" fmla="*/ 0 h 26"/>
              <a:gd name="T6" fmla="*/ 4 w 1311"/>
              <a:gd name="T7" fmla="*/ 26 h 26"/>
              <a:gd name="T8" fmla="*/ 149 w 1311"/>
              <a:gd name="T9" fmla="*/ 0 h 26"/>
              <a:gd name="T10" fmla="*/ 149 w 1311"/>
              <a:gd name="T11" fmla="*/ 26 h 26"/>
              <a:gd name="T12" fmla="*/ 293 w 1311"/>
              <a:gd name="T13" fmla="*/ 0 h 26"/>
              <a:gd name="T14" fmla="*/ 293 w 1311"/>
              <a:gd name="T15" fmla="*/ 26 h 26"/>
              <a:gd name="T16" fmla="*/ 438 w 1311"/>
              <a:gd name="T17" fmla="*/ 0 h 26"/>
              <a:gd name="T18" fmla="*/ 438 w 1311"/>
              <a:gd name="T19" fmla="*/ 26 h 26"/>
              <a:gd name="T20" fmla="*/ 583 w 1311"/>
              <a:gd name="T21" fmla="*/ 0 h 26"/>
              <a:gd name="T22" fmla="*/ 583 w 1311"/>
              <a:gd name="T23" fmla="*/ 26 h 26"/>
              <a:gd name="T24" fmla="*/ 728 w 1311"/>
              <a:gd name="T25" fmla="*/ 0 h 26"/>
              <a:gd name="T26" fmla="*/ 728 w 1311"/>
              <a:gd name="T27" fmla="*/ 26 h 26"/>
              <a:gd name="T28" fmla="*/ 872 w 1311"/>
              <a:gd name="T29" fmla="*/ 0 h 26"/>
              <a:gd name="T30" fmla="*/ 872 w 1311"/>
              <a:gd name="T31" fmla="*/ 26 h 26"/>
              <a:gd name="T32" fmla="*/ 1017 w 1311"/>
              <a:gd name="T33" fmla="*/ 0 h 26"/>
              <a:gd name="T34" fmla="*/ 1017 w 1311"/>
              <a:gd name="T35" fmla="*/ 26 h 26"/>
              <a:gd name="T36" fmla="*/ 1162 w 1311"/>
              <a:gd name="T37" fmla="*/ 0 h 26"/>
              <a:gd name="T38" fmla="*/ 1162 w 1311"/>
              <a:gd name="T39" fmla="*/ 26 h 26"/>
              <a:gd name="T40" fmla="*/ 1307 w 1311"/>
              <a:gd name="T41" fmla="*/ 0 h 26"/>
              <a:gd name="T42" fmla="*/ 1307 w 1311"/>
              <a:gd name="T43" fmla="*/ 26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311" h="26">
                <a:moveTo>
                  <a:pt x="0" y="0"/>
                </a:moveTo>
                <a:lnTo>
                  <a:pt x="1311" y="0"/>
                </a:lnTo>
                <a:moveTo>
                  <a:pt x="4" y="0"/>
                </a:moveTo>
                <a:lnTo>
                  <a:pt x="4" y="26"/>
                </a:lnTo>
                <a:moveTo>
                  <a:pt x="149" y="0"/>
                </a:moveTo>
                <a:lnTo>
                  <a:pt x="149" y="26"/>
                </a:lnTo>
                <a:moveTo>
                  <a:pt x="293" y="0"/>
                </a:moveTo>
                <a:lnTo>
                  <a:pt x="293" y="26"/>
                </a:lnTo>
                <a:moveTo>
                  <a:pt x="438" y="0"/>
                </a:moveTo>
                <a:lnTo>
                  <a:pt x="438" y="26"/>
                </a:lnTo>
                <a:moveTo>
                  <a:pt x="583" y="0"/>
                </a:moveTo>
                <a:lnTo>
                  <a:pt x="583" y="26"/>
                </a:lnTo>
                <a:moveTo>
                  <a:pt x="728" y="0"/>
                </a:moveTo>
                <a:lnTo>
                  <a:pt x="728" y="26"/>
                </a:lnTo>
                <a:moveTo>
                  <a:pt x="872" y="0"/>
                </a:moveTo>
                <a:lnTo>
                  <a:pt x="872" y="26"/>
                </a:lnTo>
                <a:moveTo>
                  <a:pt x="1017" y="0"/>
                </a:moveTo>
                <a:lnTo>
                  <a:pt x="1017" y="26"/>
                </a:lnTo>
                <a:moveTo>
                  <a:pt x="1162" y="0"/>
                </a:moveTo>
                <a:lnTo>
                  <a:pt x="1162" y="26"/>
                </a:lnTo>
                <a:moveTo>
                  <a:pt x="1307" y="0"/>
                </a:moveTo>
                <a:lnTo>
                  <a:pt x="1307" y="26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17"/>
          <p:cNvSpPr>
            <a:spLocks noChangeArrowheads="1"/>
          </p:cNvSpPr>
          <p:nvPr/>
        </p:nvSpPr>
        <p:spPr bwMode="auto">
          <a:xfrm>
            <a:off x="820123" y="2431385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15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8" name="Rectangle 18"/>
          <p:cNvSpPr>
            <a:spLocks noChangeArrowheads="1"/>
          </p:cNvSpPr>
          <p:nvPr/>
        </p:nvSpPr>
        <p:spPr bwMode="auto">
          <a:xfrm>
            <a:off x="820123" y="2171829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3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29" name="Rectangle 19"/>
          <p:cNvSpPr>
            <a:spLocks noChangeArrowheads="1"/>
          </p:cNvSpPr>
          <p:nvPr/>
        </p:nvSpPr>
        <p:spPr bwMode="auto">
          <a:xfrm>
            <a:off x="820123" y="1913464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45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30" name="Rectangle 20"/>
          <p:cNvSpPr>
            <a:spLocks noChangeArrowheads="1"/>
          </p:cNvSpPr>
          <p:nvPr/>
        </p:nvSpPr>
        <p:spPr bwMode="auto">
          <a:xfrm>
            <a:off x="820123" y="1655098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6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31" name="Rectangle 21"/>
          <p:cNvSpPr>
            <a:spLocks noChangeArrowheads="1"/>
          </p:cNvSpPr>
          <p:nvPr/>
        </p:nvSpPr>
        <p:spPr bwMode="auto">
          <a:xfrm>
            <a:off x="820123" y="1395541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 dirty="0">
                <a:solidFill>
                  <a:srgbClr val="000000"/>
                </a:solidFill>
                <a:cs typeface="Arial" panose="020B0604020202020204" pitchFamily="34" charset="0"/>
              </a:rPr>
              <a:t>75000</a:t>
            </a:r>
            <a:endParaRPr lang="en-US" altLang="en-US" sz="675" dirty="0">
              <a:cs typeface="Arial" panose="020B0604020202020204" pitchFamily="34" charset="0"/>
            </a:endParaRPr>
          </a:p>
        </p:txBody>
      </p:sp>
      <p:sp>
        <p:nvSpPr>
          <p:cNvPr id="32" name="Freeform 22"/>
          <p:cNvSpPr>
            <a:spLocks noEditPoints="1"/>
          </p:cNvSpPr>
          <p:nvPr/>
        </p:nvSpPr>
        <p:spPr bwMode="auto">
          <a:xfrm>
            <a:off x="1081088" y="1437213"/>
            <a:ext cx="30956" cy="1046560"/>
          </a:xfrm>
          <a:custGeom>
            <a:avLst/>
            <a:gdLst>
              <a:gd name="T0" fmla="*/ 26 w 26"/>
              <a:gd name="T1" fmla="*/ 879 h 879"/>
              <a:gd name="T2" fmla="*/ 26 w 26"/>
              <a:gd name="T3" fmla="*/ 0 h 879"/>
              <a:gd name="T4" fmla="*/ 26 w 26"/>
              <a:gd name="T5" fmla="*/ 874 h 879"/>
              <a:gd name="T6" fmla="*/ 0 w 26"/>
              <a:gd name="T7" fmla="*/ 874 h 879"/>
              <a:gd name="T8" fmla="*/ 26 w 26"/>
              <a:gd name="T9" fmla="*/ 657 h 879"/>
              <a:gd name="T10" fmla="*/ 0 w 26"/>
              <a:gd name="T11" fmla="*/ 657 h 879"/>
              <a:gd name="T12" fmla="*/ 26 w 26"/>
              <a:gd name="T13" fmla="*/ 440 h 879"/>
              <a:gd name="T14" fmla="*/ 0 w 26"/>
              <a:gd name="T15" fmla="*/ 440 h 879"/>
              <a:gd name="T16" fmla="*/ 26 w 26"/>
              <a:gd name="T17" fmla="*/ 222 h 879"/>
              <a:gd name="T18" fmla="*/ 0 w 26"/>
              <a:gd name="T19" fmla="*/ 222 h 879"/>
              <a:gd name="T20" fmla="*/ 26 w 26"/>
              <a:gd name="T21" fmla="*/ 5 h 879"/>
              <a:gd name="T22" fmla="*/ 0 w 26"/>
              <a:gd name="T23" fmla="*/ 5 h 8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6" h="879">
                <a:moveTo>
                  <a:pt x="26" y="879"/>
                </a:moveTo>
                <a:lnTo>
                  <a:pt x="26" y="0"/>
                </a:lnTo>
                <a:moveTo>
                  <a:pt x="26" y="874"/>
                </a:moveTo>
                <a:lnTo>
                  <a:pt x="0" y="874"/>
                </a:lnTo>
                <a:moveTo>
                  <a:pt x="26" y="657"/>
                </a:moveTo>
                <a:lnTo>
                  <a:pt x="0" y="657"/>
                </a:lnTo>
                <a:moveTo>
                  <a:pt x="26" y="440"/>
                </a:moveTo>
                <a:lnTo>
                  <a:pt x="0" y="440"/>
                </a:lnTo>
                <a:moveTo>
                  <a:pt x="26" y="222"/>
                </a:moveTo>
                <a:lnTo>
                  <a:pt x="0" y="222"/>
                </a:lnTo>
                <a:moveTo>
                  <a:pt x="26" y="5"/>
                </a:moveTo>
                <a:lnTo>
                  <a:pt x="0" y="5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Line 23"/>
          <p:cNvSpPr>
            <a:spLocks noChangeShapeType="1"/>
          </p:cNvSpPr>
          <p:nvPr/>
        </p:nvSpPr>
        <p:spPr bwMode="auto">
          <a:xfrm>
            <a:off x="1284685" y="1657478"/>
            <a:ext cx="0" cy="42863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Line 24"/>
          <p:cNvSpPr>
            <a:spLocks noChangeShapeType="1"/>
          </p:cNvSpPr>
          <p:nvPr/>
        </p:nvSpPr>
        <p:spPr bwMode="auto">
          <a:xfrm>
            <a:off x="1284685" y="1700341"/>
            <a:ext cx="0" cy="4405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Line 25"/>
          <p:cNvSpPr>
            <a:spLocks noChangeShapeType="1"/>
          </p:cNvSpPr>
          <p:nvPr/>
        </p:nvSpPr>
        <p:spPr bwMode="auto">
          <a:xfrm>
            <a:off x="1260873" y="1657478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Line 26"/>
          <p:cNvSpPr>
            <a:spLocks noChangeShapeType="1"/>
          </p:cNvSpPr>
          <p:nvPr/>
        </p:nvSpPr>
        <p:spPr bwMode="auto">
          <a:xfrm>
            <a:off x="1260873" y="1744394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Line 27"/>
          <p:cNvSpPr>
            <a:spLocks noChangeShapeType="1"/>
          </p:cNvSpPr>
          <p:nvPr/>
        </p:nvSpPr>
        <p:spPr bwMode="auto">
          <a:xfrm>
            <a:off x="1525191" y="1531273"/>
            <a:ext cx="0" cy="50006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Line 28"/>
          <p:cNvSpPr>
            <a:spLocks noChangeShapeType="1"/>
          </p:cNvSpPr>
          <p:nvPr/>
        </p:nvSpPr>
        <p:spPr bwMode="auto">
          <a:xfrm>
            <a:off x="1525191" y="1581279"/>
            <a:ext cx="0" cy="51197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Line 29"/>
          <p:cNvSpPr>
            <a:spLocks noChangeShapeType="1"/>
          </p:cNvSpPr>
          <p:nvPr/>
        </p:nvSpPr>
        <p:spPr bwMode="auto">
          <a:xfrm>
            <a:off x="1502569" y="1531272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Line 30"/>
          <p:cNvSpPr>
            <a:spLocks noChangeShapeType="1"/>
          </p:cNvSpPr>
          <p:nvPr/>
        </p:nvSpPr>
        <p:spPr bwMode="auto">
          <a:xfrm>
            <a:off x="1502569" y="1632476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Line 31"/>
          <p:cNvSpPr>
            <a:spLocks noChangeShapeType="1"/>
          </p:cNvSpPr>
          <p:nvPr/>
        </p:nvSpPr>
        <p:spPr bwMode="auto">
          <a:xfrm>
            <a:off x="1628775" y="1531272"/>
            <a:ext cx="0" cy="4762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Line 32"/>
          <p:cNvSpPr>
            <a:spLocks noChangeShapeType="1"/>
          </p:cNvSpPr>
          <p:nvPr/>
        </p:nvSpPr>
        <p:spPr bwMode="auto">
          <a:xfrm>
            <a:off x="1628775" y="1578897"/>
            <a:ext cx="0" cy="4762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Line 33"/>
          <p:cNvSpPr>
            <a:spLocks noChangeShapeType="1"/>
          </p:cNvSpPr>
          <p:nvPr/>
        </p:nvSpPr>
        <p:spPr bwMode="auto">
          <a:xfrm>
            <a:off x="1606154" y="1531272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Line 34"/>
          <p:cNvSpPr>
            <a:spLocks noChangeShapeType="1"/>
          </p:cNvSpPr>
          <p:nvPr/>
        </p:nvSpPr>
        <p:spPr bwMode="auto">
          <a:xfrm>
            <a:off x="1606154" y="1626522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Line 35"/>
          <p:cNvSpPr>
            <a:spLocks noChangeShapeType="1"/>
          </p:cNvSpPr>
          <p:nvPr/>
        </p:nvSpPr>
        <p:spPr bwMode="auto">
          <a:xfrm>
            <a:off x="2318147" y="1793210"/>
            <a:ext cx="0" cy="4643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Line 36"/>
          <p:cNvSpPr>
            <a:spLocks noChangeShapeType="1"/>
          </p:cNvSpPr>
          <p:nvPr/>
        </p:nvSpPr>
        <p:spPr bwMode="auto">
          <a:xfrm>
            <a:off x="2318147" y="1839645"/>
            <a:ext cx="0" cy="4643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Line 37"/>
          <p:cNvSpPr>
            <a:spLocks noChangeShapeType="1"/>
          </p:cNvSpPr>
          <p:nvPr/>
        </p:nvSpPr>
        <p:spPr bwMode="auto">
          <a:xfrm>
            <a:off x="2295525" y="1793210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Line 38"/>
          <p:cNvSpPr>
            <a:spLocks noChangeShapeType="1"/>
          </p:cNvSpPr>
          <p:nvPr/>
        </p:nvSpPr>
        <p:spPr bwMode="auto">
          <a:xfrm>
            <a:off x="2295525" y="1886078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Line 39"/>
          <p:cNvSpPr>
            <a:spLocks noChangeShapeType="1"/>
          </p:cNvSpPr>
          <p:nvPr/>
        </p:nvSpPr>
        <p:spPr bwMode="auto">
          <a:xfrm>
            <a:off x="2456260" y="1927750"/>
            <a:ext cx="0" cy="23813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Line 40"/>
          <p:cNvSpPr>
            <a:spLocks noChangeShapeType="1"/>
          </p:cNvSpPr>
          <p:nvPr/>
        </p:nvSpPr>
        <p:spPr bwMode="auto">
          <a:xfrm>
            <a:off x="2456260" y="1951563"/>
            <a:ext cx="0" cy="2500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Line 41"/>
          <p:cNvSpPr>
            <a:spLocks noChangeShapeType="1"/>
          </p:cNvSpPr>
          <p:nvPr/>
        </p:nvSpPr>
        <p:spPr bwMode="auto">
          <a:xfrm>
            <a:off x="2432447" y="1927751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Line 42"/>
          <p:cNvSpPr>
            <a:spLocks noChangeShapeType="1"/>
          </p:cNvSpPr>
          <p:nvPr/>
        </p:nvSpPr>
        <p:spPr bwMode="auto">
          <a:xfrm>
            <a:off x="2432447" y="1976566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Oval 43"/>
          <p:cNvSpPr>
            <a:spLocks noChangeArrowheads="1"/>
          </p:cNvSpPr>
          <p:nvPr/>
        </p:nvSpPr>
        <p:spPr bwMode="auto">
          <a:xfrm>
            <a:off x="1263254" y="1680101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Oval 44"/>
          <p:cNvSpPr>
            <a:spLocks noChangeArrowheads="1"/>
          </p:cNvSpPr>
          <p:nvPr/>
        </p:nvSpPr>
        <p:spPr bwMode="auto">
          <a:xfrm>
            <a:off x="1263254" y="1680101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Oval 45"/>
          <p:cNvSpPr>
            <a:spLocks noChangeArrowheads="1"/>
          </p:cNvSpPr>
          <p:nvPr/>
        </p:nvSpPr>
        <p:spPr bwMode="auto">
          <a:xfrm>
            <a:off x="1504951" y="1561039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Oval 46"/>
          <p:cNvSpPr>
            <a:spLocks noChangeArrowheads="1"/>
          </p:cNvSpPr>
          <p:nvPr/>
        </p:nvSpPr>
        <p:spPr bwMode="auto">
          <a:xfrm>
            <a:off x="1504951" y="1561039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Oval 47"/>
          <p:cNvSpPr>
            <a:spLocks noChangeArrowheads="1"/>
          </p:cNvSpPr>
          <p:nvPr/>
        </p:nvSpPr>
        <p:spPr bwMode="auto">
          <a:xfrm>
            <a:off x="1608535" y="1558657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Oval 48"/>
          <p:cNvSpPr>
            <a:spLocks noChangeArrowheads="1"/>
          </p:cNvSpPr>
          <p:nvPr/>
        </p:nvSpPr>
        <p:spPr bwMode="auto">
          <a:xfrm>
            <a:off x="1608535" y="1558657"/>
            <a:ext cx="40481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Oval 49"/>
          <p:cNvSpPr>
            <a:spLocks noChangeArrowheads="1"/>
          </p:cNvSpPr>
          <p:nvPr/>
        </p:nvSpPr>
        <p:spPr bwMode="auto">
          <a:xfrm>
            <a:off x="1952626" y="1574135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Oval 50"/>
          <p:cNvSpPr>
            <a:spLocks noChangeArrowheads="1"/>
          </p:cNvSpPr>
          <p:nvPr/>
        </p:nvSpPr>
        <p:spPr bwMode="auto">
          <a:xfrm>
            <a:off x="1952626" y="1574135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Oval 51"/>
          <p:cNvSpPr>
            <a:spLocks noChangeArrowheads="1"/>
          </p:cNvSpPr>
          <p:nvPr/>
        </p:nvSpPr>
        <p:spPr bwMode="auto">
          <a:xfrm>
            <a:off x="2297907" y="1819404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Oval 52"/>
          <p:cNvSpPr>
            <a:spLocks noChangeArrowheads="1"/>
          </p:cNvSpPr>
          <p:nvPr/>
        </p:nvSpPr>
        <p:spPr bwMode="auto">
          <a:xfrm>
            <a:off x="2297907" y="1819404"/>
            <a:ext cx="40481" cy="40481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Oval 53"/>
          <p:cNvSpPr>
            <a:spLocks noChangeArrowheads="1"/>
          </p:cNvSpPr>
          <p:nvPr/>
        </p:nvSpPr>
        <p:spPr bwMode="auto">
          <a:xfrm>
            <a:off x="2436019" y="1931323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Oval 54"/>
          <p:cNvSpPr>
            <a:spLocks noChangeArrowheads="1"/>
          </p:cNvSpPr>
          <p:nvPr/>
        </p:nvSpPr>
        <p:spPr bwMode="auto">
          <a:xfrm>
            <a:off x="2436019" y="1931323"/>
            <a:ext cx="40481" cy="40481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Oval 55"/>
          <p:cNvSpPr>
            <a:spLocks noChangeArrowheads="1"/>
          </p:cNvSpPr>
          <p:nvPr/>
        </p:nvSpPr>
        <p:spPr bwMode="auto">
          <a:xfrm>
            <a:off x="2538413" y="2274223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Oval 56"/>
          <p:cNvSpPr>
            <a:spLocks noChangeArrowheads="1"/>
          </p:cNvSpPr>
          <p:nvPr/>
        </p:nvSpPr>
        <p:spPr bwMode="auto">
          <a:xfrm>
            <a:off x="2538413" y="2274223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Oval 57"/>
          <p:cNvSpPr>
            <a:spLocks noChangeArrowheads="1"/>
          </p:cNvSpPr>
          <p:nvPr/>
        </p:nvSpPr>
        <p:spPr bwMode="auto">
          <a:xfrm>
            <a:off x="2601517" y="2399239"/>
            <a:ext cx="40481" cy="40481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Oval 58"/>
          <p:cNvSpPr>
            <a:spLocks noChangeArrowheads="1"/>
          </p:cNvSpPr>
          <p:nvPr/>
        </p:nvSpPr>
        <p:spPr bwMode="auto">
          <a:xfrm>
            <a:off x="2601517" y="2399239"/>
            <a:ext cx="40481" cy="40481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Freeform 59"/>
          <p:cNvSpPr>
            <a:spLocks/>
          </p:cNvSpPr>
          <p:nvPr/>
        </p:nvSpPr>
        <p:spPr bwMode="auto">
          <a:xfrm>
            <a:off x="1284685" y="1618188"/>
            <a:ext cx="1337072" cy="791766"/>
          </a:xfrm>
          <a:custGeom>
            <a:avLst/>
            <a:gdLst>
              <a:gd name="T0" fmla="*/ 7 w 1123"/>
              <a:gd name="T1" fmla="*/ 0 h 665"/>
              <a:gd name="T2" fmla="*/ 29 w 1123"/>
              <a:gd name="T3" fmla="*/ 0 h 665"/>
              <a:gd name="T4" fmla="*/ 45 w 1123"/>
              <a:gd name="T5" fmla="*/ 0 h 665"/>
              <a:gd name="T6" fmla="*/ 67 w 1123"/>
              <a:gd name="T7" fmla="*/ 0 h 665"/>
              <a:gd name="T8" fmla="*/ 82 w 1123"/>
              <a:gd name="T9" fmla="*/ 0 h 665"/>
              <a:gd name="T10" fmla="*/ 105 w 1123"/>
              <a:gd name="T11" fmla="*/ 0 h 665"/>
              <a:gd name="T12" fmla="*/ 120 w 1123"/>
              <a:gd name="T13" fmla="*/ 0 h 665"/>
              <a:gd name="T14" fmla="*/ 142 w 1123"/>
              <a:gd name="T15" fmla="*/ 0 h 665"/>
              <a:gd name="T16" fmla="*/ 157 w 1123"/>
              <a:gd name="T17" fmla="*/ 0 h 665"/>
              <a:gd name="T18" fmla="*/ 180 w 1123"/>
              <a:gd name="T19" fmla="*/ 0 h 665"/>
              <a:gd name="T20" fmla="*/ 195 w 1123"/>
              <a:gd name="T21" fmla="*/ 0 h 665"/>
              <a:gd name="T22" fmla="*/ 218 w 1123"/>
              <a:gd name="T23" fmla="*/ 0 h 665"/>
              <a:gd name="T24" fmla="*/ 233 w 1123"/>
              <a:gd name="T25" fmla="*/ 0 h 665"/>
              <a:gd name="T26" fmla="*/ 256 w 1123"/>
              <a:gd name="T27" fmla="*/ 0 h 665"/>
              <a:gd name="T28" fmla="*/ 270 w 1123"/>
              <a:gd name="T29" fmla="*/ 0 h 665"/>
              <a:gd name="T30" fmla="*/ 293 w 1123"/>
              <a:gd name="T31" fmla="*/ 1 h 665"/>
              <a:gd name="T32" fmla="*/ 309 w 1123"/>
              <a:gd name="T33" fmla="*/ 1 h 665"/>
              <a:gd name="T34" fmla="*/ 331 w 1123"/>
              <a:gd name="T35" fmla="*/ 1 h 665"/>
              <a:gd name="T36" fmla="*/ 346 w 1123"/>
              <a:gd name="T37" fmla="*/ 1 h 665"/>
              <a:gd name="T38" fmla="*/ 369 w 1123"/>
              <a:gd name="T39" fmla="*/ 1 h 665"/>
              <a:gd name="T40" fmla="*/ 384 w 1123"/>
              <a:gd name="T41" fmla="*/ 1 h 665"/>
              <a:gd name="T42" fmla="*/ 406 w 1123"/>
              <a:gd name="T43" fmla="*/ 1 h 665"/>
              <a:gd name="T44" fmla="*/ 421 w 1123"/>
              <a:gd name="T45" fmla="*/ 1 h 665"/>
              <a:gd name="T46" fmla="*/ 444 w 1123"/>
              <a:gd name="T47" fmla="*/ 1 h 665"/>
              <a:gd name="T48" fmla="*/ 459 w 1123"/>
              <a:gd name="T49" fmla="*/ 2 h 665"/>
              <a:gd name="T50" fmla="*/ 482 w 1123"/>
              <a:gd name="T51" fmla="*/ 3 h 665"/>
              <a:gd name="T52" fmla="*/ 497 w 1123"/>
              <a:gd name="T53" fmla="*/ 3 h 665"/>
              <a:gd name="T54" fmla="*/ 519 w 1123"/>
              <a:gd name="T55" fmla="*/ 3 h 665"/>
              <a:gd name="T56" fmla="*/ 535 w 1123"/>
              <a:gd name="T57" fmla="*/ 4 h 665"/>
              <a:gd name="T58" fmla="*/ 557 w 1123"/>
              <a:gd name="T59" fmla="*/ 6 h 665"/>
              <a:gd name="T60" fmla="*/ 572 w 1123"/>
              <a:gd name="T61" fmla="*/ 6 h 665"/>
              <a:gd name="T62" fmla="*/ 594 w 1123"/>
              <a:gd name="T63" fmla="*/ 8 h 665"/>
              <a:gd name="T64" fmla="*/ 610 w 1123"/>
              <a:gd name="T65" fmla="*/ 10 h 665"/>
              <a:gd name="T66" fmla="*/ 632 w 1123"/>
              <a:gd name="T67" fmla="*/ 12 h 665"/>
              <a:gd name="T68" fmla="*/ 647 w 1123"/>
              <a:gd name="T69" fmla="*/ 14 h 665"/>
              <a:gd name="T70" fmla="*/ 671 w 1123"/>
              <a:gd name="T71" fmla="*/ 19 h 665"/>
              <a:gd name="T72" fmla="*/ 685 w 1123"/>
              <a:gd name="T73" fmla="*/ 21 h 665"/>
              <a:gd name="T74" fmla="*/ 708 w 1123"/>
              <a:gd name="T75" fmla="*/ 27 h 665"/>
              <a:gd name="T76" fmla="*/ 723 w 1123"/>
              <a:gd name="T77" fmla="*/ 33 h 665"/>
              <a:gd name="T78" fmla="*/ 746 w 1123"/>
              <a:gd name="T79" fmla="*/ 40 h 665"/>
              <a:gd name="T80" fmla="*/ 761 w 1123"/>
              <a:gd name="T81" fmla="*/ 47 h 665"/>
              <a:gd name="T82" fmla="*/ 783 w 1123"/>
              <a:gd name="T83" fmla="*/ 59 h 665"/>
              <a:gd name="T84" fmla="*/ 799 w 1123"/>
              <a:gd name="T85" fmla="*/ 69 h 665"/>
              <a:gd name="T86" fmla="*/ 821 w 1123"/>
              <a:gd name="T87" fmla="*/ 85 h 665"/>
              <a:gd name="T88" fmla="*/ 836 w 1123"/>
              <a:gd name="T89" fmla="*/ 98 h 665"/>
              <a:gd name="T90" fmla="*/ 859 w 1123"/>
              <a:gd name="T91" fmla="*/ 121 h 665"/>
              <a:gd name="T92" fmla="*/ 874 w 1123"/>
              <a:gd name="T93" fmla="*/ 140 h 665"/>
              <a:gd name="T94" fmla="*/ 896 w 1123"/>
              <a:gd name="T95" fmla="*/ 171 h 665"/>
              <a:gd name="T96" fmla="*/ 912 w 1123"/>
              <a:gd name="T97" fmla="*/ 194 h 665"/>
              <a:gd name="T98" fmla="*/ 934 w 1123"/>
              <a:gd name="T99" fmla="*/ 233 h 665"/>
              <a:gd name="T100" fmla="*/ 949 w 1123"/>
              <a:gd name="T101" fmla="*/ 262 h 665"/>
              <a:gd name="T102" fmla="*/ 972 w 1123"/>
              <a:gd name="T103" fmla="*/ 310 h 665"/>
              <a:gd name="T104" fmla="*/ 987 w 1123"/>
              <a:gd name="T105" fmla="*/ 344 h 665"/>
              <a:gd name="T106" fmla="*/ 1009 w 1123"/>
              <a:gd name="T107" fmla="*/ 398 h 665"/>
              <a:gd name="T108" fmla="*/ 1024 w 1123"/>
              <a:gd name="T109" fmla="*/ 434 h 665"/>
              <a:gd name="T110" fmla="*/ 1047 w 1123"/>
              <a:gd name="T111" fmla="*/ 490 h 665"/>
              <a:gd name="T112" fmla="*/ 1062 w 1123"/>
              <a:gd name="T113" fmla="*/ 528 h 665"/>
              <a:gd name="T114" fmla="*/ 1084 w 1123"/>
              <a:gd name="T115" fmla="*/ 583 h 665"/>
              <a:gd name="T116" fmla="*/ 1100 w 1123"/>
              <a:gd name="T117" fmla="*/ 617 h 665"/>
              <a:gd name="T118" fmla="*/ 1123 w 1123"/>
              <a:gd name="T119" fmla="*/ 665 h 6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123" h="665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7" y="0"/>
                </a:lnTo>
                <a:lnTo>
                  <a:pt x="7" y="0"/>
                </a:lnTo>
                <a:lnTo>
                  <a:pt x="14" y="0"/>
                </a:lnTo>
                <a:lnTo>
                  <a:pt x="14" y="0"/>
                </a:lnTo>
                <a:lnTo>
                  <a:pt x="22" y="0"/>
                </a:lnTo>
                <a:lnTo>
                  <a:pt x="22" y="0"/>
                </a:lnTo>
                <a:lnTo>
                  <a:pt x="29" y="0"/>
                </a:lnTo>
                <a:lnTo>
                  <a:pt x="29" y="0"/>
                </a:lnTo>
                <a:lnTo>
                  <a:pt x="37" y="0"/>
                </a:lnTo>
                <a:lnTo>
                  <a:pt x="37" y="0"/>
                </a:lnTo>
                <a:lnTo>
                  <a:pt x="45" y="0"/>
                </a:lnTo>
                <a:lnTo>
                  <a:pt x="45" y="0"/>
                </a:lnTo>
                <a:lnTo>
                  <a:pt x="52" y="0"/>
                </a:lnTo>
                <a:lnTo>
                  <a:pt x="52" y="0"/>
                </a:lnTo>
                <a:lnTo>
                  <a:pt x="60" y="0"/>
                </a:lnTo>
                <a:lnTo>
                  <a:pt x="60" y="0"/>
                </a:lnTo>
                <a:lnTo>
                  <a:pt x="67" y="0"/>
                </a:lnTo>
                <a:lnTo>
                  <a:pt x="67" y="0"/>
                </a:lnTo>
                <a:lnTo>
                  <a:pt x="75" y="0"/>
                </a:lnTo>
                <a:lnTo>
                  <a:pt x="75" y="0"/>
                </a:lnTo>
                <a:lnTo>
                  <a:pt x="82" y="0"/>
                </a:lnTo>
                <a:lnTo>
                  <a:pt x="82" y="0"/>
                </a:lnTo>
                <a:lnTo>
                  <a:pt x="89" y="0"/>
                </a:lnTo>
                <a:lnTo>
                  <a:pt x="89" y="0"/>
                </a:lnTo>
                <a:lnTo>
                  <a:pt x="97" y="0"/>
                </a:lnTo>
                <a:lnTo>
                  <a:pt x="97" y="0"/>
                </a:lnTo>
                <a:lnTo>
                  <a:pt x="105" y="0"/>
                </a:lnTo>
                <a:lnTo>
                  <a:pt x="105" y="0"/>
                </a:lnTo>
                <a:lnTo>
                  <a:pt x="112" y="0"/>
                </a:lnTo>
                <a:lnTo>
                  <a:pt x="112" y="0"/>
                </a:lnTo>
                <a:lnTo>
                  <a:pt x="120" y="0"/>
                </a:lnTo>
                <a:lnTo>
                  <a:pt x="120" y="0"/>
                </a:lnTo>
                <a:lnTo>
                  <a:pt x="128" y="0"/>
                </a:lnTo>
                <a:lnTo>
                  <a:pt x="128" y="0"/>
                </a:lnTo>
                <a:lnTo>
                  <a:pt x="135" y="0"/>
                </a:lnTo>
                <a:lnTo>
                  <a:pt x="135" y="0"/>
                </a:lnTo>
                <a:lnTo>
                  <a:pt x="142" y="0"/>
                </a:lnTo>
                <a:lnTo>
                  <a:pt x="142" y="0"/>
                </a:lnTo>
                <a:lnTo>
                  <a:pt x="150" y="0"/>
                </a:lnTo>
                <a:lnTo>
                  <a:pt x="150" y="0"/>
                </a:lnTo>
                <a:lnTo>
                  <a:pt x="157" y="0"/>
                </a:lnTo>
                <a:lnTo>
                  <a:pt x="157" y="0"/>
                </a:lnTo>
                <a:lnTo>
                  <a:pt x="165" y="0"/>
                </a:lnTo>
                <a:lnTo>
                  <a:pt x="165" y="0"/>
                </a:lnTo>
                <a:lnTo>
                  <a:pt x="173" y="0"/>
                </a:lnTo>
                <a:lnTo>
                  <a:pt x="173" y="0"/>
                </a:lnTo>
                <a:lnTo>
                  <a:pt x="180" y="0"/>
                </a:lnTo>
                <a:lnTo>
                  <a:pt x="180" y="0"/>
                </a:lnTo>
                <a:lnTo>
                  <a:pt x="188" y="0"/>
                </a:lnTo>
                <a:lnTo>
                  <a:pt x="188" y="0"/>
                </a:lnTo>
                <a:lnTo>
                  <a:pt x="195" y="0"/>
                </a:lnTo>
                <a:lnTo>
                  <a:pt x="195" y="0"/>
                </a:lnTo>
                <a:lnTo>
                  <a:pt x="203" y="0"/>
                </a:lnTo>
                <a:lnTo>
                  <a:pt x="203" y="0"/>
                </a:lnTo>
                <a:lnTo>
                  <a:pt x="210" y="0"/>
                </a:lnTo>
                <a:lnTo>
                  <a:pt x="210" y="0"/>
                </a:lnTo>
                <a:lnTo>
                  <a:pt x="218" y="0"/>
                </a:lnTo>
                <a:lnTo>
                  <a:pt x="218" y="0"/>
                </a:lnTo>
                <a:lnTo>
                  <a:pt x="226" y="0"/>
                </a:lnTo>
                <a:lnTo>
                  <a:pt x="226" y="0"/>
                </a:lnTo>
                <a:lnTo>
                  <a:pt x="233" y="0"/>
                </a:lnTo>
                <a:lnTo>
                  <a:pt x="233" y="0"/>
                </a:lnTo>
                <a:lnTo>
                  <a:pt x="241" y="0"/>
                </a:lnTo>
                <a:lnTo>
                  <a:pt x="241" y="0"/>
                </a:lnTo>
                <a:lnTo>
                  <a:pt x="248" y="0"/>
                </a:lnTo>
                <a:lnTo>
                  <a:pt x="248" y="0"/>
                </a:lnTo>
                <a:lnTo>
                  <a:pt x="256" y="0"/>
                </a:lnTo>
                <a:lnTo>
                  <a:pt x="256" y="0"/>
                </a:lnTo>
                <a:lnTo>
                  <a:pt x="263" y="0"/>
                </a:lnTo>
                <a:lnTo>
                  <a:pt x="263" y="0"/>
                </a:lnTo>
                <a:lnTo>
                  <a:pt x="270" y="0"/>
                </a:lnTo>
                <a:lnTo>
                  <a:pt x="270" y="0"/>
                </a:lnTo>
                <a:lnTo>
                  <a:pt x="278" y="0"/>
                </a:lnTo>
                <a:lnTo>
                  <a:pt x="278" y="0"/>
                </a:lnTo>
                <a:lnTo>
                  <a:pt x="285" y="0"/>
                </a:lnTo>
                <a:lnTo>
                  <a:pt x="285" y="0"/>
                </a:lnTo>
                <a:lnTo>
                  <a:pt x="293" y="1"/>
                </a:lnTo>
                <a:lnTo>
                  <a:pt x="293" y="1"/>
                </a:lnTo>
                <a:lnTo>
                  <a:pt x="301" y="1"/>
                </a:lnTo>
                <a:lnTo>
                  <a:pt x="301" y="1"/>
                </a:lnTo>
                <a:lnTo>
                  <a:pt x="309" y="1"/>
                </a:lnTo>
                <a:lnTo>
                  <a:pt x="309" y="1"/>
                </a:lnTo>
                <a:lnTo>
                  <a:pt x="316" y="1"/>
                </a:lnTo>
                <a:lnTo>
                  <a:pt x="316" y="1"/>
                </a:lnTo>
                <a:lnTo>
                  <a:pt x="323" y="1"/>
                </a:lnTo>
                <a:lnTo>
                  <a:pt x="323" y="1"/>
                </a:lnTo>
                <a:lnTo>
                  <a:pt x="331" y="1"/>
                </a:lnTo>
                <a:lnTo>
                  <a:pt x="331" y="1"/>
                </a:lnTo>
                <a:lnTo>
                  <a:pt x="338" y="1"/>
                </a:lnTo>
                <a:lnTo>
                  <a:pt x="338" y="1"/>
                </a:lnTo>
                <a:lnTo>
                  <a:pt x="346" y="1"/>
                </a:lnTo>
                <a:lnTo>
                  <a:pt x="346" y="1"/>
                </a:lnTo>
                <a:lnTo>
                  <a:pt x="354" y="1"/>
                </a:lnTo>
                <a:lnTo>
                  <a:pt x="354" y="1"/>
                </a:lnTo>
                <a:lnTo>
                  <a:pt x="361" y="1"/>
                </a:lnTo>
                <a:lnTo>
                  <a:pt x="361" y="1"/>
                </a:lnTo>
                <a:lnTo>
                  <a:pt x="369" y="1"/>
                </a:lnTo>
                <a:lnTo>
                  <a:pt x="369" y="1"/>
                </a:lnTo>
                <a:lnTo>
                  <a:pt x="376" y="1"/>
                </a:lnTo>
                <a:lnTo>
                  <a:pt x="376" y="1"/>
                </a:lnTo>
                <a:lnTo>
                  <a:pt x="384" y="1"/>
                </a:lnTo>
                <a:lnTo>
                  <a:pt x="384" y="1"/>
                </a:lnTo>
                <a:lnTo>
                  <a:pt x="391" y="1"/>
                </a:lnTo>
                <a:lnTo>
                  <a:pt x="391" y="1"/>
                </a:lnTo>
                <a:lnTo>
                  <a:pt x="399" y="1"/>
                </a:lnTo>
                <a:lnTo>
                  <a:pt x="399" y="1"/>
                </a:lnTo>
                <a:lnTo>
                  <a:pt x="406" y="1"/>
                </a:lnTo>
                <a:lnTo>
                  <a:pt x="406" y="1"/>
                </a:lnTo>
                <a:lnTo>
                  <a:pt x="414" y="1"/>
                </a:lnTo>
                <a:lnTo>
                  <a:pt x="414" y="1"/>
                </a:lnTo>
                <a:lnTo>
                  <a:pt x="421" y="1"/>
                </a:lnTo>
                <a:lnTo>
                  <a:pt x="421" y="1"/>
                </a:lnTo>
                <a:lnTo>
                  <a:pt x="429" y="1"/>
                </a:lnTo>
                <a:lnTo>
                  <a:pt x="429" y="1"/>
                </a:lnTo>
                <a:lnTo>
                  <a:pt x="437" y="1"/>
                </a:lnTo>
                <a:lnTo>
                  <a:pt x="437" y="1"/>
                </a:lnTo>
                <a:lnTo>
                  <a:pt x="444" y="1"/>
                </a:lnTo>
                <a:lnTo>
                  <a:pt x="444" y="1"/>
                </a:lnTo>
                <a:lnTo>
                  <a:pt x="451" y="2"/>
                </a:lnTo>
                <a:lnTo>
                  <a:pt x="451" y="2"/>
                </a:lnTo>
                <a:lnTo>
                  <a:pt x="459" y="2"/>
                </a:lnTo>
                <a:lnTo>
                  <a:pt x="459" y="2"/>
                </a:lnTo>
                <a:lnTo>
                  <a:pt x="466" y="2"/>
                </a:lnTo>
                <a:lnTo>
                  <a:pt x="466" y="2"/>
                </a:lnTo>
                <a:lnTo>
                  <a:pt x="474" y="2"/>
                </a:lnTo>
                <a:lnTo>
                  <a:pt x="474" y="2"/>
                </a:lnTo>
                <a:lnTo>
                  <a:pt x="482" y="3"/>
                </a:lnTo>
                <a:lnTo>
                  <a:pt x="482" y="3"/>
                </a:lnTo>
                <a:lnTo>
                  <a:pt x="490" y="3"/>
                </a:lnTo>
                <a:lnTo>
                  <a:pt x="490" y="3"/>
                </a:lnTo>
                <a:lnTo>
                  <a:pt x="497" y="3"/>
                </a:lnTo>
                <a:lnTo>
                  <a:pt x="497" y="3"/>
                </a:lnTo>
                <a:lnTo>
                  <a:pt x="504" y="3"/>
                </a:lnTo>
                <a:lnTo>
                  <a:pt x="504" y="3"/>
                </a:lnTo>
                <a:lnTo>
                  <a:pt x="512" y="3"/>
                </a:lnTo>
                <a:lnTo>
                  <a:pt x="512" y="3"/>
                </a:lnTo>
                <a:lnTo>
                  <a:pt x="519" y="3"/>
                </a:lnTo>
                <a:lnTo>
                  <a:pt x="519" y="3"/>
                </a:lnTo>
                <a:lnTo>
                  <a:pt x="527" y="4"/>
                </a:lnTo>
                <a:lnTo>
                  <a:pt x="527" y="4"/>
                </a:lnTo>
                <a:lnTo>
                  <a:pt x="535" y="4"/>
                </a:lnTo>
                <a:lnTo>
                  <a:pt x="535" y="4"/>
                </a:lnTo>
                <a:lnTo>
                  <a:pt x="542" y="5"/>
                </a:lnTo>
                <a:lnTo>
                  <a:pt x="542" y="5"/>
                </a:lnTo>
                <a:lnTo>
                  <a:pt x="550" y="5"/>
                </a:lnTo>
                <a:lnTo>
                  <a:pt x="550" y="5"/>
                </a:lnTo>
                <a:lnTo>
                  <a:pt x="557" y="6"/>
                </a:lnTo>
                <a:lnTo>
                  <a:pt x="557" y="6"/>
                </a:lnTo>
                <a:lnTo>
                  <a:pt x="565" y="6"/>
                </a:lnTo>
                <a:lnTo>
                  <a:pt x="565" y="6"/>
                </a:lnTo>
                <a:lnTo>
                  <a:pt x="572" y="6"/>
                </a:lnTo>
                <a:lnTo>
                  <a:pt x="572" y="6"/>
                </a:lnTo>
                <a:lnTo>
                  <a:pt x="580" y="7"/>
                </a:lnTo>
                <a:lnTo>
                  <a:pt x="580" y="7"/>
                </a:lnTo>
                <a:lnTo>
                  <a:pt x="587" y="8"/>
                </a:lnTo>
                <a:lnTo>
                  <a:pt x="587" y="8"/>
                </a:lnTo>
                <a:lnTo>
                  <a:pt x="594" y="8"/>
                </a:lnTo>
                <a:lnTo>
                  <a:pt x="594" y="8"/>
                </a:lnTo>
                <a:lnTo>
                  <a:pt x="602" y="9"/>
                </a:lnTo>
                <a:lnTo>
                  <a:pt x="602" y="9"/>
                </a:lnTo>
                <a:lnTo>
                  <a:pt x="610" y="10"/>
                </a:lnTo>
                <a:lnTo>
                  <a:pt x="610" y="10"/>
                </a:lnTo>
                <a:lnTo>
                  <a:pt x="618" y="11"/>
                </a:lnTo>
                <a:lnTo>
                  <a:pt x="618" y="11"/>
                </a:lnTo>
                <a:lnTo>
                  <a:pt x="625" y="11"/>
                </a:lnTo>
                <a:lnTo>
                  <a:pt x="625" y="11"/>
                </a:lnTo>
                <a:lnTo>
                  <a:pt x="632" y="12"/>
                </a:lnTo>
                <a:lnTo>
                  <a:pt x="632" y="12"/>
                </a:lnTo>
                <a:lnTo>
                  <a:pt x="640" y="14"/>
                </a:lnTo>
                <a:lnTo>
                  <a:pt x="640" y="14"/>
                </a:lnTo>
                <a:lnTo>
                  <a:pt x="647" y="14"/>
                </a:lnTo>
                <a:lnTo>
                  <a:pt x="647" y="14"/>
                </a:lnTo>
                <a:lnTo>
                  <a:pt x="655" y="16"/>
                </a:lnTo>
                <a:lnTo>
                  <a:pt x="655" y="16"/>
                </a:lnTo>
                <a:lnTo>
                  <a:pt x="663" y="17"/>
                </a:lnTo>
                <a:lnTo>
                  <a:pt x="663" y="17"/>
                </a:lnTo>
                <a:lnTo>
                  <a:pt x="671" y="19"/>
                </a:lnTo>
                <a:lnTo>
                  <a:pt x="671" y="19"/>
                </a:lnTo>
                <a:lnTo>
                  <a:pt x="678" y="20"/>
                </a:lnTo>
                <a:lnTo>
                  <a:pt x="678" y="20"/>
                </a:lnTo>
                <a:lnTo>
                  <a:pt x="685" y="21"/>
                </a:lnTo>
                <a:lnTo>
                  <a:pt x="685" y="21"/>
                </a:lnTo>
                <a:lnTo>
                  <a:pt x="693" y="24"/>
                </a:lnTo>
                <a:lnTo>
                  <a:pt x="693" y="24"/>
                </a:lnTo>
                <a:lnTo>
                  <a:pt x="700" y="25"/>
                </a:lnTo>
                <a:lnTo>
                  <a:pt x="700" y="25"/>
                </a:lnTo>
                <a:lnTo>
                  <a:pt x="708" y="27"/>
                </a:lnTo>
                <a:lnTo>
                  <a:pt x="708" y="27"/>
                </a:lnTo>
                <a:lnTo>
                  <a:pt x="715" y="29"/>
                </a:lnTo>
                <a:lnTo>
                  <a:pt x="715" y="29"/>
                </a:lnTo>
                <a:lnTo>
                  <a:pt x="723" y="33"/>
                </a:lnTo>
                <a:lnTo>
                  <a:pt x="723" y="33"/>
                </a:lnTo>
                <a:lnTo>
                  <a:pt x="731" y="34"/>
                </a:lnTo>
                <a:lnTo>
                  <a:pt x="731" y="34"/>
                </a:lnTo>
                <a:lnTo>
                  <a:pt x="738" y="37"/>
                </a:lnTo>
                <a:lnTo>
                  <a:pt x="738" y="37"/>
                </a:lnTo>
                <a:lnTo>
                  <a:pt x="746" y="40"/>
                </a:lnTo>
                <a:lnTo>
                  <a:pt x="746" y="40"/>
                </a:lnTo>
                <a:lnTo>
                  <a:pt x="753" y="43"/>
                </a:lnTo>
                <a:lnTo>
                  <a:pt x="753" y="43"/>
                </a:lnTo>
                <a:lnTo>
                  <a:pt x="761" y="47"/>
                </a:lnTo>
                <a:lnTo>
                  <a:pt x="761" y="47"/>
                </a:lnTo>
                <a:lnTo>
                  <a:pt x="768" y="51"/>
                </a:lnTo>
                <a:lnTo>
                  <a:pt x="768" y="51"/>
                </a:lnTo>
                <a:lnTo>
                  <a:pt x="775" y="55"/>
                </a:lnTo>
                <a:lnTo>
                  <a:pt x="775" y="55"/>
                </a:lnTo>
                <a:lnTo>
                  <a:pt x="783" y="59"/>
                </a:lnTo>
                <a:lnTo>
                  <a:pt x="783" y="59"/>
                </a:lnTo>
                <a:lnTo>
                  <a:pt x="791" y="64"/>
                </a:lnTo>
                <a:lnTo>
                  <a:pt x="791" y="64"/>
                </a:lnTo>
                <a:lnTo>
                  <a:pt x="799" y="69"/>
                </a:lnTo>
                <a:lnTo>
                  <a:pt x="799" y="69"/>
                </a:lnTo>
                <a:lnTo>
                  <a:pt x="806" y="74"/>
                </a:lnTo>
                <a:lnTo>
                  <a:pt x="806" y="74"/>
                </a:lnTo>
                <a:lnTo>
                  <a:pt x="813" y="79"/>
                </a:lnTo>
                <a:lnTo>
                  <a:pt x="813" y="79"/>
                </a:lnTo>
                <a:lnTo>
                  <a:pt x="821" y="85"/>
                </a:lnTo>
                <a:lnTo>
                  <a:pt x="821" y="85"/>
                </a:lnTo>
                <a:lnTo>
                  <a:pt x="828" y="92"/>
                </a:lnTo>
                <a:lnTo>
                  <a:pt x="828" y="92"/>
                </a:lnTo>
                <a:lnTo>
                  <a:pt x="836" y="98"/>
                </a:lnTo>
                <a:lnTo>
                  <a:pt x="836" y="98"/>
                </a:lnTo>
                <a:lnTo>
                  <a:pt x="844" y="106"/>
                </a:lnTo>
                <a:lnTo>
                  <a:pt x="844" y="106"/>
                </a:lnTo>
                <a:lnTo>
                  <a:pt x="851" y="113"/>
                </a:lnTo>
                <a:lnTo>
                  <a:pt x="851" y="113"/>
                </a:lnTo>
                <a:lnTo>
                  <a:pt x="859" y="121"/>
                </a:lnTo>
                <a:lnTo>
                  <a:pt x="859" y="121"/>
                </a:lnTo>
                <a:lnTo>
                  <a:pt x="866" y="130"/>
                </a:lnTo>
                <a:lnTo>
                  <a:pt x="866" y="130"/>
                </a:lnTo>
                <a:lnTo>
                  <a:pt x="874" y="140"/>
                </a:lnTo>
                <a:lnTo>
                  <a:pt x="874" y="140"/>
                </a:lnTo>
                <a:lnTo>
                  <a:pt x="881" y="149"/>
                </a:lnTo>
                <a:lnTo>
                  <a:pt x="881" y="149"/>
                </a:lnTo>
                <a:lnTo>
                  <a:pt x="889" y="160"/>
                </a:lnTo>
                <a:lnTo>
                  <a:pt x="889" y="160"/>
                </a:lnTo>
                <a:lnTo>
                  <a:pt x="896" y="171"/>
                </a:lnTo>
                <a:lnTo>
                  <a:pt x="896" y="171"/>
                </a:lnTo>
                <a:lnTo>
                  <a:pt x="903" y="182"/>
                </a:lnTo>
                <a:lnTo>
                  <a:pt x="903" y="182"/>
                </a:lnTo>
                <a:lnTo>
                  <a:pt x="912" y="194"/>
                </a:lnTo>
                <a:lnTo>
                  <a:pt x="912" y="194"/>
                </a:lnTo>
                <a:lnTo>
                  <a:pt x="919" y="206"/>
                </a:lnTo>
                <a:lnTo>
                  <a:pt x="919" y="206"/>
                </a:lnTo>
                <a:lnTo>
                  <a:pt x="927" y="219"/>
                </a:lnTo>
                <a:lnTo>
                  <a:pt x="927" y="219"/>
                </a:lnTo>
                <a:lnTo>
                  <a:pt x="934" y="233"/>
                </a:lnTo>
                <a:lnTo>
                  <a:pt x="934" y="233"/>
                </a:lnTo>
                <a:lnTo>
                  <a:pt x="942" y="248"/>
                </a:lnTo>
                <a:lnTo>
                  <a:pt x="942" y="248"/>
                </a:lnTo>
                <a:lnTo>
                  <a:pt x="949" y="262"/>
                </a:lnTo>
                <a:lnTo>
                  <a:pt x="949" y="262"/>
                </a:lnTo>
                <a:lnTo>
                  <a:pt x="956" y="278"/>
                </a:lnTo>
                <a:lnTo>
                  <a:pt x="956" y="278"/>
                </a:lnTo>
                <a:lnTo>
                  <a:pt x="964" y="294"/>
                </a:lnTo>
                <a:lnTo>
                  <a:pt x="964" y="294"/>
                </a:lnTo>
                <a:lnTo>
                  <a:pt x="972" y="310"/>
                </a:lnTo>
                <a:lnTo>
                  <a:pt x="972" y="310"/>
                </a:lnTo>
                <a:lnTo>
                  <a:pt x="980" y="327"/>
                </a:lnTo>
                <a:lnTo>
                  <a:pt x="980" y="327"/>
                </a:lnTo>
                <a:lnTo>
                  <a:pt x="987" y="344"/>
                </a:lnTo>
                <a:lnTo>
                  <a:pt x="987" y="344"/>
                </a:lnTo>
                <a:lnTo>
                  <a:pt x="994" y="361"/>
                </a:lnTo>
                <a:lnTo>
                  <a:pt x="994" y="361"/>
                </a:lnTo>
                <a:lnTo>
                  <a:pt x="1002" y="380"/>
                </a:lnTo>
                <a:lnTo>
                  <a:pt x="1002" y="380"/>
                </a:lnTo>
                <a:lnTo>
                  <a:pt x="1009" y="398"/>
                </a:lnTo>
                <a:lnTo>
                  <a:pt x="1009" y="398"/>
                </a:lnTo>
                <a:lnTo>
                  <a:pt x="1017" y="416"/>
                </a:lnTo>
                <a:lnTo>
                  <a:pt x="1017" y="416"/>
                </a:lnTo>
                <a:lnTo>
                  <a:pt x="1024" y="434"/>
                </a:lnTo>
                <a:lnTo>
                  <a:pt x="1024" y="434"/>
                </a:lnTo>
                <a:lnTo>
                  <a:pt x="1032" y="453"/>
                </a:lnTo>
                <a:lnTo>
                  <a:pt x="1032" y="453"/>
                </a:lnTo>
                <a:lnTo>
                  <a:pt x="1040" y="472"/>
                </a:lnTo>
                <a:lnTo>
                  <a:pt x="1040" y="472"/>
                </a:lnTo>
                <a:lnTo>
                  <a:pt x="1047" y="490"/>
                </a:lnTo>
                <a:lnTo>
                  <a:pt x="1047" y="490"/>
                </a:lnTo>
                <a:lnTo>
                  <a:pt x="1055" y="509"/>
                </a:lnTo>
                <a:lnTo>
                  <a:pt x="1055" y="509"/>
                </a:lnTo>
                <a:lnTo>
                  <a:pt x="1062" y="528"/>
                </a:lnTo>
                <a:lnTo>
                  <a:pt x="1062" y="528"/>
                </a:lnTo>
                <a:lnTo>
                  <a:pt x="1070" y="546"/>
                </a:lnTo>
                <a:lnTo>
                  <a:pt x="1070" y="546"/>
                </a:lnTo>
                <a:lnTo>
                  <a:pt x="1077" y="564"/>
                </a:lnTo>
                <a:lnTo>
                  <a:pt x="1077" y="564"/>
                </a:lnTo>
                <a:lnTo>
                  <a:pt x="1084" y="583"/>
                </a:lnTo>
                <a:lnTo>
                  <a:pt x="1084" y="583"/>
                </a:lnTo>
                <a:lnTo>
                  <a:pt x="1093" y="600"/>
                </a:lnTo>
                <a:lnTo>
                  <a:pt x="1093" y="600"/>
                </a:lnTo>
                <a:lnTo>
                  <a:pt x="1100" y="617"/>
                </a:lnTo>
                <a:lnTo>
                  <a:pt x="1100" y="617"/>
                </a:lnTo>
                <a:lnTo>
                  <a:pt x="1108" y="633"/>
                </a:lnTo>
                <a:lnTo>
                  <a:pt x="1108" y="633"/>
                </a:lnTo>
                <a:lnTo>
                  <a:pt x="1115" y="650"/>
                </a:lnTo>
                <a:lnTo>
                  <a:pt x="1115" y="650"/>
                </a:lnTo>
                <a:lnTo>
                  <a:pt x="1123" y="665"/>
                </a:lnTo>
              </a:path>
            </a:pathLst>
          </a:custGeom>
          <a:noFill/>
          <a:ln w="142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angle 60"/>
          <p:cNvSpPr>
            <a:spLocks noChangeArrowheads="1"/>
          </p:cNvSpPr>
          <p:nvPr/>
        </p:nvSpPr>
        <p:spPr bwMode="auto">
          <a:xfrm>
            <a:off x="1568054" y="2624266"/>
            <a:ext cx="639599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 dirty="0">
                <a:solidFill>
                  <a:srgbClr val="000000"/>
                </a:solidFill>
                <a:cs typeface="Arial" panose="020B0604020202020204" pitchFamily="34" charset="0"/>
              </a:rPr>
              <a:t>Log Molar </a:t>
            </a:r>
            <a:r>
              <a:rPr lang="en-US" altLang="en-US" sz="675" b="1" dirty="0" err="1">
                <a:solidFill>
                  <a:srgbClr val="000000"/>
                </a:solidFill>
                <a:cs typeface="Arial" panose="020B0604020202020204" pitchFamily="34" charset="0"/>
              </a:rPr>
              <a:t>conc</a:t>
            </a:r>
            <a:endParaRPr lang="en-US" altLang="en-US" sz="675" dirty="0">
              <a:cs typeface="Arial" panose="020B0604020202020204" pitchFamily="34" charset="0"/>
            </a:endParaRPr>
          </a:p>
        </p:txBody>
      </p:sp>
      <p:sp>
        <p:nvSpPr>
          <p:cNvPr id="96" name="Rectangle 95"/>
          <p:cNvSpPr/>
          <p:nvPr/>
        </p:nvSpPr>
        <p:spPr>
          <a:xfrm rot="16200000">
            <a:off x="9501" y="1884665"/>
            <a:ext cx="148149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750" b="1" dirty="0"/>
              <a:t>RFU (Ex 340 nm/Em 460 nm)</a:t>
            </a:r>
            <a:endParaRPr lang="en-US" sz="750" b="1" dirty="0"/>
          </a:p>
        </p:txBody>
      </p:sp>
      <p:sp>
        <p:nvSpPr>
          <p:cNvPr id="101" name="Rectangle 90"/>
          <p:cNvSpPr>
            <a:spLocks noChangeArrowheads="1"/>
          </p:cNvSpPr>
          <p:nvPr/>
        </p:nvSpPr>
        <p:spPr bwMode="auto">
          <a:xfrm>
            <a:off x="3175397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8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2" name="Rectangle 91"/>
          <p:cNvSpPr>
            <a:spLocks noChangeArrowheads="1"/>
          </p:cNvSpPr>
          <p:nvPr/>
        </p:nvSpPr>
        <p:spPr bwMode="auto">
          <a:xfrm>
            <a:off x="3356372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8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3" name="Rectangle 92"/>
          <p:cNvSpPr>
            <a:spLocks noChangeArrowheads="1"/>
          </p:cNvSpPr>
          <p:nvPr/>
        </p:nvSpPr>
        <p:spPr bwMode="auto">
          <a:xfrm>
            <a:off x="3538538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7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4" name="Rectangle 93"/>
          <p:cNvSpPr>
            <a:spLocks noChangeArrowheads="1"/>
          </p:cNvSpPr>
          <p:nvPr/>
        </p:nvSpPr>
        <p:spPr bwMode="auto">
          <a:xfrm>
            <a:off x="3719513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7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5" name="Rectangle 94"/>
          <p:cNvSpPr>
            <a:spLocks noChangeArrowheads="1"/>
          </p:cNvSpPr>
          <p:nvPr/>
        </p:nvSpPr>
        <p:spPr bwMode="auto">
          <a:xfrm>
            <a:off x="3901679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6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6" name="Rectangle 95"/>
          <p:cNvSpPr>
            <a:spLocks noChangeArrowheads="1"/>
          </p:cNvSpPr>
          <p:nvPr/>
        </p:nvSpPr>
        <p:spPr bwMode="auto">
          <a:xfrm>
            <a:off x="4082654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6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7" name="Rectangle 96"/>
          <p:cNvSpPr>
            <a:spLocks noChangeArrowheads="1"/>
          </p:cNvSpPr>
          <p:nvPr/>
        </p:nvSpPr>
        <p:spPr bwMode="auto">
          <a:xfrm>
            <a:off x="4264820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5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8" name="Rectangle 97"/>
          <p:cNvSpPr>
            <a:spLocks noChangeArrowheads="1"/>
          </p:cNvSpPr>
          <p:nvPr/>
        </p:nvSpPr>
        <p:spPr bwMode="auto">
          <a:xfrm>
            <a:off x="4445795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5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09" name="Rectangle 98"/>
          <p:cNvSpPr>
            <a:spLocks noChangeArrowheads="1"/>
          </p:cNvSpPr>
          <p:nvPr/>
        </p:nvSpPr>
        <p:spPr bwMode="auto">
          <a:xfrm>
            <a:off x="4627960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4.5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0" name="Rectangle 99"/>
          <p:cNvSpPr>
            <a:spLocks noChangeArrowheads="1"/>
          </p:cNvSpPr>
          <p:nvPr/>
        </p:nvSpPr>
        <p:spPr bwMode="auto">
          <a:xfrm>
            <a:off x="4808935" y="2514601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-4.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1" name="Freeform 100"/>
          <p:cNvSpPr>
            <a:spLocks noEditPoints="1"/>
          </p:cNvSpPr>
          <p:nvPr/>
        </p:nvSpPr>
        <p:spPr bwMode="auto">
          <a:xfrm>
            <a:off x="3239691" y="2468167"/>
            <a:ext cx="1644254" cy="32147"/>
          </a:xfrm>
          <a:custGeom>
            <a:avLst/>
            <a:gdLst>
              <a:gd name="T0" fmla="*/ 0 w 1381"/>
              <a:gd name="T1" fmla="*/ 0 h 27"/>
              <a:gd name="T2" fmla="*/ 1381 w 1381"/>
              <a:gd name="T3" fmla="*/ 0 h 27"/>
              <a:gd name="T4" fmla="*/ 5 w 1381"/>
              <a:gd name="T5" fmla="*/ 0 h 27"/>
              <a:gd name="T6" fmla="*/ 5 w 1381"/>
              <a:gd name="T7" fmla="*/ 27 h 27"/>
              <a:gd name="T8" fmla="*/ 157 w 1381"/>
              <a:gd name="T9" fmla="*/ 0 h 27"/>
              <a:gd name="T10" fmla="*/ 157 w 1381"/>
              <a:gd name="T11" fmla="*/ 27 h 27"/>
              <a:gd name="T12" fmla="*/ 310 w 1381"/>
              <a:gd name="T13" fmla="*/ 0 h 27"/>
              <a:gd name="T14" fmla="*/ 310 w 1381"/>
              <a:gd name="T15" fmla="*/ 27 h 27"/>
              <a:gd name="T16" fmla="*/ 462 w 1381"/>
              <a:gd name="T17" fmla="*/ 0 h 27"/>
              <a:gd name="T18" fmla="*/ 462 w 1381"/>
              <a:gd name="T19" fmla="*/ 27 h 27"/>
              <a:gd name="T20" fmla="*/ 614 w 1381"/>
              <a:gd name="T21" fmla="*/ 0 h 27"/>
              <a:gd name="T22" fmla="*/ 614 w 1381"/>
              <a:gd name="T23" fmla="*/ 27 h 27"/>
              <a:gd name="T24" fmla="*/ 767 w 1381"/>
              <a:gd name="T25" fmla="*/ 0 h 27"/>
              <a:gd name="T26" fmla="*/ 767 w 1381"/>
              <a:gd name="T27" fmla="*/ 27 h 27"/>
              <a:gd name="T28" fmla="*/ 919 w 1381"/>
              <a:gd name="T29" fmla="*/ 0 h 27"/>
              <a:gd name="T30" fmla="*/ 919 w 1381"/>
              <a:gd name="T31" fmla="*/ 27 h 27"/>
              <a:gd name="T32" fmla="*/ 1072 w 1381"/>
              <a:gd name="T33" fmla="*/ 0 h 27"/>
              <a:gd name="T34" fmla="*/ 1072 w 1381"/>
              <a:gd name="T35" fmla="*/ 27 h 27"/>
              <a:gd name="T36" fmla="*/ 1224 w 1381"/>
              <a:gd name="T37" fmla="*/ 0 h 27"/>
              <a:gd name="T38" fmla="*/ 1224 w 1381"/>
              <a:gd name="T39" fmla="*/ 27 h 27"/>
              <a:gd name="T40" fmla="*/ 1377 w 1381"/>
              <a:gd name="T41" fmla="*/ 0 h 27"/>
              <a:gd name="T42" fmla="*/ 1377 w 1381"/>
              <a:gd name="T43" fmla="*/ 27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381" h="27">
                <a:moveTo>
                  <a:pt x="0" y="0"/>
                </a:moveTo>
                <a:lnTo>
                  <a:pt x="1381" y="0"/>
                </a:lnTo>
                <a:moveTo>
                  <a:pt x="5" y="0"/>
                </a:moveTo>
                <a:lnTo>
                  <a:pt x="5" y="27"/>
                </a:lnTo>
                <a:moveTo>
                  <a:pt x="157" y="0"/>
                </a:moveTo>
                <a:lnTo>
                  <a:pt x="157" y="27"/>
                </a:lnTo>
                <a:moveTo>
                  <a:pt x="310" y="0"/>
                </a:moveTo>
                <a:lnTo>
                  <a:pt x="310" y="27"/>
                </a:lnTo>
                <a:moveTo>
                  <a:pt x="462" y="0"/>
                </a:moveTo>
                <a:lnTo>
                  <a:pt x="462" y="27"/>
                </a:lnTo>
                <a:moveTo>
                  <a:pt x="614" y="0"/>
                </a:moveTo>
                <a:lnTo>
                  <a:pt x="614" y="27"/>
                </a:lnTo>
                <a:moveTo>
                  <a:pt x="767" y="0"/>
                </a:moveTo>
                <a:lnTo>
                  <a:pt x="767" y="27"/>
                </a:lnTo>
                <a:moveTo>
                  <a:pt x="919" y="0"/>
                </a:moveTo>
                <a:lnTo>
                  <a:pt x="919" y="27"/>
                </a:lnTo>
                <a:moveTo>
                  <a:pt x="1072" y="0"/>
                </a:moveTo>
                <a:lnTo>
                  <a:pt x="1072" y="27"/>
                </a:lnTo>
                <a:moveTo>
                  <a:pt x="1224" y="0"/>
                </a:moveTo>
                <a:lnTo>
                  <a:pt x="1224" y="27"/>
                </a:lnTo>
                <a:moveTo>
                  <a:pt x="1377" y="0"/>
                </a:moveTo>
                <a:lnTo>
                  <a:pt x="1377" y="27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01"/>
          <p:cNvSpPr>
            <a:spLocks noChangeArrowheads="1"/>
          </p:cNvSpPr>
          <p:nvPr/>
        </p:nvSpPr>
        <p:spPr bwMode="auto">
          <a:xfrm>
            <a:off x="2970610" y="2418160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1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3" name="Rectangle 102"/>
          <p:cNvSpPr>
            <a:spLocks noChangeArrowheads="1"/>
          </p:cNvSpPr>
          <p:nvPr/>
        </p:nvSpPr>
        <p:spPr bwMode="auto">
          <a:xfrm>
            <a:off x="2970610" y="2264569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2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4" name="Rectangle 103"/>
          <p:cNvSpPr>
            <a:spLocks noChangeArrowheads="1"/>
          </p:cNvSpPr>
          <p:nvPr/>
        </p:nvSpPr>
        <p:spPr bwMode="auto">
          <a:xfrm>
            <a:off x="2970610" y="2105026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3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5" name="Rectangle 104"/>
          <p:cNvSpPr>
            <a:spLocks noChangeArrowheads="1"/>
          </p:cNvSpPr>
          <p:nvPr/>
        </p:nvSpPr>
        <p:spPr bwMode="auto">
          <a:xfrm>
            <a:off x="2970610" y="1951435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4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6" name="Rectangle 105"/>
          <p:cNvSpPr>
            <a:spLocks noChangeArrowheads="1"/>
          </p:cNvSpPr>
          <p:nvPr/>
        </p:nvSpPr>
        <p:spPr bwMode="auto">
          <a:xfrm>
            <a:off x="2970610" y="1793082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5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7" name="Rectangle 106"/>
          <p:cNvSpPr>
            <a:spLocks noChangeArrowheads="1"/>
          </p:cNvSpPr>
          <p:nvPr/>
        </p:nvSpPr>
        <p:spPr bwMode="auto">
          <a:xfrm>
            <a:off x="2970610" y="1639492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6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8" name="Rectangle 107"/>
          <p:cNvSpPr>
            <a:spLocks noChangeArrowheads="1"/>
          </p:cNvSpPr>
          <p:nvPr/>
        </p:nvSpPr>
        <p:spPr bwMode="auto">
          <a:xfrm>
            <a:off x="2970610" y="1485901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7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19" name="Rectangle 108"/>
          <p:cNvSpPr>
            <a:spLocks noChangeArrowheads="1"/>
          </p:cNvSpPr>
          <p:nvPr/>
        </p:nvSpPr>
        <p:spPr bwMode="auto">
          <a:xfrm>
            <a:off x="2970610" y="1327548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80000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20" name="Freeform 109"/>
          <p:cNvSpPr>
            <a:spLocks noEditPoints="1"/>
          </p:cNvSpPr>
          <p:nvPr/>
        </p:nvSpPr>
        <p:spPr bwMode="auto">
          <a:xfrm>
            <a:off x="3212307" y="1371600"/>
            <a:ext cx="33338" cy="1101329"/>
          </a:xfrm>
          <a:custGeom>
            <a:avLst/>
            <a:gdLst>
              <a:gd name="T0" fmla="*/ 28 w 28"/>
              <a:gd name="T1" fmla="*/ 925 h 925"/>
              <a:gd name="T2" fmla="*/ 28 w 28"/>
              <a:gd name="T3" fmla="*/ 0 h 925"/>
              <a:gd name="T4" fmla="*/ 28 w 28"/>
              <a:gd name="T5" fmla="*/ 921 h 925"/>
              <a:gd name="T6" fmla="*/ 0 w 28"/>
              <a:gd name="T7" fmla="*/ 921 h 925"/>
              <a:gd name="T8" fmla="*/ 28 w 28"/>
              <a:gd name="T9" fmla="*/ 790 h 925"/>
              <a:gd name="T10" fmla="*/ 0 w 28"/>
              <a:gd name="T11" fmla="*/ 790 h 925"/>
              <a:gd name="T12" fmla="*/ 28 w 28"/>
              <a:gd name="T13" fmla="*/ 660 h 925"/>
              <a:gd name="T14" fmla="*/ 0 w 28"/>
              <a:gd name="T15" fmla="*/ 660 h 925"/>
              <a:gd name="T16" fmla="*/ 28 w 28"/>
              <a:gd name="T17" fmla="*/ 528 h 925"/>
              <a:gd name="T18" fmla="*/ 0 w 28"/>
              <a:gd name="T19" fmla="*/ 528 h 925"/>
              <a:gd name="T20" fmla="*/ 28 w 28"/>
              <a:gd name="T21" fmla="*/ 398 h 925"/>
              <a:gd name="T22" fmla="*/ 0 w 28"/>
              <a:gd name="T23" fmla="*/ 398 h 925"/>
              <a:gd name="T24" fmla="*/ 28 w 28"/>
              <a:gd name="T25" fmla="*/ 267 h 925"/>
              <a:gd name="T26" fmla="*/ 0 w 28"/>
              <a:gd name="T27" fmla="*/ 267 h 925"/>
              <a:gd name="T28" fmla="*/ 28 w 28"/>
              <a:gd name="T29" fmla="*/ 136 h 925"/>
              <a:gd name="T30" fmla="*/ 0 w 28"/>
              <a:gd name="T31" fmla="*/ 136 h 925"/>
              <a:gd name="T32" fmla="*/ 28 w 28"/>
              <a:gd name="T33" fmla="*/ 5 h 925"/>
              <a:gd name="T34" fmla="*/ 0 w 28"/>
              <a:gd name="T35" fmla="*/ 5 h 9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</a:cxnLst>
            <a:rect l="0" t="0" r="r" b="b"/>
            <a:pathLst>
              <a:path w="28" h="925">
                <a:moveTo>
                  <a:pt x="28" y="925"/>
                </a:moveTo>
                <a:lnTo>
                  <a:pt x="28" y="0"/>
                </a:lnTo>
                <a:moveTo>
                  <a:pt x="28" y="921"/>
                </a:moveTo>
                <a:lnTo>
                  <a:pt x="0" y="921"/>
                </a:lnTo>
                <a:moveTo>
                  <a:pt x="28" y="790"/>
                </a:moveTo>
                <a:lnTo>
                  <a:pt x="0" y="790"/>
                </a:lnTo>
                <a:moveTo>
                  <a:pt x="28" y="660"/>
                </a:moveTo>
                <a:lnTo>
                  <a:pt x="0" y="660"/>
                </a:lnTo>
                <a:moveTo>
                  <a:pt x="28" y="528"/>
                </a:moveTo>
                <a:lnTo>
                  <a:pt x="0" y="528"/>
                </a:lnTo>
                <a:moveTo>
                  <a:pt x="28" y="398"/>
                </a:moveTo>
                <a:lnTo>
                  <a:pt x="0" y="398"/>
                </a:lnTo>
                <a:moveTo>
                  <a:pt x="28" y="267"/>
                </a:moveTo>
                <a:lnTo>
                  <a:pt x="0" y="267"/>
                </a:lnTo>
                <a:moveTo>
                  <a:pt x="28" y="136"/>
                </a:moveTo>
                <a:lnTo>
                  <a:pt x="0" y="136"/>
                </a:lnTo>
                <a:moveTo>
                  <a:pt x="28" y="5"/>
                </a:moveTo>
                <a:lnTo>
                  <a:pt x="0" y="5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Line 110"/>
          <p:cNvSpPr>
            <a:spLocks noChangeShapeType="1"/>
          </p:cNvSpPr>
          <p:nvPr/>
        </p:nvSpPr>
        <p:spPr bwMode="auto">
          <a:xfrm>
            <a:off x="3426620" y="1712119"/>
            <a:ext cx="0" cy="58341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Line 111"/>
          <p:cNvSpPr>
            <a:spLocks noChangeShapeType="1"/>
          </p:cNvSpPr>
          <p:nvPr/>
        </p:nvSpPr>
        <p:spPr bwMode="auto">
          <a:xfrm>
            <a:off x="3426620" y="1770460"/>
            <a:ext cx="0" cy="58341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Line 112"/>
          <p:cNvSpPr>
            <a:spLocks noChangeShapeType="1"/>
          </p:cNvSpPr>
          <p:nvPr/>
        </p:nvSpPr>
        <p:spPr bwMode="auto">
          <a:xfrm>
            <a:off x="3401617" y="1712119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Line 113"/>
          <p:cNvSpPr>
            <a:spLocks noChangeShapeType="1"/>
          </p:cNvSpPr>
          <p:nvPr/>
        </p:nvSpPr>
        <p:spPr bwMode="auto">
          <a:xfrm>
            <a:off x="3401617" y="1828800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Line 114"/>
          <p:cNvSpPr>
            <a:spLocks noChangeShapeType="1"/>
          </p:cNvSpPr>
          <p:nvPr/>
        </p:nvSpPr>
        <p:spPr bwMode="auto">
          <a:xfrm>
            <a:off x="3681413" y="1627585"/>
            <a:ext cx="0" cy="30956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Line 115"/>
          <p:cNvSpPr>
            <a:spLocks noChangeShapeType="1"/>
          </p:cNvSpPr>
          <p:nvPr/>
        </p:nvSpPr>
        <p:spPr bwMode="auto">
          <a:xfrm>
            <a:off x="3681413" y="1658541"/>
            <a:ext cx="0" cy="29766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Line 116"/>
          <p:cNvSpPr>
            <a:spLocks noChangeShapeType="1"/>
          </p:cNvSpPr>
          <p:nvPr/>
        </p:nvSpPr>
        <p:spPr bwMode="auto">
          <a:xfrm>
            <a:off x="3656410" y="1627585"/>
            <a:ext cx="4881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Line 117"/>
          <p:cNvSpPr>
            <a:spLocks noChangeShapeType="1"/>
          </p:cNvSpPr>
          <p:nvPr/>
        </p:nvSpPr>
        <p:spPr bwMode="auto">
          <a:xfrm>
            <a:off x="3656410" y="1688306"/>
            <a:ext cx="4881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Line 118"/>
          <p:cNvSpPr>
            <a:spLocks noChangeShapeType="1"/>
          </p:cNvSpPr>
          <p:nvPr/>
        </p:nvSpPr>
        <p:spPr bwMode="auto">
          <a:xfrm>
            <a:off x="4152901" y="1510903"/>
            <a:ext cx="0" cy="42863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Line 119"/>
          <p:cNvSpPr>
            <a:spLocks noChangeShapeType="1"/>
          </p:cNvSpPr>
          <p:nvPr/>
        </p:nvSpPr>
        <p:spPr bwMode="auto">
          <a:xfrm>
            <a:off x="4152901" y="1553766"/>
            <a:ext cx="0" cy="42863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Line 120"/>
          <p:cNvSpPr>
            <a:spLocks noChangeShapeType="1"/>
          </p:cNvSpPr>
          <p:nvPr/>
        </p:nvSpPr>
        <p:spPr bwMode="auto">
          <a:xfrm>
            <a:off x="4127898" y="1510904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Line 121"/>
          <p:cNvSpPr>
            <a:spLocks noChangeShapeType="1"/>
          </p:cNvSpPr>
          <p:nvPr/>
        </p:nvSpPr>
        <p:spPr bwMode="auto">
          <a:xfrm>
            <a:off x="4127898" y="1596629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Line 122"/>
          <p:cNvSpPr>
            <a:spLocks noChangeShapeType="1"/>
          </p:cNvSpPr>
          <p:nvPr/>
        </p:nvSpPr>
        <p:spPr bwMode="auto">
          <a:xfrm>
            <a:off x="4516041" y="1743075"/>
            <a:ext cx="0" cy="27385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Line 123"/>
          <p:cNvSpPr>
            <a:spLocks noChangeShapeType="1"/>
          </p:cNvSpPr>
          <p:nvPr/>
        </p:nvSpPr>
        <p:spPr bwMode="auto">
          <a:xfrm>
            <a:off x="4516041" y="1770460"/>
            <a:ext cx="0" cy="28575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Line 124"/>
          <p:cNvSpPr>
            <a:spLocks noChangeShapeType="1"/>
          </p:cNvSpPr>
          <p:nvPr/>
        </p:nvSpPr>
        <p:spPr bwMode="auto">
          <a:xfrm>
            <a:off x="4491039" y="1743075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Line 125"/>
          <p:cNvSpPr>
            <a:spLocks noChangeShapeType="1"/>
          </p:cNvSpPr>
          <p:nvPr/>
        </p:nvSpPr>
        <p:spPr bwMode="auto">
          <a:xfrm>
            <a:off x="4491039" y="1799035"/>
            <a:ext cx="50006" cy="0"/>
          </a:xfrm>
          <a:prstGeom prst="line">
            <a:avLst/>
          </a:prstGeom>
          <a:noFill/>
          <a:ln w="22225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Oval 126"/>
          <p:cNvSpPr>
            <a:spLocks noChangeArrowheads="1"/>
          </p:cNvSpPr>
          <p:nvPr/>
        </p:nvSpPr>
        <p:spPr bwMode="auto">
          <a:xfrm>
            <a:off x="3405188" y="1749028"/>
            <a:ext cx="42863" cy="44054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Oval 127"/>
          <p:cNvSpPr>
            <a:spLocks noChangeArrowheads="1"/>
          </p:cNvSpPr>
          <p:nvPr/>
        </p:nvSpPr>
        <p:spPr bwMode="auto">
          <a:xfrm>
            <a:off x="3405188" y="1749028"/>
            <a:ext cx="42863" cy="44054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Oval 128"/>
          <p:cNvSpPr>
            <a:spLocks noChangeArrowheads="1"/>
          </p:cNvSpPr>
          <p:nvPr/>
        </p:nvSpPr>
        <p:spPr bwMode="auto">
          <a:xfrm>
            <a:off x="3658791" y="1635919"/>
            <a:ext cx="44054" cy="44054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Oval 129"/>
          <p:cNvSpPr>
            <a:spLocks noChangeArrowheads="1"/>
          </p:cNvSpPr>
          <p:nvPr/>
        </p:nvSpPr>
        <p:spPr bwMode="auto">
          <a:xfrm>
            <a:off x="3658791" y="1635919"/>
            <a:ext cx="44054" cy="44054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Oval 130"/>
          <p:cNvSpPr>
            <a:spLocks noChangeArrowheads="1"/>
          </p:cNvSpPr>
          <p:nvPr/>
        </p:nvSpPr>
        <p:spPr bwMode="auto">
          <a:xfrm>
            <a:off x="3768328" y="1554956"/>
            <a:ext cx="42863" cy="44054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Oval 131"/>
          <p:cNvSpPr>
            <a:spLocks noChangeArrowheads="1"/>
          </p:cNvSpPr>
          <p:nvPr/>
        </p:nvSpPr>
        <p:spPr bwMode="auto">
          <a:xfrm>
            <a:off x="3768328" y="1554956"/>
            <a:ext cx="42863" cy="44054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Oval 132"/>
          <p:cNvSpPr>
            <a:spLocks noChangeArrowheads="1"/>
          </p:cNvSpPr>
          <p:nvPr/>
        </p:nvSpPr>
        <p:spPr bwMode="auto">
          <a:xfrm>
            <a:off x="4131469" y="1532335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Oval 133"/>
          <p:cNvSpPr>
            <a:spLocks noChangeArrowheads="1"/>
          </p:cNvSpPr>
          <p:nvPr/>
        </p:nvSpPr>
        <p:spPr bwMode="auto">
          <a:xfrm>
            <a:off x="4131469" y="1532335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Oval 134"/>
          <p:cNvSpPr>
            <a:spLocks noChangeArrowheads="1"/>
          </p:cNvSpPr>
          <p:nvPr/>
        </p:nvSpPr>
        <p:spPr bwMode="auto">
          <a:xfrm>
            <a:off x="4494610" y="1749028"/>
            <a:ext cx="42863" cy="44054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Oval 135"/>
          <p:cNvSpPr>
            <a:spLocks noChangeArrowheads="1"/>
          </p:cNvSpPr>
          <p:nvPr/>
        </p:nvSpPr>
        <p:spPr bwMode="auto">
          <a:xfrm>
            <a:off x="4494610" y="1749028"/>
            <a:ext cx="42863" cy="44054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Oval 136"/>
          <p:cNvSpPr>
            <a:spLocks noChangeArrowheads="1"/>
          </p:cNvSpPr>
          <p:nvPr/>
        </p:nvSpPr>
        <p:spPr bwMode="auto">
          <a:xfrm>
            <a:off x="4639866" y="2031206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Oval 137"/>
          <p:cNvSpPr>
            <a:spLocks noChangeArrowheads="1"/>
          </p:cNvSpPr>
          <p:nvPr/>
        </p:nvSpPr>
        <p:spPr bwMode="auto">
          <a:xfrm>
            <a:off x="4639866" y="2031206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Oval 138"/>
          <p:cNvSpPr>
            <a:spLocks noChangeArrowheads="1"/>
          </p:cNvSpPr>
          <p:nvPr/>
        </p:nvSpPr>
        <p:spPr bwMode="auto">
          <a:xfrm>
            <a:off x="4748213" y="2314575"/>
            <a:ext cx="44054" cy="44054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Oval 139"/>
          <p:cNvSpPr>
            <a:spLocks noChangeArrowheads="1"/>
          </p:cNvSpPr>
          <p:nvPr/>
        </p:nvSpPr>
        <p:spPr bwMode="auto">
          <a:xfrm>
            <a:off x="4748213" y="2314575"/>
            <a:ext cx="44054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Oval 140"/>
          <p:cNvSpPr>
            <a:spLocks noChangeArrowheads="1"/>
          </p:cNvSpPr>
          <p:nvPr/>
        </p:nvSpPr>
        <p:spPr bwMode="auto">
          <a:xfrm>
            <a:off x="4813697" y="2412206"/>
            <a:ext cx="44054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Oval 141"/>
          <p:cNvSpPr>
            <a:spLocks noChangeArrowheads="1"/>
          </p:cNvSpPr>
          <p:nvPr/>
        </p:nvSpPr>
        <p:spPr bwMode="auto">
          <a:xfrm>
            <a:off x="4813697" y="2412206"/>
            <a:ext cx="44054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Freeform 142"/>
          <p:cNvSpPr>
            <a:spLocks/>
          </p:cNvSpPr>
          <p:nvPr/>
        </p:nvSpPr>
        <p:spPr bwMode="auto">
          <a:xfrm>
            <a:off x="3426620" y="1639491"/>
            <a:ext cx="1408510" cy="809625"/>
          </a:xfrm>
          <a:custGeom>
            <a:avLst/>
            <a:gdLst>
              <a:gd name="T0" fmla="*/ 8 w 1183"/>
              <a:gd name="T1" fmla="*/ 0 h 680"/>
              <a:gd name="T2" fmla="*/ 31 w 1183"/>
              <a:gd name="T3" fmla="*/ 0 h 680"/>
              <a:gd name="T4" fmla="*/ 47 w 1183"/>
              <a:gd name="T5" fmla="*/ 0 h 680"/>
              <a:gd name="T6" fmla="*/ 71 w 1183"/>
              <a:gd name="T7" fmla="*/ 0 h 680"/>
              <a:gd name="T8" fmla="*/ 87 w 1183"/>
              <a:gd name="T9" fmla="*/ 0 h 680"/>
              <a:gd name="T10" fmla="*/ 111 w 1183"/>
              <a:gd name="T11" fmla="*/ 0 h 680"/>
              <a:gd name="T12" fmla="*/ 127 w 1183"/>
              <a:gd name="T13" fmla="*/ 0 h 680"/>
              <a:gd name="T14" fmla="*/ 150 w 1183"/>
              <a:gd name="T15" fmla="*/ 0 h 680"/>
              <a:gd name="T16" fmla="*/ 166 w 1183"/>
              <a:gd name="T17" fmla="*/ 0 h 680"/>
              <a:gd name="T18" fmla="*/ 190 w 1183"/>
              <a:gd name="T19" fmla="*/ 0 h 680"/>
              <a:gd name="T20" fmla="*/ 206 w 1183"/>
              <a:gd name="T21" fmla="*/ 0 h 680"/>
              <a:gd name="T22" fmla="*/ 230 w 1183"/>
              <a:gd name="T23" fmla="*/ 0 h 680"/>
              <a:gd name="T24" fmla="*/ 245 w 1183"/>
              <a:gd name="T25" fmla="*/ 0 h 680"/>
              <a:gd name="T26" fmla="*/ 270 w 1183"/>
              <a:gd name="T27" fmla="*/ 0 h 680"/>
              <a:gd name="T28" fmla="*/ 285 w 1183"/>
              <a:gd name="T29" fmla="*/ 0 h 680"/>
              <a:gd name="T30" fmla="*/ 309 w 1183"/>
              <a:gd name="T31" fmla="*/ 0 h 680"/>
              <a:gd name="T32" fmla="*/ 326 w 1183"/>
              <a:gd name="T33" fmla="*/ 0 h 680"/>
              <a:gd name="T34" fmla="*/ 349 w 1183"/>
              <a:gd name="T35" fmla="*/ 0 h 680"/>
              <a:gd name="T36" fmla="*/ 365 w 1183"/>
              <a:gd name="T37" fmla="*/ 0 h 680"/>
              <a:gd name="T38" fmla="*/ 389 w 1183"/>
              <a:gd name="T39" fmla="*/ 0 h 680"/>
              <a:gd name="T40" fmla="*/ 405 w 1183"/>
              <a:gd name="T41" fmla="*/ 0 h 680"/>
              <a:gd name="T42" fmla="*/ 429 w 1183"/>
              <a:gd name="T43" fmla="*/ 0 h 680"/>
              <a:gd name="T44" fmla="*/ 444 w 1183"/>
              <a:gd name="T45" fmla="*/ 0 h 680"/>
              <a:gd name="T46" fmla="*/ 468 w 1183"/>
              <a:gd name="T47" fmla="*/ 0 h 680"/>
              <a:gd name="T48" fmla="*/ 484 w 1183"/>
              <a:gd name="T49" fmla="*/ 0 h 680"/>
              <a:gd name="T50" fmla="*/ 508 w 1183"/>
              <a:gd name="T51" fmla="*/ 0 h 680"/>
              <a:gd name="T52" fmla="*/ 524 w 1183"/>
              <a:gd name="T53" fmla="*/ 1 h 680"/>
              <a:gd name="T54" fmla="*/ 547 w 1183"/>
              <a:gd name="T55" fmla="*/ 1 h 680"/>
              <a:gd name="T56" fmla="*/ 564 w 1183"/>
              <a:gd name="T57" fmla="*/ 1 h 680"/>
              <a:gd name="T58" fmla="*/ 587 w 1183"/>
              <a:gd name="T59" fmla="*/ 2 h 680"/>
              <a:gd name="T60" fmla="*/ 603 w 1183"/>
              <a:gd name="T61" fmla="*/ 3 h 680"/>
              <a:gd name="T62" fmla="*/ 627 w 1183"/>
              <a:gd name="T63" fmla="*/ 3 h 680"/>
              <a:gd name="T64" fmla="*/ 643 w 1183"/>
              <a:gd name="T65" fmla="*/ 4 h 680"/>
              <a:gd name="T66" fmla="*/ 666 w 1183"/>
              <a:gd name="T67" fmla="*/ 6 h 680"/>
              <a:gd name="T68" fmla="*/ 682 w 1183"/>
              <a:gd name="T69" fmla="*/ 6 h 680"/>
              <a:gd name="T70" fmla="*/ 707 w 1183"/>
              <a:gd name="T71" fmla="*/ 9 h 680"/>
              <a:gd name="T72" fmla="*/ 722 w 1183"/>
              <a:gd name="T73" fmla="*/ 11 h 680"/>
              <a:gd name="T74" fmla="*/ 746 w 1183"/>
              <a:gd name="T75" fmla="*/ 15 h 680"/>
              <a:gd name="T76" fmla="*/ 762 w 1183"/>
              <a:gd name="T77" fmla="*/ 18 h 680"/>
              <a:gd name="T78" fmla="*/ 786 w 1183"/>
              <a:gd name="T79" fmla="*/ 24 h 680"/>
              <a:gd name="T80" fmla="*/ 802 w 1183"/>
              <a:gd name="T81" fmla="*/ 29 h 680"/>
              <a:gd name="T82" fmla="*/ 826 w 1183"/>
              <a:gd name="T83" fmla="*/ 39 h 680"/>
              <a:gd name="T84" fmla="*/ 842 w 1183"/>
              <a:gd name="T85" fmla="*/ 47 h 680"/>
              <a:gd name="T86" fmla="*/ 866 w 1183"/>
              <a:gd name="T87" fmla="*/ 63 h 680"/>
              <a:gd name="T88" fmla="*/ 881 w 1183"/>
              <a:gd name="T89" fmla="*/ 75 h 680"/>
              <a:gd name="T90" fmla="*/ 905 w 1183"/>
              <a:gd name="T91" fmla="*/ 99 h 680"/>
              <a:gd name="T92" fmla="*/ 921 w 1183"/>
              <a:gd name="T93" fmla="*/ 118 h 680"/>
              <a:gd name="T94" fmla="*/ 945 w 1183"/>
              <a:gd name="T95" fmla="*/ 151 h 680"/>
              <a:gd name="T96" fmla="*/ 961 w 1183"/>
              <a:gd name="T97" fmla="*/ 178 h 680"/>
              <a:gd name="T98" fmla="*/ 984 w 1183"/>
              <a:gd name="T99" fmla="*/ 224 h 680"/>
              <a:gd name="T100" fmla="*/ 1000 w 1183"/>
              <a:gd name="T101" fmla="*/ 258 h 680"/>
              <a:gd name="T102" fmla="*/ 1024 w 1183"/>
              <a:gd name="T103" fmla="*/ 315 h 680"/>
              <a:gd name="T104" fmla="*/ 1040 w 1183"/>
              <a:gd name="T105" fmla="*/ 355 h 680"/>
              <a:gd name="T106" fmla="*/ 1064 w 1183"/>
              <a:gd name="T107" fmla="*/ 417 h 680"/>
              <a:gd name="T108" fmla="*/ 1080 w 1183"/>
              <a:gd name="T109" fmla="*/ 458 h 680"/>
              <a:gd name="T110" fmla="*/ 1103 w 1183"/>
              <a:gd name="T111" fmla="*/ 519 h 680"/>
              <a:gd name="T112" fmla="*/ 1119 w 1183"/>
              <a:gd name="T113" fmla="*/ 557 h 680"/>
              <a:gd name="T114" fmla="*/ 1143 w 1183"/>
              <a:gd name="T115" fmla="*/ 609 h 680"/>
              <a:gd name="T116" fmla="*/ 1159 w 1183"/>
              <a:gd name="T117" fmla="*/ 639 h 680"/>
              <a:gd name="T118" fmla="*/ 1183 w 1183"/>
              <a:gd name="T119" fmla="*/ 680 h 6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183" h="68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8" y="0"/>
                </a:lnTo>
                <a:lnTo>
                  <a:pt x="8" y="0"/>
                </a:lnTo>
                <a:lnTo>
                  <a:pt x="15" y="0"/>
                </a:lnTo>
                <a:lnTo>
                  <a:pt x="15" y="0"/>
                </a:lnTo>
                <a:lnTo>
                  <a:pt x="24" y="0"/>
                </a:lnTo>
                <a:lnTo>
                  <a:pt x="24" y="0"/>
                </a:lnTo>
                <a:lnTo>
                  <a:pt x="31" y="0"/>
                </a:lnTo>
                <a:lnTo>
                  <a:pt x="31" y="0"/>
                </a:lnTo>
                <a:lnTo>
                  <a:pt x="40" y="0"/>
                </a:lnTo>
                <a:lnTo>
                  <a:pt x="40" y="0"/>
                </a:lnTo>
                <a:lnTo>
                  <a:pt x="47" y="0"/>
                </a:lnTo>
                <a:lnTo>
                  <a:pt x="47" y="0"/>
                </a:lnTo>
                <a:lnTo>
                  <a:pt x="55" y="0"/>
                </a:lnTo>
                <a:lnTo>
                  <a:pt x="55" y="0"/>
                </a:lnTo>
                <a:lnTo>
                  <a:pt x="63" y="0"/>
                </a:lnTo>
                <a:lnTo>
                  <a:pt x="63" y="0"/>
                </a:lnTo>
                <a:lnTo>
                  <a:pt x="71" y="0"/>
                </a:lnTo>
                <a:lnTo>
                  <a:pt x="71" y="0"/>
                </a:lnTo>
                <a:lnTo>
                  <a:pt x="79" y="0"/>
                </a:lnTo>
                <a:lnTo>
                  <a:pt x="79" y="0"/>
                </a:lnTo>
                <a:lnTo>
                  <a:pt x="87" y="0"/>
                </a:lnTo>
                <a:lnTo>
                  <a:pt x="87" y="0"/>
                </a:lnTo>
                <a:lnTo>
                  <a:pt x="94" y="0"/>
                </a:lnTo>
                <a:lnTo>
                  <a:pt x="94" y="0"/>
                </a:lnTo>
                <a:lnTo>
                  <a:pt x="103" y="0"/>
                </a:lnTo>
                <a:lnTo>
                  <a:pt x="103" y="0"/>
                </a:lnTo>
                <a:lnTo>
                  <a:pt x="111" y="0"/>
                </a:lnTo>
                <a:lnTo>
                  <a:pt x="111" y="0"/>
                </a:lnTo>
                <a:lnTo>
                  <a:pt x="119" y="0"/>
                </a:lnTo>
                <a:lnTo>
                  <a:pt x="119" y="0"/>
                </a:lnTo>
                <a:lnTo>
                  <a:pt x="127" y="0"/>
                </a:lnTo>
                <a:lnTo>
                  <a:pt x="127" y="0"/>
                </a:lnTo>
                <a:lnTo>
                  <a:pt x="135" y="0"/>
                </a:lnTo>
                <a:lnTo>
                  <a:pt x="135" y="0"/>
                </a:lnTo>
                <a:lnTo>
                  <a:pt x="143" y="0"/>
                </a:lnTo>
                <a:lnTo>
                  <a:pt x="143" y="0"/>
                </a:lnTo>
                <a:lnTo>
                  <a:pt x="150" y="0"/>
                </a:lnTo>
                <a:lnTo>
                  <a:pt x="150" y="0"/>
                </a:lnTo>
                <a:lnTo>
                  <a:pt x="158" y="0"/>
                </a:lnTo>
                <a:lnTo>
                  <a:pt x="158" y="0"/>
                </a:lnTo>
                <a:lnTo>
                  <a:pt x="166" y="0"/>
                </a:lnTo>
                <a:lnTo>
                  <a:pt x="166" y="0"/>
                </a:lnTo>
                <a:lnTo>
                  <a:pt x="175" y="0"/>
                </a:lnTo>
                <a:lnTo>
                  <a:pt x="175" y="0"/>
                </a:lnTo>
                <a:lnTo>
                  <a:pt x="182" y="0"/>
                </a:lnTo>
                <a:lnTo>
                  <a:pt x="182" y="0"/>
                </a:lnTo>
                <a:lnTo>
                  <a:pt x="190" y="0"/>
                </a:lnTo>
                <a:lnTo>
                  <a:pt x="190" y="0"/>
                </a:lnTo>
                <a:lnTo>
                  <a:pt x="198" y="0"/>
                </a:lnTo>
                <a:lnTo>
                  <a:pt x="198" y="0"/>
                </a:lnTo>
                <a:lnTo>
                  <a:pt x="206" y="0"/>
                </a:lnTo>
                <a:lnTo>
                  <a:pt x="206" y="0"/>
                </a:lnTo>
                <a:lnTo>
                  <a:pt x="214" y="0"/>
                </a:lnTo>
                <a:lnTo>
                  <a:pt x="214" y="0"/>
                </a:lnTo>
                <a:lnTo>
                  <a:pt x="222" y="0"/>
                </a:lnTo>
                <a:lnTo>
                  <a:pt x="222" y="0"/>
                </a:lnTo>
                <a:lnTo>
                  <a:pt x="230" y="0"/>
                </a:lnTo>
                <a:lnTo>
                  <a:pt x="230" y="0"/>
                </a:lnTo>
                <a:lnTo>
                  <a:pt x="238" y="0"/>
                </a:lnTo>
                <a:lnTo>
                  <a:pt x="238" y="0"/>
                </a:lnTo>
                <a:lnTo>
                  <a:pt x="245" y="0"/>
                </a:lnTo>
                <a:lnTo>
                  <a:pt x="245" y="0"/>
                </a:lnTo>
                <a:lnTo>
                  <a:pt x="254" y="0"/>
                </a:lnTo>
                <a:lnTo>
                  <a:pt x="254" y="0"/>
                </a:lnTo>
                <a:lnTo>
                  <a:pt x="262" y="0"/>
                </a:lnTo>
                <a:lnTo>
                  <a:pt x="262" y="0"/>
                </a:lnTo>
                <a:lnTo>
                  <a:pt x="270" y="0"/>
                </a:lnTo>
                <a:lnTo>
                  <a:pt x="270" y="0"/>
                </a:lnTo>
                <a:lnTo>
                  <a:pt x="278" y="0"/>
                </a:lnTo>
                <a:lnTo>
                  <a:pt x="278" y="0"/>
                </a:lnTo>
                <a:lnTo>
                  <a:pt x="285" y="0"/>
                </a:lnTo>
                <a:lnTo>
                  <a:pt x="285" y="0"/>
                </a:lnTo>
                <a:lnTo>
                  <a:pt x="294" y="0"/>
                </a:lnTo>
                <a:lnTo>
                  <a:pt x="294" y="0"/>
                </a:lnTo>
                <a:lnTo>
                  <a:pt x="301" y="0"/>
                </a:lnTo>
                <a:lnTo>
                  <a:pt x="301" y="0"/>
                </a:lnTo>
                <a:lnTo>
                  <a:pt x="309" y="0"/>
                </a:lnTo>
                <a:lnTo>
                  <a:pt x="309" y="0"/>
                </a:lnTo>
                <a:lnTo>
                  <a:pt x="317" y="0"/>
                </a:lnTo>
                <a:lnTo>
                  <a:pt x="317" y="0"/>
                </a:lnTo>
                <a:lnTo>
                  <a:pt x="326" y="0"/>
                </a:lnTo>
                <a:lnTo>
                  <a:pt x="326" y="0"/>
                </a:lnTo>
                <a:lnTo>
                  <a:pt x="333" y="0"/>
                </a:lnTo>
                <a:lnTo>
                  <a:pt x="333" y="0"/>
                </a:lnTo>
                <a:lnTo>
                  <a:pt x="341" y="0"/>
                </a:lnTo>
                <a:lnTo>
                  <a:pt x="341" y="0"/>
                </a:lnTo>
                <a:lnTo>
                  <a:pt x="349" y="0"/>
                </a:lnTo>
                <a:lnTo>
                  <a:pt x="349" y="0"/>
                </a:lnTo>
                <a:lnTo>
                  <a:pt x="357" y="0"/>
                </a:lnTo>
                <a:lnTo>
                  <a:pt x="357" y="0"/>
                </a:lnTo>
                <a:lnTo>
                  <a:pt x="365" y="0"/>
                </a:lnTo>
                <a:lnTo>
                  <a:pt x="365" y="0"/>
                </a:lnTo>
                <a:lnTo>
                  <a:pt x="373" y="0"/>
                </a:lnTo>
                <a:lnTo>
                  <a:pt x="373" y="0"/>
                </a:lnTo>
                <a:lnTo>
                  <a:pt x="380" y="0"/>
                </a:lnTo>
                <a:lnTo>
                  <a:pt x="380" y="0"/>
                </a:lnTo>
                <a:lnTo>
                  <a:pt x="389" y="0"/>
                </a:lnTo>
                <a:lnTo>
                  <a:pt x="389" y="0"/>
                </a:lnTo>
                <a:lnTo>
                  <a:pt x="396" y="0"/>
                </a:lnTo>
                <a:lnTo>
                  <a:pt x="396" y="0"/>
                </a:lnTo>
                <a:lnTo>
                  <a:pt x="405" y="0"/>
                </a:lnTo>
                <a:lnTo>
                  <a:pt x="405" y="0"/>
                </a:lnTo>
                <a:lnTo>
                  <a:pt x="413" y="0"/>
                </a:lnTo>
                <a:lnTo>
                  <a:pt x="413" y="0"/>
                </a:lnTo>
                <a:lnTo>
                  <a:pt x="421" y="0"/>
                </a:lnTo>
                <a:lnTo>
                  <a:pt x="421" y="0"/>
                </a:lnTo>
                <a:lnTo>
                  <a:pt x="429" y="0"/>
                </a:lnTo>
                <a:lnTo>
                  <a:pt x="429" y="0"/>
                </a:lnTo>
                <a:lnTo>
                  <a:pt x="436" y="0"/>
                </a:lnTo>
                <a:lnTo>
                  <a:pt x="436" y="0"/>
                </a:lnTo>
                <a:lnTo>
                  <a:pt x="444" y="0"/>
                </a:lnTo>
                <a:lnTo>
                  <a:pt x="444" y="0"/>
                </a:lnTo>
                <a:lnTo>
                  <a:pt x="452" y="0"/>
                </a:lnTo>
                <a:lnTo>
                  <a:pt x="452" y="0"/>
                </a:lnTo>
                <a:lnTo>
                  <a:pt x="460" y="0"/>
                </a:lnTo>
                <a:lnTo>
                  <a:pt x="460" y="0"/>
                </a:lnTo>
                <a:lnTo>
                  <a:pt x="468" y="0"/>
                </a:lnTo>
                <a:lnTo>
                  <a:pt x="468" y="0"/>
                </a:lnTo>
                <a:lnTo>
                  <a:pt x="476" y="0"/>
                </a:lnTo>
                <a:lnTo>
                  <a:pt x="476" y="0"/>
                </a:lnTo>
                <a:lnTo>
                  <a:pt x="484" y="0"/>
                </a:lnTo>
                <a:lnTo>
                  <a:pt x="484" y="0"/>
                </a:lnTo>
                <a:lnTo>
                  <a:pt x="492" y="0"/>
                </a:lnTo>
                <a:lnTo>
                  <a:pt x="492" y="0"/>
                </a:lnTo>
                <a:lnTo>
                  <a:pt x="500" y="0"/>
                </a:lnTo>
                <a:lnTo>
                  <a:pt x="500" y="0"/>
                </a:lnTo>
                <a:lnTo>
                  <a:pt x="508" y="0"/>
                </a:lnTo>
                <a:lnTo>
                  <a:pt x="508" y="0"/>
                </a:lnTo>
                <a:lnTo>
                  <a:pt x="516" y="1"/>
                </a:lnTo>
                <a:lnTo>
                  <a:pt x="516" y="1"/>
                </a:lnTo>
                <a:lnTo>
                  <a:pt x="524" y="1"/>
                </a:lnTo>
                <a:lnTo>
                  <a:pt x="524" y="1"/>
                </a:lnTo>
                <a:lnTo>
                  <a:pt x="531" y="1"/>
                </a:lnTo>
                <a:lnTo>
                  <a:pt x="531" y="1"/>
                </a:lnTo>
                <a:lnTo>
                  <a:pt x="540" y="1"/>
                </a:lnTo>
                <a:lnTo>
                  <a:pt x="540" y="1"/>
                </a:lnTo>
                <a:lnTo>
                  <a:pt x="547" y="1"/>
                </a:lnTo>
                <a:lnTo>
                  <a:pt x="547" y="1"/>
                </a:lnTo>
                <a:lnTo>
                  <a:pt x="556" y="1"/>
                </a:lnTo>
                <a:lnTo>
                  <a:pt x="556" y="1"/>
                </a:lnTo>
                <a:lnTo>
                  <a:pt x="564" y="1"/>
                </a:lnTo>
                <a:lnTo>
                  <a:pt x="564" y="1"/>
                </a:lnTo>
                <a:lnTo>
                  <a:pt x="571" y="2"/>
                </a:lnTo>
                <a:lnTo>
                  <a:pt x="571" y="2"/>
                </a:lnTo>
                <a:lnTo>
                  <a:pt x="580" y="2"/>
                </a:lnTo>
                <a:lnTo>
                  <a:pt x="580" y="2"/>
                </a:lnTo>
                <a:lnTo>
                  <a:pt x="587" y="2"/>
                </a:lnTo>
                <a:lnTo>
                  <a:pt x="587" y="2"/>
                </a:lnTo>
                <a:lnTo>
                  <a:pt x="595" y="2"/>
                </a:lnTo>
                <a:lnTo>
                  <a:pt x="595" y="2"/>
                </a:lnTo>
                <a:lnTo>
                  <a:pt x="603" y="3"/>
                </a:lnTo>
                <a:lnTo>
                  <a:pt x="603" y="3"/>
                </a:lnTo>
                <a:lnTo>
                  <a:pt x="611" y="3"/>
                </a:lnTo>
                <a:lnTo>
                  <a:pt x="611" y="3"/>
                </a:lnTo>
                <a:lnTo>
                  <a:pt x="619" y="3"/>
                </a:lnTo>
                <a:lnTo>
                  <a:pt x="619" y="3"/>
                </a:lnTo>
                <a:lnTo>
                  <a:pt x="627" y="3"/>
                </a:lnTo>
                <a:lnTo>
                  <a:pt x="627" y="3"/>
                </a:lnTo>
                <a:lnTo>
                  <a:pt x="635" y="3"/>
                </a:lnTo>
                <a:lnTo>
                  <a:pt x="635" y="3"/>
                </a:lnTo>
                <a:lnTo>
                  <a:pt x="643" y="4"/>
                </a:lnTo>
                <a:lnTo>
                  <a:pt x="643" y="4"/>
                </a:lnTo>
                <a:lnTo>
                  <a:pt x="651" y="4"/>
                </a:lnTo>
                <a:lnTo>
                  <a:pt x="651" y="4"/>
                </a:lnTo>
                <a:lnTo>
                  <a:pt x="659" y="5"/>
                </a:lnTo>
                <a:lnTo>
                  <a:pt x="659" y="5"/>
                </a:lnTo>
                <a:lnTo>
                  <a:pt x="666" y="6"/>
                </a:lnTo>
                <a:lnTo>
                  <a:pt x="666" y="6"/>
                </a:lnTo>
                <a:lnTo>
                  <a:pt x="675" y="6"/>
                </a:lnTo>
                <a:lnTo>
                  <a:pt x="675" y="6"/>
                </a:lnTo>
                <a:lnTo>
                  <a:pt x="682" y="6"/>
                </a:lnTo>
                <a:lnTo>
                  <a:pt x="682" y="6"/>
                </a:lnTo>
                <a:lnTo>
                  <a:pt x="691" y="7"/>
                </a:lnTo>
                <a:lnTo>
                  <a:pt x="691" y="7"/>
                </a:lnTo>
                <a:lnTo>
                  <a:pt x="698" y="8"/>
                </a:lnTo>
                <a:lnTo>
                  <a:pt x="698" y="8"/>
                </a:lnTo>
                <a:lnTo>
                  <a:pt x="707" y="9"/>
                </a:lnTo>
                <a:lnTo>
                  <a:pt x="707" y="9"/>
                </a:lnTo>
                <a:lnTo>
                  <a:pt x="715" y="9"/>
                </a:lnTo>
                <a:lnTo>
                  <a:pt x="715" y="9"/>
                </a:lnTo>
                <a:lnTo>
                  <a:pt x="722" y="11"/>
                </a:lnTo>
                <a:lnTo>
                  <a:pt x="722" y="11"/>
                </a:lnTo>
                <a:lnTo>
                  <a:pt x="730" y="12"/>
                </a:lnTo>
                <a:lnTo>
                  <a:pt x="730" y="12"/>
                </a:lnTo>
                <a:lnTo>
                  <a:pt x="738" y="13"/>
                </a:lnTo>
                <a:lnTo>
                  <a:pt x="738" y="13"/>
                </a:lnTo>
                <a:lnTo>
                  <a:pt x="746" y="15"/>
                </a:lnTo>
                <a:lnTo>
                  <a:pt x="746" y="15"/>
                </a:lnTo>
                <a:lnTo>
                  <a:pt x="754" y="16"/>
                </a:lnTo>
                <a:lnTo>
                  <a:pt x="754" y="16"/>
                </a:lnTo>
                <a:lnTo>
                  <a:pt x="762" y="18"/>
                </a:lnTo>
                <a:lnTo>
                  <a:pt x="762" y="18"/>
                </a:lnTo>
                <a:lnTo>
                  <a:pt x="770" y="19"/>
                </a:lnTo>
                <a:lnTo>
                  <a:pt x="770" y="19"/>
                </a:lnTo>
                <a:lnTo>
                  <a:pt x="778" y="22"/>
                </a:lnTo>
                <a:lnTo>
                  <a:pt x="778" y="22"/>
                </a:lnTo>
                <a:lnTo>
                  <a:pt x="786" y="24"/>
                </a:lnTo>
                <a:lnTo>
                  <a:pt x="786" y="24"/>
                </a:lnTo>
                <a:lnTo>
                  <a:pt x="794" y="26"/>
                </a:lnTo>
                <a:lnTo>
                  <a:pt x="794" y="26"/>
                </a:lnTo>
                <a:lnTo>
                  <a:pt x="802" y="29"/>
                </a:lnTo>
                <a:lnTo>
                  <a:pt x="802" y="29"/>
                </a:lnTo>
                <a:lnTo>
                  <a:pt x="810" y="32"/>
                </a:lnTo>
                <a:lnTo>
                  <a:pt x="810" y="32"/>
                </a:lnTo>
                <a:lnTo>
                  <a:pt x="817" y="35"/>
                </a:lnTo>
                <a:lnTo>
                  <a:pt x="817" y="35"/>
                </a:lnTo>
                <a:lnTo>
                  <a:pt x="826" y="39"/>
                </a:lnTo>
                <a:lnTo>
                  <a:pt x="826" y="39"/>
                </a:lnTo>
                <a:lnTo>
                  <a:pt x="833" y="43"/>
                </a:lnTo>
                <a:lnTo>
                  <a:pt x="833" y="43"/>
                </a:lnTo>
                <a:lnTo>
                  <a:pt x="842" y="47"/>
                </a:lnTo>
                <a:lnTo>
                  <a:pt x="842" y="47"/>
                </a:lnTo>
                <a:lnTo>
                  <a:pt x="849" y="52"/>
                </a:lnTo>
                <a:lnTo>
                  <a:pt x="849" y="52"/>
                </a:lnTo>
                <a:lnTo>
                  <a:pt x="857" y="57"/>
                </a:lnTo>
                <a:lnTo>
                  <a:pt x="857" y="57"/>
                </a:lnTo>
                <a:lnTo>
                  <a:pt x="866" y="63"/>
                </a:lnTo>
                <a:lnTo>
                  <a:pt x="866" y="63"/>
                </a:lnTo>
                <a:lnTo>
                  <a:pt x="873" y="69"/>
                </a:lnTo>
                <a:lnTo>
                  <a:pt x="873" y="69"/>
                </a:lnTo>
                <a:lnTo>
                  <a:pt x="881" y="75"/>
                </a:lnTo>
                <a:lnTo>
                  <a:pt x="881" y="75"/>
                </a:lnTo>
                <a:lnTo>
                  <a:pt x="889" y="83"/>
                </a:lnTo>
                <a:lnTo>
                  <a:pt x="889" y="83"/>
                </a:lnTo>
                <a:lnTo>
                  <a:pt x="897" y="91"/>
                </a:lnTo>
                <a:lnTo>
                  <a:pt x="897" y="91"/>
                </a:lnTo>
                <a:lnTo>
                  <a:pt x="905" y="99"/>
                </a:lnTo>
                <a:lnTo>
                  <a:pt x="905" y="99"/>
                </a:lnTo>
                <a:lnTo>
                  <a:pt x="913" y="108"/>
                </a:lnTo>
                <a:lnTo>
                  <a:pt x="913" y="108"/>
                </a:lnTo>
                <a:lnTo>
                  <a:pt x="921" y="118"/>
                </a:lnTo>
                <a:lnTo>
                  <a:pt x="921" y="118"/>
                </a:lnTo>
                <a:lnTo>
                  <a:pt x="929" y="129"/>
                </a:lnTo>
                <a:lnTo>
                  <a:pt x="929" y="129"/>
                </a:lnTo>
                <a:lnTo>
                  <a:pt x="937" y="140"/>
                </a:lnTo>
                <a:lnTo>
                  <a:pt x="937" y="140"/>
                </a:lnTo>
                <a:lnTo>
                  <a:pt x="945" y="151"/>
                </a:lnTo>
                <a:lnTo>
                  <a:pt x="945" y="151"/>
                </a:lnTo>
                <a:lnTo>
                  <a:pt x="952" y="164"/>
                </a:lnTo>
                <a:lnTo>
                  <a:pt x="952" y="164"/>
                </a:lnTo>
                <a:lnTo>
                  <a:pt x="961" y="178"/>
                </a:lnTo>
                <a:lnTo>
                  <a:pt x="961" y="178"/>
                </a:lnTo>
                <a:lnTo>
                  <a:pt x="968" y="193"/>
                </a:lnTo>
                <a:lnTo>
                  <a:pt x="968" y="193"/>
                </a:lnTo>
                <a:lnTo>
                  <a:pt x="977" y="208"/>
                </a:lnTo>
                <a:lnTo>
                  <a:pt x="977" y="208"/>
                </a:lnTo>
                <a:lnTo>
                  <a:pt x="984" y="224"/>
                </a:lnTo>
                <a:lnTo>
                  <a:pt x="984" y="224"/>
                </a:lnTo>
                <a:lnTo>
                  <a:pt x="993" y="241"/>
                </a:lnTo>
                <a:lnTo>
                  <a:pt x="993" y="241"/>
                </a:lnTo>
                <a:lnTo>
                  <a:pt x="1000" y="258"/>
                </a:lnTo>
                <a:lnTo>
                  <a:pt x="1000" y="258"/>
                </a:lnTo>
                <a:lnTo>
                  <a:pt x="1008" y="277"/>
                </a:lnTo>
                <a:lnTo>
                  <a:pt x="1008" y="277"/>
                </a:lnTo>
                <a:lnTo>
                  <a:pt x="1016" y="296"/>
                </a:lnTo>
                <a:lnTo>
                  <a:pt x="1016" y="296"/>
                </a:lnTo>
                <a:lnTo>
                  <a:pt x="1024" y="315"/>
                </a:lnTo>
                <a:lnTo>
                  <a:pt x="1024" y="315"/>
                </a:lnTo>
                <a:lnTo>
                  <a:pt x="1032" y="335"/>
                </a:lnTo>
                <a:lnTo>
                  <a:pt x="1032" y="335"/>
                </a:lnTo>
                <a:lnTo>
                  <a:pt x="1040" y="355"/>
                </a:lnTo>
                <a:lnTo>
                  <a:pt x="1040" y="355"/>
                </a:lnTo>
                <a:lnTo>
                  <a:pt x="1047" y="376"/>
                </a:lnTo>
                <a:lnTo>
                  <a:pt x="1047" y="376"/>
                </a:lnTo>
                <a:lnTo>
                  <a:pt x="1056" y="397"/>
                </a:lnTo>
                <a:lnTo>
                  <a:pt x="1056" y="397"/>
                </a:lnTo>
                <a:lnTo>
                  <a:pt x="1064" y="417"/>
                </a:lnTo>
                <a:lnTo>
                  <a:pt x="1064" y="417"/>
                </a:lnTo>
                <a:lnTo>
                  <a:pt x="1072" y="438"/>
                </a:lnTo>
                <a:lnTo>
                  <a:pt x="1072" y="438"/>
                </a:lnTo>
                <a:lnTo>
                  <a:pt x="1080" y="458"/>
                </a:lnTo>
                <a:lnTo>
                  <a:pt x="1080" y="458"/>
                </a:lnTo>
                <a:lnTo>
                  <a:pt x="1088" y="479"/>
                </a:lnTo>
                <a:lnTo>
                  <a:pt x="1088" y="479"/>
                </a:lnTo>
                <a:lnTo>
                  <a:pt x="1096" y="500"/>
                </a:lnTo>
                <a:lnTo>
                  <a:pt x="1096" y="500"/>
                </a:lnTo>
                <a:lnTo>
                  <a:pt x="1103" y="519"/>
                </a:lnTo>
                <a:lnTo>
                  <a:pt x="1103" y="519"/>
                </a:lnTo>
                <a:lnTo>
                  <a:pt x="1112" y="538"/>
                </a:lnTo>
                <a:lnTo>
                  <a:pt x="1112" y="538"/>
                </a:lnTo>
                <a:lnTo>
                  <a:pt x="1119" y="557"/>
                </a:lnTo>
                <a:lnTo>
                  <a:pt x="1119" y="557"/>
                </a:lnTo>
                <a:lnTo>
                  <a:pt x="1128" y="575"/>
                </a:lnTo>
                <a:lnTo>
                  <a:pt x="1128" y="575"/>
                </a:lnTo>
                <a:lnTo>
                  <a:pt x="1135" y="592"/>
                </a:lnTo>
                <a:lnTo>
                  <a:pt x="1135" y="592"/>
                </a:lnTo>
                <a:lnTo>
                  <a:pt x="1143" y="609"/>
                </a:lnTo>
                <a:lnTo>
                  <a:pt x="1143" y="609"/>
                </a:lnTo>
                <a:lnTo>
                  <a:pt x="1151" y="625"/>
                </a:lnTo>
                <a:lnTo>
                  <a:pt x="1151" y="625"/>
                </a:lnTo>
                <a:lnTo>
                  <a:pt x="1159" y="639"/>
                </a:lnTo>
                <a:lnTo>
                  <a:pt x="1159" y="639"/>
                </a:lnTo>
                <a:lnTo>
                  <a:pt x="1167" y="654"/>
                </a:lnTo>
                <a:lnTo>
                  <a:pt x="1167" y="654"/>
                </a:lnTo>
                <a:lnTo>
                  <a:pt x="1175" y="667"/>
                </a:lnTo>
                <a:lnTo>
                  <a:pt x="1175" y="667"/>
                </a:lnTo>
                <a:lnTo>
                  <a:pt x="1183" y="680"/>
                </a:lnTo>
              </a:path>
            </a:pathLst>
          </a:custGeom>
          <a:noFill/>
          <a:ln w="142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Rectangle 143"/>
          <p:cNvSpPr>
            <a:spLocks noChangeArrowheads="1"/>
          </p:cNvSpPr>
          <p:nvPr/>
        </p:nvSpPr>
        <p:spPr bwMode="auto">
          <a:xfrm>
            <a:off x="3725467" y="2621757"/>
            <a:ext cx="639599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cs typeface="Arial" panose="020B0604020202020204" pitchFamily="34" charset="0"/>
              </a:rPr>
              <a:t>Log Molar conc</a:t>
            </a:r>
            <a:endParaRPr lang="en-US" altLang="en-US" sz="675">
              <a:cs typeface="Arial" panose="020B0604020202020204" pitchFamily="34" charset="0"/>
            </a:endParaRPr>
          </a:p>
        </p:txBody>
      </p:sp>
      <p:sp>
        <p:nvSpPr>
          <p:cNvPr id="184" name="Rectangle 173"/>
          <p:cNvSpPr>
            <a:spLocks noChangeArrowheads="1"/>
          </p:cNvSpPr>
          <p:nvPr/>
        </p:nvSpPr>
        <p:spPr bwMode="auto">
          <a:xfrm>
            <a:off x="5445920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8.5</a:t>
            </a:r>
            <a:endParaRPr lang="en-US" altLang="en-US" sz="675">
              <a:latin typeface="+mn-lt"/>
            </a:endParaRPr>
          </a:p>
        </p:txBody>
      </p:sp>
      <p:sp>
        <p:nvSpPr>
          <p:cNvPr id="185" name="Rectangle 174"/>
          <p:cNvSpPr>
            <a:spLocks noChangeArrowheads="1"/>
          </p:cNvSpPr>
          <p:nvPr/>
        </p:nvSpPr>
        <p:spPr bwMode="auto">
          <a:xfrm>
            <a:off x="5618560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8.0</a:t>
            </a:r>
            <a:endParaRPr lang="en-US" altLang="en-US" sz="675">
              <a:latin typeface="+mn-lt"/>
            </a:endParaRPr>
          </a:p>
        </p:txBody>
      </p:sp>
      <p:sp>
        <p:nvSpPr>
          <p:cNvPr id="186" name="Rectangle 175"/>
          <p:cNvSpPr>
            <a:spLocks noChangeArrowheads="1"/>
          </p:cNvSpPr>
          <p:nvPr/>
        </p:nvSpPr>
        <p:spPr bwMode="auto">
          <a:xfrm>
            <a:off x="5791201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7.5</a:t>
            </a:r>
            <a:endParaRPr lang="en-US" altLang="en-US" sz="675">
              <a:latin typeface="+mn-lt"/>
            </a:endParaRPr>
          </a:p>
        </p:txBody>
      </p:sp>
      <p:sp>
        <p:nvSpPr>
          <p:cNvPr id="187" name="Rectangle 176"/>
          <p:cNvSpPr>
            <a:spLocks noChangeArrowheads="1"/>
          </p:cNvSpPr>
          <p:nvPr/>
        </p:nvSpPr>
        <p:spPr bwMode="auto">
          <a:xfrm>
            <a:off x="5963841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7.0</a:t>
            </a:r>
            <a:endParaRPr lang="en-US" altLang="en-US" sz="675">
              <a:latin typeface="+mn-lt"/>
            </a:endParaRPr>
          </a:p>
        </p:txBody>
      </p:sp>
      <p:sp>
        <p:nvSpPr>
          <p:cNvPr id="188" name="Rectangle 177"/>
          <p:cNvSpPr>
            <a:spLocks noChangeArrowheads="1"/>
          </p:cNvSpPr>
          <p:nvPr/>
        </p:nvSpPr>
        <p:spPr bwMode="auto">
          <a:xfrm>
            <a:off x="6137672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6.5</a:t>
            </a:r>
            <a:endParaRPr lang="en-US" altLang="en-US" sz="675">
              <a:latin typeface="+mn-lt"/>
            </a:endParaRPr>
          </a:p>
        </p:txBody>
      </p:sp>
      <p:sp>
        <p:nvSpPr>
          <p:cNvPr id="189" name="Rectangle 178"/>
          <p:cNvSpPr>
            <a:spLocks noChangeArrowheads="1"/>
          </p:cNvSpPr>
          <p:nvPr/>
        </p:nvSpPr>
        <p:spPr bwMode="auto">
          <a:xfrm>
            <a:off x="6310313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6.0</a:t>
            </a:r>
            <a:endParaRPr lang="en-US" altLang="en-US" sz="675">
              <a:latin typeface="+mn-lt"/>
            </a:endParaRPr>
          </a:p>
        </p:txBody>
      </p:sp>
      <p:sp>
        <p:nvSpPr>
          <p:cNvPr id="190" name="Rectangle 179"/>
          <p:cNvSpPr>
            <a:spLocks noChangeArrowheads="1"/>
          </p:cNvSpPr>
          <p:nvPr/>
        </p:nvSpPr>
        <p:spPr bwMode="auto">
          <a:xfrm>
            <a:off x="6482954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5.5</a:t>
            </a:r>
            <a:endParaRPr lang="en-US" altLang="en-US" sz="675">
              <a:latin typeface="+mn-lt"/>
            </a:endParaRPr>
          </a:p>
        </p:txBody>
      </p:sp>
      <p:sp>
        <p:nvSpPr>
          <p:cNvPr id="191" name="Rectangle 180"/>
          <p:cNvSpPr>
            <a:spLocks noChangeArrowheads="1"/>
          </p:cNvSpPr>
          <p:nvPr/>
        </p:nvSpPr>
        <p:spPr bwMode="auto">
          <a:xfrm>
            <a:off x="6655595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5.0</a:t>
            </a:r>
            <a:endParaRPr lang="en-US" altLang="en-US" sz="675">
              <a:latin typeface="+mn-lt"/>
            </a:endParaRPr>
          </a:p>
        </p:txBody>
      </p:sp>
      <p:sp>
        <p:nvSpPr>
          <p:cNvPr id="192" name="Rectangle 181"/>
          <p:cNvSpPr>
            <a:spLocks noChangeArrowheads="1"/>
          </p:cNvSpPr>
          <p:nvPr/>
        </p:nvSpPr>
        <p:spPr bwMode="auto">
          <a:xfrm>
            <a:off x="6828235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4.5</a:t>
            </a:r>
            <a:endParaRPr lang="en-US" altLang="en-US" sz="675">
              <a:latin typeface="+mn-lt"/>
            </a:endParaRPr>
          </a:p>
        </p:txBody>
      </p:sp>
      <p:sp>
        <p:nvSpPr>
          <p:cNvPr id="193" name="Rectangle 182"/>
          <p:cNvSpPr>
            <a:spLocks noChangeArrowheads="1"/>
          </p:cNvSpPr>
          <p:nvPr/>
        </p:nvSpPr>
        <p:spPr bwMode="auto">
          <a:xfrm>
            <a:off x="7000876" y="2522935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4.0</a:t>
            </a:r>
            <a:endParaRPr lang="en-US" altLang="en-US" sz="675">
              <a:latin typeface="+mn-lt"/>
            </a:endParaRPr>
          </a:p>
        </p:txBody>
      </p:sp>
      <p:sp>
        <p:nvSpPr>
          <p:cNvPr id="194" name="Freeform 183"/>
          <p:cNvSpPr>
            <a:spLocks noEditPoints="1"/>
          </p:cNvSpPr>
          <p:nvPr/>
        </p:nvSpPr>
        <p:spPr bwMode="auto">
          <a:xfrm>
            <a:off x="5507833" y="2480073"/>
            <a:ext cx="1564481" cy="30956"/>
          </a:xfrm>
          <a:custGeom>
            <a:avLst/>
            <a:gdLst>
              <a:gd name="T0" fmla="*/ 0 w 1314"/>
              <a:gd name="T1" fmla="*/ 0 h 26"/>
              <a:gd name="T2" fmla="*/ 1314 w 1314"/>
              <a:gd name="T3" fmla="*/ 0 h 26"/>
              <a:gd name="T4" fmla="*/ 4 w 1314"/>
              <a:gd name="T5" fmla="*/ 0 h 26"/>
              <a:gd name="T6" fmla="*/ 4 w 1314"/>
              <a:gd name="T7" fmla="*/ 26 h 26"/>
              <a:gd name="T8" fmla="*/ 149 w 1314"/>
              <a:gd name="T9" fmla="*/ 0 h 26"/>
              <a:gd name="T10" fmla="*/ 149 w 1314"/>
              <a:gd name="T11" fmla="*/ 26 h 26"/>
              <a:gd name="T12" fmla="*/ 294 w 1314"/>
              <a:gd name="T13" fmla="*/ 0 h 26"/>
              <a:gd name="T14" fmla="*/ 294 w 1314"/>
              <a:gd name="T15" fmla="*/ 26 h 26"/>
              <a:gd name="T16" fmla="*/ 439 w 1314"/>
              <a:gd name="T17" fmla="*/ 0 h 26"/>
              <a:gd name="T18" fmla="*/ 439 w 1314"/>
              <a:gd name="T19" fmla="*/ 26 h 26"/>
              <a:gd name="T20" fmla="*/ 584 w 1314"/>
              <a:gd name="T21" fmla="*/ 0 h 26"/>
              <a:gd name="T22" fmla="*/ 584 w 1314"/>
              <a:gd name="T23" fmla="*/ 26 h 26"/>
              <a:gd name="T24" fmla="*/ 730 w 1314"/>
              <a:gd name="T25" fmla="*/ 0 h 26"/>
              <a:gd name="T26" fmla="*/ 730 w 1314"/>
              <a:gd name="T27" fmla="*/ 26 h 26"/>
              <a:gd name="T28" fmla="*/ 875 w 1314"/>
              <a:gd name="T29" fmla="*/ 0 h 26"/>
              <a:gd name="T30" fmla="*/ 875 w 1314"/>
              <a:gd name="T31" fmla="*/ 26 h 26"/>
              <a:gd name="T32" fmla="*/ 1020 w 1314"/>
              <a:gd name="T33" fmla="*/ 0 h 26"/>
              <a:gd name="T34" fmla="*/ 1020 w 1314"/>
              <a:gd name="T35" fmla="*/ 26 h 26"/>
              <a:gd name="T36" fmla="*/ 1165 w 1314"/>
              <a:gd name="T37" fmla="*/ 0 h 26"/>
              <a:gd name="T38" fmla="*/ 1165 w 1314"/>
              <a:gd name="T39" fmla="*/ 26 h 26"/>
              <a:gd name="T40" fmla="*/ 1310 w 1314"/>
              <a:gd name="T41" fmla="*/ 0 h 26"/>
              <a:gd name="T42" fmla="*/ 1310 w 1314"/>
              <a:gd name="T43" fmla="*/ 26 h 2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314" h="26">
                <a:moveTo>
                  <a:pt x="0" y="0"/>
                </a:moveTo>
                <a:lnTo>
                  <a:pt x="1314" y="0"/>
                </a:lnTo>
                <a:moveTo>
                  <a:pt x="4" y="0"/>
                </a:moveTo>
                <a:lnTo>
                  <a:pt x="4" y="26"/>
                </a:lnTo>
                <a:moveTo>
                  <a:pt x="149" y="0"/>
                </a:moveTo>
                <a:lnTo>
                  <a:pt x="149" y="26"/>
                </a:lnTo>
                <a:moveTo>
                  <a:pt x="294" y="0"/>
                </a:moveTo>
                <a:lnTo>
                  <a:pt x="294" y="26"/>
                </a:lnTo>
                <a:moveTo>
                  <a:pt x="439" y="0"/>
                </a:moveTo>
                <a:lnTo>
                  <a:pt x="439" y="26"/>
                </a:lnTo>
                <a:moveTo>
                  <a:pt x="584" y="0"/>
                </a:moveTo>
                <a:lnTo>
                  <a:pt x="584" y="26"/>
                </a:lnTo>
                <a:moveTo>
                  <a:pt x="730" y="0"/>
                </a:moveTo>
                <a:lnTo>
                  <a:pt x="730" y="26"/>
                </a:lnTo>
                <a:moveTo>
                  <a:pt x="875" y="0"/>
                </a:moveTo>
                <a:lnTo>
                  <a:pt x="875" y="26"/>
                </a:lnTo>
                <a:moveTo>
                  <a:pt x="1020" y="0"/>
                </a:moveTo>
                <a:lnTo>
                  <a:pt x="1020" y="26"/>
                </a:lnTo>
                <a:moveTo>
                  <a:pt x="1165" y="0"/>
                </a:moveTo>
                <a:lnTo>
                  <a:pt x="1165" y="26"/>
                </a:lnTo>
                <a:moveTo>
                  <a:pt x="1310" y="0"/>
                </a:moveTo>
                <a:lnTo>
                  <a:pt x="1310" y="26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195" name="Rectangle 184"/>
          <p:cNvSpPr>
            <a:spLocks noChangeArrowheads="1"/>
          </p:cNvSpPr>
          <p:nvPr/>
        </p:nvSpPr>
        <p:spPr bwMode="auto">
          <a:xfrm>
            <a:off x="5251847" y="2431257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15000</a:t>
            </a:r>
            <a:endParaRPr lang="en-US" altLang="en-US" sz="675">
              <a:latin typeface="+mn-lt"/>
            </a:endParaRPr>
          </a:p>
        </p:txBody>
      </p:sp>
      <p:sp>
        <p:nvSpPr>
          <p:cNvPr id="196" name="Rectangle 185"/>
          <p:cNvSpPr>
            <a:spLocks noChangeArrowheads="1"/>
          </p:cNvSpPr>
          <p:nvPr/>
        </p:nvSpPr>
        <p:spPr bwMode="auto">
          <a:xfrm>
            <a:off x="5251847" y="2171701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30000</a:t>
            </a:r>
            <a:endParaRPr lang="en-US" altLang="en-US" sz="675">
              <a:latin typeface="+mn-lt"/>
            </a:endParaRPr>
          </a:p>
        </p:txBody>
      </p:sp>
      <p:sp>
        <p:nvSpPr>
          <p:cNvPr id="197" name="Rectangle 186"/>
          <p:cNvSpPr>
            <a:spLocks noChangeArrowheads="1"/>
          </p:cNvSpPr>
          <p:nvPr/>
        </p:nvSpPr>
        <p:spPr bwMode="auto">
          <a:xfrm>
            <a:off x="5251847" y="1912144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45000</a:t>
            </a:r>
            <a:endParaRPr lang="en-US" altLang="en-US" sz="675">
              <a:latin typeface="+mn-lt"/>
            </a:endParaRPr>
          </a:p>
        </p:txBody>
      </p:sp>
      <p:sp>
        <p:nvSpPr>
          <p:cNvPr id="198" name="Rectangle 187"/>
          <p:cNvSpPr>
            <a:spLocks noChangeArrowheads="1"/>
          </p:cNvSpPr>
          <p:nvPr/>
        </p:nvSpPr>
        <p:spPr bwMode="auto">
          <a:xfrm>
            <a:off x="5251847" y="1652588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60000</a:t>
            </a:r>
            <a:endParaRPr lang="en-US" altLang="en-US" sz="675">
              <a:latin typeface="+mn-lt"/>
            </a:endParaRPr>
          </a:p>
        </p:txBody>
      </p:sp>
      <p:sp>
        <p:nvSpPr>
          <p:cNvPr id="199" name="Rectangle 188"/>
          <p:cNvSpPr>
            <a:spLocks noChangeArrowheads="1"/>
          </p:cNvSpPr>
          <p:nvPr/>
        </p:nvSpPr>
        <p:spPr bwMode="auto">
          <a:xfrm>
            <a:off x="5251847" y="1393032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75000</a:t>
            </a:r>
            <a:endParaRPr lang="en-US" altLang="en-US" sz="675">
              <a:latin typeface="+mn-lt"/>
            </a:endParaRPr>
          </a:p>
        </p:txBody>
      </p:sp>
      <p:sp>
        <p:nvSpPr>
          <p:cNvPr id="200" name="Freeform 189"/>
          <p:cNvSpPr>
            <a:spLocks noEditPoints="1"/>
          </p:cNvSpPr>
          <p:nvPr/>
        </p:nvSpPr>
        <p:spPr bwMode="auto">
          <a:xfrm>
            <a:off x="5481639" y="1435894"/>
            <a:ext cx="30956" cy="1048941"/>
          </a:xfrm>
          <a:custGeom>
            <a:avLst/>
            <a:gdLst>
              <a:gd name="T0" fmla="*/ 26 w 26"/>
              <a:gd name="T1" fmla="*/ 881 h 881"/>
              <a:gd name="T2" fmla="*/ 26 w 26"/>
              <a:gd name="T3" fmla="*/ 0 h 881"/>
              <a:gd name="T4" fmla="*/ 26 w 26"/>
              <a:gd name="T5" fmla="*/ 877 h 881"/>
              <a:gd name="T6" fmla="*/ 0 w 26"/>
              <a:gd name="T7" fmla="*/ 877 h 881"/>
              <a:gd name="T8" fmla="*/ 26 w 26"/>
              <a:gd name="T9" fmla="*/ 659 h 881"/>
              <a:gd name="T10" fmla="*/ 0 w 26"/>
              <a:gd name="T11" fmla="*/ 659 h 881"/>
              <a:gd name="T12" fmla="*/ 26 w 26"/>
              <a:gd name="T13" fmla="*/ 441 h 881"/>
              <a:gd name="T14" fmla="*/ 0 w 26"/>
              <a:gd name="T15" fmla="*/ 441 h 881"/>
              <a:gd name="T16" fmla="*/ 26 w 26"/>
              <a:gd name="T17" fmla="*/ 222 h 881"/>
              <a:gd name="T18" fmla="*/ 0 w 26"/>
              <a:gd name="T19" fmla="*/ 222 h 881"/>
              <a:gd name="T20" fmla="*/ 26 w 26"/>
              <a:gd name="T21" fmla="*/ 4 h 881"/>
              <a:gd name="T22" fmla="*/ 0 w 26"/>
              <a:gd name="T23" fmla="*/ 4 h 8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26" h="881">
                <a:moveTo>
                  <a:pt x="26" y="881"/>
                </a:moveTo>
                <a:lnTo>
                  <a:pt x="26" y="0"/>
                </a:lnTo>
                <a:moveTo>
                  <a:pt x="26" y="877"/>
                </a:moveTo>
                <a:lnTo>
                  <a:pt x="0" y="877"/>
                </a:lnTo>
                <a:moveTo>
                  <a:pt x="26" y="659"/>
                </a:moveTo>
                <a:lnTo>
                  <a:pt x="0" y="659"/>
                </a:lnTo>
                <a:moveTo>
                  <a:pt x="26" y="441"/>
                </a:moveTo>
                <a:lnTo>
                  <a:pt x="0" y="441"/>
                </a:lnTo>
                <a:moveTo>
                  <a:pt x="26" y="222"/>
                </a:moveTo>
                <a:lnTo>
                  <a:pt x="0" y="222"/>
                </a:lnTo>
                <a:moveTo>
                  <a:pt x="26" y="4"/>
                </a:moveTo>
                <a:lnTo>
                  <a:pt x="0" y="4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1" name="Line 190"/>
          <p:cNvSpPr>
            <a:spLocks noChangeShapeType="1"/>
          </p:cNvSpPr>
          <p:nvPr/>
        </p:nvSpPr>
        <p:spPr bwMode="auto">
          <a:xfrm>
            <a:off x="6376988" y="1757362"/>
            <a:ext cx="0" cy="4405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2" name="Line 191"/>
          <p:cNvSpPr>
            <a:spLocks noChangeShapeType="1"/>
          </p:cNvSpPr>
          <p:nvPr/>
        </p:nvSpPr>
        <p:spPr bwMode="auto">
          <a:xfrm>
            <a:off x="6376988" y="1801416"/>
            <a:ext cx="0" cy="4405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3" name="Line 192"/>
          <p:cNvSpPr>
            <a:spLocks noChangeShapeType="1"/>
          </p:cNvSpPr>
          <p:nvPr/>
        </p:nvSpPr>
        <p:spPr bwMode="auto">
          <a:xfrm>
            <a:off x="6353176" y="1757363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4" name="Line 193"/>
          <p:cNvSpPr>
            <a:spLocks noChangeShapeType="1"/>
          </p:cNvSpPr>
          <p:nvPr/>
        </p:nvSpPr>
        <p:spPr bwMode="auto">
          <a:xfrm>
            <a:off x="6353176" y="1845469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5" name="Line 194"/>
          <p:cNvSpPr>
            <a:spLocks noChangeShapeType="1"/>
          </p:cNvSpPr>
          <p:nvPr/>
        </p:nvSpPr>
        <p:spPr bwMode="auto">
          <a:xfrm>
            <a:off x="6722270" y="1689497"/>
            <a:ext cx="0" cy="52388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6" name="Line 195"/>
          <p:cNvSpPr>
            <a:spLocks noChangeShapeType="1"/>
          </p:cNvSpPr>
          <p:nvPr/>
        </p:nvSpPr>
        <p:spPr bwMode="auto">
          <a:xfrm>
            <a:off x="6722270" y="1741885"/>
            <a:ext cx="0" cy="53579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7" name="Line 196"/>
          <p:cNvSpPr>
            <a:spLocks noChangeShapeType="1"/>
          </p:cNvSpPr>
          <p:nvPr/>
        </p:nvSpPr>
        <p:spPr bwMode="auto">
          <a:xfrm>
            <a:off x="6698457" y="1689497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8" name="Line 197"/>
          <p:cNvSpPr>
            <a:spLocks noChangeShapeType="1"/>
          </p:cNvSpPr>
          <p:nvPr/>
        </p:nvSpPr>
        <p:spPr bwMode="auto">
          <a:xfrm>
            <a:off x="6698457" y="1795463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09" name="Line 198"/>
          <p:cNvSpPr>
            <a:spLocks noChangeShapeType="1"/>
          </p:cNvSpPr>
          <p:nvPr/>
        </p:nvSpPr>
        <p:spPr bwMode="auto">
          <a:xfrm>
            <a:off x="6860382" y="1796654"/>
            <a:ext cx="0" cy="35719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0" name="Line 199"/>
          <p:cNvSpPr>
            <a:spLocks noChangeShapeType="1"/>
          </p:cNvSpPr>
          <p:nvPr/>
        </p:nvSpPr>
        <p:spPr bwMode="auto">
          <a:xfrm>
            <a:off x="6860382" y="1832373"/>
            <a:ext cx="0" cy="3691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1" name="Line 200"/>
          <p:cNvSpPr>
            <a:spLocks noChangeShapeType="1"/>
          </p:cNvSpPr>
          <p:nvPr/>
        </p:nvSpPr>
        <p:spPr bwMode="auto">
          <a:xfrm>
            <a:off x="6836570" y="1796654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2" name="Line 201"/>
          <p:cNvSpPr>
            <a:spLocks noChangeShapeType="1"/>
          </p:cNvSpPr>
          <p:nvPr/>
        </p:nvSpPr>
        <p:spPr bwMode="auto">
          <a:xfrm>
            <a:off x="6836570" y="1869281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3" name="Oval 202"/>
          <p:cNvSpPr>
            <a:spLocks noChangeArrowheads="1"/>
          </p:cNvSpPr>
          <p:nvPr/>
        </p:nvSpPr>
        <p:spPr bwMode="auto">
          <a:xfrm>
            <a:off x="5664995" y="1507332"/>
            <a:ext cx="40481" cy="40481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4" name="Oval 203"/>
          <p:cNvSpPr>
            <a:spLocks noChangeArrowheads="1"/>
          </p:cNvSpPr>
          <p:nvPr/>
        </p:nvSpPr>
        <p:spPr bwMode="auto">
          <a:xfrm>
            <a:off x="5664995" y="1507332"/>
            <a:ext cx="40481" cy="40481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5" name="Oval 204"/>
          <p:cNvSpPr>
            <a:spLocks noChangeArrowheads="1"/>
          </p:cNvSpPr>
          <p:nvPr/>
        </p:nvSpPr>
        <p:spPr bwMode="auto">
          <a:xfrm>
            <a:off x="5906692" y="1701404"/>
            <a:ext cx="41672" cy="40481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6" name="Oval 205"/>
          <p:cNvSpPr>
            <a:spLocks noChangeArrowheads="1"/>
          </p:cNvSpPr>
          <p:nvPr/>
        </p:nvSpPr>
        <p:spPr bwMode="auto">
          <a:xfrm>
            <a:off x="5906692" y="1700213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7" name="Oval 206"/>
          <p:cNvSpPr>
            <a:spLocks noChangeArrowheads="1"/>
          </p:cNvSpPr>
          <p:nvPr/>
        </p:nvSpPr>
        <p:spPr bwMode="auto">
          <a:xfrm>
            <a:off x="6010276" y="1647826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8" name="Oval 207"/>
          <p:cNvSpPr>
            <a:spLocks noChangeArrowheads="1"/>
          </p:cNvSpPr>
          <p:nvPr/>
        </p:nvSpPr>
        <p:spPr bwMode="auto">
          <a:xfrm>
            <a:off x="6010276" y="1647826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19" name="Oval 208"/>
          <p:cNvSpPr>
            <a:spLocks noChangeArrowheads="1"/>
          </p:cNvSpPr>
          <p:nvPr/>
        </p:nvSpPr>
        <p:spPr bwMode="auto">
          <a:xfrm>
            <a:off x="6355558" y="1779985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0" name="Oval 209"/>
          <p:cNvSpPr>
            <a:spLocks noChangeArrowheads="1"/>
          </p:cNvSpPr>
          <p:nvPr/>
        </p:nvSpPr>
        <p:spPr bwMode="auto">
          <a:xfrm>
            <a:off x="6355558" y="1779985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1" name="Oval 210"/>
          <p:cNvSpPr>
            <a:spLocks noChangeArrowheads="1"/>
          </p:cNvSpPr>
          <p:nvPr/>
        </p:nvSpPr>
        <p:spPr bwMode="auto">
          <a:xfrm>
            <a:off x="6702029" y="1721644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2" name="Oval 211"/>
          <p:cNvSpPr>
            <a:spLocks noChangeArrowheads="1"/>
          </p:cNvSpPr>
          <p:nvPr/>
        </p:nvSpPr>
        <p:spPr bwMode="auto">
          <a:xfrm>
            <a:off x="6702029" y="1721644"/>
            <a:ext cx="40481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3" name="Oval 212"/>
          <p:cNvSpPr>
            <a:spLocks noChangeArrowheads="1"/>
          </p:cNvSpPr>
          <p:nvPr/>
        </p:nvSpPr>
        <p:spPr bwMode="auto">
          <a:xfrm>
            <a:off x="6840142" y="1812132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4" name="Oval 213"/>
          <p:cNvSpPr>
            <a:spLocks noChangeArrowheads="1"/>
          </p:cNvSpPr>
          <p:nvPr/>
        </p:nvSpPr>
        <p:spPr bwMode="auto">
          <a:xfrm>
            <a:off x="6838951" y="1812132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5" name="Oval 214"/>
          <p:cNvSpPr>
            <a:spLocks noChangeArrowheads="1"/>
          </p:cNvSpPr>
          <p:nvPr/>
        </p:nvSpPr>
        <p:spPr bwMode="auto">
          <a:xfrm>
            <a:off x="6943726" y="2128838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6" name="Oval 215"/>
          <p:cNvSpPr>
            <a:spLocks noChangeArrowheads="1"/>
          </p:cNvSpPr>
          <p:nvPr/>
        </p:nvSpPr>
        <p:spPr bwMode="auto">
          <a:xfrm>
            <a:off x="6943726" y="2128838"/>
            <a:ext cx="40481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7" name="Oval 216"/>
          <p:cNvSpPr>
            <a:spLocks noChangeArrowheads="1"/>
          </p:cNvSpPr>
          <p:nvPr/>
        </p:nvSpPr>
        <p:spPr bwMode="auto">
          <a:xfrm>
            <a:off x="7005639" y="2287192"/>
            <a:ext cx="41672" cy="40481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8" name="Oval 217"/>
          <p:cNvSpPr>
            <a:spLocks noChangeArrowheads="1"/>
          </p:cNvSpPr>
          <p:nvPr/>
        </p:nvSpPr>
        <p:spPr bwMode="auto">
          <a:xfrm>
            <a:off x="7005639" y="2287192"/>
            <a:ext cx="41672" cy="40481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29" name="Freeform 218"/>
          <p:cNvSpPr>
            <a:spLocks/>
          </p:cNvSpPr>
          <p:nvPr/>
        </p:nvSpPr>
        <p:spPr bwMode="auto">
          <a:xfrm>
            <a:off x="5685235" y="1681163"/>
            <a:ext cx="1340644" cy="639366"/>
          </a:xfrm>
          <a:custGeom>
            <a:avLst/>
            <a:gdLst>
              <a:gd name="T0" fmla="*/ 7 w 1126"/>
              <a:gd name="T1" fmla="*/ 0 h 537"/>
              <a:gd name="T2" fmla="*/ 30 w 1126"/>
              <a:gd name="T3" fmla="*/ 0 h 537"/>
              <a:gd name="T4" fmla="*/ 45 w 1126"/>
              <a:gd name="T5" fmla="*/ 0 h 537"/>
              <a:gd name="T6" fmla="*/ 68 w 1126"/>
              <a:gd name="T7" fmla="*/ 0 h 537"/>
              <a:gd name="T8" fmla="*/ 83 w 1126"/>
              <a:gd name="T9" fmla="*/ 0 h 537"/>
              <a:gd name="T10" fmla="*/ 105 w 1126"/>
              <a:gd name="T11" fmla="*/ 0 h 537"/>
              <a:gd name="T12" fmla="*/ 121 w 1126"/>
              <a:gd name="T13" fmla="*/ 0 h 537"/>
              <a:gd name="T14" fmla="*/ 143 w 1126"/>
              <a:gd name="T15" fmla="*/ 0 h 537"/>
              <a:gd name="T16" fmla="*/ 158 w 1126"/>
              <a:gd name="T17" fmla="*/ 0 h 537"/>
              <a:gd name="T18" fmla="*/ 181 w 1126"/>
              <a:gd name="T19" fmla="*/ 0 h 537"/>
              <a:gd name="T20" fmla="*/ 196 w 1126"/>
              <a:gd name="T21" fmla="*/ 0 h 537"/>
              <a:gd name="T22" fmla="*/ 219 w 1126"/>
              <a:gd name="T23" fmla="*/ 0 h 537"/>
              <a:gd name="T24" fmla="*/ 234 w 1126"/>
              <a:gd name="T25" fmla="*/ 0 h 537"/>
              <a:gd name="T26" fmla="*/ 257 w 1126"/>
              <a:gd name="T27" fmla="*/ 0 h 537"/>
              <a:gd name="T28" fmla="*/ 271 w 1126"/>
              <a:gd name="T29" fmla="*/ 0 h 537"/>
              <a:gd name="T30" fmla="*/ 295 w 1126"/>
              <a:gd name="T31" fmla="*/ 0 h 537"/>
              <a:gd name="T32" fmla="*/ 310 w 1126"/>
              <a:gd name="T33" fmla="*/ 0 h 537"/>
              <a:gd name="T34" fmla="*/ 332 w 1126"/>
              <a:gd name="T35" fmla="*/ 0 h 537"/>
              <a:gd name="T36" fmla="*/ 348 w 1126"/>
              <a:gd name="T37" fmla="*/ 0 h 537"/>
              <a:gd name="T38" fmla="*/ 370 w 1126"/>
              <a:gd name="T39" fmla="*/ 0 h 537"/>
              <a:gd name="T40" fmla="*/ 385 w 1126"/>
              <a:gd name="T41" fmla="*/ 0 h 537"/>
              <a:gd name="T42" fmla="*/ 408 w 1126"/>
              <a:gd name="T43" fmla="*/ 0 h 537"/>
              <a:gd name="T44" fmla="*/ 423 w 1126"/>
              <a:gd name="T45" fmla="*/ 0 h 537"/>
              <a:gd name="T46" fmla="*/ 446 w 1126"/>
              <a:gd name="T47" fmla="*/ 0 h 537"/>
              <a:gd name="T48" fmla="*/ 461 w 1126"/>
              <a:gd name="T49" fmla="*/ 0 h 537"/>
              <a:gd name="T50" fmla="*/ 483 w 1126"/>
              <a:gd name="T51" fmla="*/ 0 h 537"/>
              <a:gd name="T52" fmla="*/ 499 w 1126"/>
              <a:gd name="T53" fmla="*/ 0 h 537"/>
              <a:gd name="T54" fmla="*/ 521 w 1126"/>
              <a:gd name="T55" fmla="*/ 0 h 537"/>
              <a:gd name="T56" fmla="*/ 536 w 1126"/>
              <a:gd name="T57" fmla="*/ 0 h 537"/>
              <a:gd name="T58" fmla="*/ 559 w 1126"/>
              <a:gd name="T59" fmla="*/ 0 h 537"/>
              <a:gd name="T60" fmla="*/ 574 w 1126"/>
              <a:gd name="T61" fmla="*/ 0 h 537"/>
              <a:gd name="T62" fmla="*/ 596 w 1126"/>
              <a:gd name="T63" fmla="*/ 1 h 537"/>
              <a:gd name="T64" fmla="*/ 612 w 1126"/>
              <a:gd name="T65" fmla="*/ 1 h 537"/>
              <a:gd name="T66" fmla="*/ 634 w 1126"/>
              <a:gd name="T67" fmla="*/ 1 h 537"/>
              <a:gd name="T68" fmla="*/ 649 w 1126"/>
              <a:gd name="T69" fmla="*/ 2 h 537"/>
              <a:gd name="T70" fmla="*/ 673 w 1126"/>
              <a:gd name="T71" fmla="*/ 2 h 537"/>
              <a:gd name="T72" fmla="*/ 687 w 1126"/>
              <a:gd name="T73" fmla="*/ 3 h 537"/>
              <a:gd name="T74" fmla="*/ 710 w 1126"/>
              <a:gd name="T75" fmla="*/ 3 h 537"/>
              <a:gd name="T76" fmla="*/ 725 w 1126"/>
              <a:gd name="T77" fmla="*/ 4 h 537"/>
              <a:gd name="T78" fmla="*/ 748 w 1126"/>
              <a:gd name="T79" fmla="*/ 6 h 537"/>
              <a:gd name="T80" fmla="*/ 763 w 1126"/>
              <a:gd name="T81" fmla="*/ 8 h 537"/>
              <a:gd name="T82" fmla="*/ 786 w 1126"/>
              <a:gd name="T83" fmla="*/ 10 h 537"/>
              <a:gd name="T84" fmla="*/ 801 w 1126"/>
              <a:gd name="T85" fmla="*/ 13 h 537"/>
              <a:gd name="T86" fmla="*/ 824 w 1126"/>
              <a:gd name="T87" fmla="*/ 17 h 537"/>
              <a:gd name="T88" fmla="*/ 839 w 1126"/>
              <a:gd name="T89" fmla="*/ 22 h 537"/>
              <a:gd name="T90" fmla="*/ 861 w 1126"/>
              <a:gd name="T91" fmla="*/ 30 h 537"/>
              <a:gd name="T92" fmla="*/ 877 w 1126"/>
              <a:gd name="T93" fmla="*/ 36 h 537"/>
              <a:gd name="T94" fmla="*/ 899 w 1126"/>
              <a:gd name="T95" fmla="*/ 49 h 537"/>
              <a:gd name="T96" fmla="*/ 915 w 1126"/>
              <a:gd name="T97" fmla="*/ 61 h 537"/>
              <a:gd name="T98" fmla="*/ 937 w 1126"/>
              <a:gd name="T99" fmla="*/ 82 h 537"/>
              <a:gd name="T100" fmla="*/ 952 w 1126"/>
              <a:gd name="T101" fmla="*/ 99 h 537"/>
              <a:gd name="T102" fmla="*/ 975 w 1126"/>
              <a:gd name="T103" fmla="*/ 131 h 537"/>
              <a:gd name="T104" fmla="*/ 990 w 1126"/>
              <a:gd name="T105" fmla="*/ 157 h 537"/>
              <a:gd name="T106" fmla="*/ 1012 w 1126"/>
              <a:gd name="T107" fmla="*/ 205 h 537"/>
              <a:gd name="T108" fmla="*/ 1028 w 1126"/>
              <a:gd name="T109" fmla="*/ 241 h 537"/>
              <a:gd name="T110" fmla="*/ 1050 w 1126"/>
              <a:gd name="T111" fmla="*/ 302 h 537"/>
              <a:gd name="T112" fmla="*/ 1065 w 1126"/>
              <a:gd name="T113" fmla="*/ 346 h 537"/>
              <a:gd name="T114" fmla="*/ 1088 w 1126"/>
              <a:gd name="T115" fmla="*/ 418 h 537"/>
              <a:gd name="T116" fmla="*/ 1103 w 1126"/>
              <a:gd name="T117" fmla="*/ 466 h 537"/>
              <a:gd name="T118" fmla="*/ 1126 w 1126"/>
              <a:gd name="T119" fmla="*/ 537 h 5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126" h="537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7" y="0"/>
                </a:lnTo>
                <a:lnTo>
                  <a:pt x="7" y="0"/>
                </a:lnTo>
                <a:lnTo>
                  <a:pt x="15" y="0"/>
                </a:lnTo>
                <a:lnTo>
                  <a:pt x="15" y="0"/>
                </a:lnTo>
                <a:lnTo>
                  <a:pt x="22" y="0"/>
                </a:lnTo>
                <a:lnTo>
                  <a:pt x="22" y="0"/>
                </a:lnTo>
                <a:lnTo>
                  <a:pt x="30" y="0"/>
                </a:lnTo>
                <a:lnTo>
                  <a:pt x="30" y="0"/>
                </a:lnTo>
                <a:lnTo>
                  <a:pt x="38" y="0"/>
                </a:lnTo>
                <a:lnTo>
                  <a:pt x="38" y="0"/>
                </a:lnTo>
                <a:lnTo>
                  <a:pt x="45" y="0"/>
                </a:lnTo>
                <a:lnTo>
                  <a:pt x="45" y="0"/>
                </a:lnTo>
                <a:lnTo>
                  <a:pt x="52" y="0"/>
                </a:lnTo>
                <a:lnTo>
                  <a:pt x="52" y="0"/>
                </a:lnTo>
                <a:lnTo>
                  <a:pt x="60" y="0"/>
                </a:lnTo>
                <a:lnTo>
                  <a:pt x="60" y="0"/>
                </a:lnTo>
                <a:lnTo>
                  <a:pt x="68" y="0"/>
                </a:lnTo>
                <a:lnTo>
                  <a:pt x="68" y="0"/>
                </a:lnTo>
                <a:lnTo>
                  <a:pt x="75" y="0"/>
                </a:lnTo>
                <a:lnTo>
                  <a:pt x="75" y="0"/>
                </a:lnTo>
                <a:lnTo>
                  <a:pt x="83" y="0"/>
                </a:lnTo>
                <a:lnTo>
                  <a:pt x="83" y="0"/>
                </a:lnTo>
                <a:lnTo>
                  <a:pt x="90" y="0"/>
                </a:lnTo>
                <a:lnTo>
                  <a:pt x="90" y="0"/>
                </a:lnTo>
                <a:lnTo>
                  <a:pt x="98" y="0"/>
                </a:lnTo>
                <a:lnTo>
                  <a:pt x="98" y="0"/>
                </a:lnTo>
                <a:lnTo>
                  <a:pt x="105" y="0"/>
                </a:lnTo>
                <a:lnTo>
                  <a:pt x="105" y="0"/>
                </a:lnTo>
                <a:lnTo>
                  <a:pt x="113" y="0"/>
                </a:lnTo>
                <a:lnTo>
                  <a:pt x="113" y="0"/>
                </a:lnTo>
                <a:lnTo>
                  <a:pt x="121" y="0"/>
                </a:lnTo>
                <a:lnTo>
                  <a:pt x="121" y="0"/>
                </a:lnTo>
                <a:lnTo>
                  <a:pt x="128" y="0"/>
                </a:lnTo>
                <a:lnTo>
                  <a:pt x="128" y="0"/>
                </a:lnTo>
                <a:lnTo>
                  <a:pt x="136" y="0"/>
                </a:lnTo>
                <a:lnTo>
                  <a:pt x="136" y="0"/>
                </a:lnTo>
                <a:lnTo>
                  <a:pt x="143" y="0"/>
                </a:lnTo>
                <a:lnTo>
                  <a:pt x="143" y="0"/>
                </a:lnTo>
                <a:lnTo>
                  <a:pt x="151" y="0"/>
                </a:lnTo>
                <a:lnTo>
                  <a:pt x="151" y="0"/>
                </a:lnTo>
                <a:lnTo>
                  <a:pt x="158" y="0"/>
                </a:lnTo>
                <a:lnTo>
                  <a:pt x="158" y="0"/>
                </a:lnTo>
                <a:lnTo>
                  <a:pt x="166" y="0"/>
                </a:lnTo>
                <a:lnTo>
                  <a:pt x="166" y="0"/>
                </a:lnTo>
                <a:lnTo>
                  <a:pt x="174" y="0"/>
                </a:lnTo>
                <a:lnTo>
                  <a:pt x="174" y="0"/>
                </a:lnTo>
                <a:lnTo>
                  <a:pt x="181" y="0"/>
                </a:lnTo>
                <a:lnTo>
                  <a:pt x="181" y="0"/>
                </a:lnTo>
                <a:lnTo>
                  <a:pt x="189" y="0"/>
                </a:lnTo>
                <a:lnTo>
                  <a:pt x="189" y="0"/>
                </a:lnTo>
                <a:lnTo>
                  <a:pt x="196" y="0"/>
                </a:lnTo>
                <a:lnTo>
                  <a:pt x="196" y="0"/>
                </a:lnTo>
                <a:lnTo>
                  <a:pt x="204" y="0"/>
                </a:lnTo>
                <a:lnTo>
                  <a:pt x="204" y="0"/>
                </a:lnTo>
                <a:lnTo>
                  <a:pt x="211" y="0"/>
                </a:lnTo>
                <a:lnTo>
                  <a:pt x="211" y="0"/>
                </a:lnTo>
                <a:lnTo>
                  <a:pt x="219" y="0"/>
                </a:lnTo>
                <a:lnTo>
                  <a:pt x="219" y="0"/>
                </a:lnTo>
                <a:lnTo>
                  <a:pt x="227" y="0"/>
                </a:lnTo>
                <a:lnTo>
                  <a:pt x="227" y="0"/>
                </a:lnTo>
                <a:lnTo>
                  <a:pt x="234" y="0"/>
                </a:lnTo>
                <a:lnTo>
                  <a:pt x="234" y="0"/>
                </a:lnTo>
                <a:lnTo>
                  <a:pt x="242" y="0"/>
                </a:lnTo>
                <a:lnTo>
                  <a:pt x="242" y="0"/>
                </a:lnTo>
                <a:lnTo>
                  <a:pt x="249" y="0"/>
                </a:lnTo>
                <a:lnTo>
                  <a:pt x="249" y="0"/>
                </a:lnTo>
                <a:lnTo>
                  <a:pt x="257" y="0"/>
                </a:lnTo>
                <a:lnTo>
                  <a:pt x="257" y="0"/>
                </a:lnTo>
                <a:lnTo>
                  <a:pt x="264" y="0"/>
                </a:lnTo>
                <a:lnTo>
                  <a:pt x="264" y="0"/>
                </a:lnTo>
                <a:lnTo>
                  <a:pt x="271" y="0"/>
                </a:lnTo>
                <a:lnTo>
                  <a:pt x="271" y="0"/>
                </a:lnTo>
                <a:lnTo>
                  <a:pt x="280" y="0"/>
                </a:lnTo>
                <a:lnTo>
                  <a:pt x="280" y="0"/>
                </a:lnTo>
                <a:lnTo>
                  <a:pt x="287" y="0"/>
                </a:lnTo>
                <a:lnTo>
                  <a:pt x="287" y="0"/>
                </a:lnTo>
                <a:lnTo>
                  <a:pt x="295" y="0"/>
                </a:lnTo>
                <a:lnTo>
                  <a:pt x="295" y="0"/>
                </a:lnTo>
                <a:lnTo>
                  <a:pt x="302" y="0"/>
                </a:lnTo>
                <a:lnTo>
                  <a:pt x="302" y="0"/>
                </a:lnTo>
                <a:lnTo>
                  <a:pt x="310" y="0"/>
                </a:lnTo>
                <a:lnTo>
                  <a:pt x="310" y="0"/>
                </a:lnTo>
                <a:lnTo>
                  <a:pt x="317" y="0"/>
                </a:lnTo>
                <a:lnTo>
                  <a:pt x="317" y="0"/>
                </a:lnTo>
                <a:lnTo>
                  <a:pt x="324" y="0"/>
                </a:lnTo>
                <a:lnTo>
                  <a:pt x="324" y="0"/>
                </a:lnTo>
                <a:lnTo>
                  <a:pt x="332" y="0"/>
                </a:lnTo>
                <a:lnTo>
                  <a:pt x="332" y="0"/>
                </a:lnTo>
                <a:lnTo>
                  <a:pt x="340" y="0"/>
                </a:lnTo>
                <a:lnTo>
                  <a:pt x="340" y="0"/>
                </a:lnTo>
                <a:lnTo>
                  <a:pt x="348" y="0"/>
                </a:lnTo>
                <a:lnTo>
                  <a:pt x="348" y="0"/>
                </a:lnTo>
                <a:lnTo>
                  <a:pt x="355" y="0"/>
                </a:lnTo>
                <a:lnTo>
                  <a:pt x="355" y="0"/>
                </a:lnTo>
                <a:lnTo>
                  <a:pt x="362" y="0"/>
                </a:lnTo>
                <a:lnTo>
                  <a:pt x="362" y="0"/>
                </a:lnTo>
                <a:lnTo>
                  <a:pt x="370" y="0"/>
                </a:lnTo>
                <a:lnTo>
                  <a:pt x="370" y="0"/>
                </a:lnTo>
                <a:lnTo>
                  <a:pt x="377" y="0"/>
                </a:lnTo>
                <a:lnTo>
                  <a:pt x="377" y="0"/>
                </a:lnTo>
                <a:lnTo>
                  <a:pt x="385" y="0"/>
                </a:lnTo>
                <a:lnTo>
                  <a:pt x="385" y="0"/>
                </a:lnTo>
                <a:lnTo>
                  <a:pt x="393" y="0"/>
                </a:lnTo>
                <a:lnTo>
                  <a:pt x="393" y="0"/>
                </a:lnTo>
                <a:lnTo>
                  <a:pt x="401" y="0"/>
                </a:lnTo>
                <a:lnTo>
                  <a:pt x="401" y="0"/>
                </a:lnTo>
                <a:lnTo>
                  <a:pt x="408" y="0"/>
                </a:lnTo>
                <a:lnTo>
                  <a:pt x="408" y="0"/>
                </a:lnTo>
                <a:lnTo>
                  <a:pt x="415" y="0"/>
                </a:lnTo>
                <a:lnTo>
                  <a:pt x="415" y="0"/>
                </a:lnTo>
                <a:lnTo>
                  <a:pt x="423" y="0"/>
                </a:lnTo>
                <a:lnTo>
                  <a:pt x="423" y="0"/>
                </a:lnTo>
                <a:lnTo>
                  <a:pt x="430" y="0"/>
                </a:lnTo>
                <a:lnTo>
                  <a:pt x="430" y="0"/>
                </a:lnTo>
                <a:lnTo>
                  <a:pt x="438" y="0"/>
                </a:lnTo>
                <a:lnTo>
                  <a:pt x="438" y="0"/>
                </a:lnTo>
                <a:lnTo>
                  <a:pt x="446" y="0"/>
                </a:lnTo>
                <a:lnTo>
                  <a:pt x="446" y="0"/>
                </a:lnTo>
                <a:lnTo>
                  <a:pt x="453" y="0"/>
                </a:lnTo>
                <a:lnTo>
                  <a:pt x="453" y="0"/>
                </a:lnTo>
                <a:lnTo>
                  <a:pt x="461" y="0"/>
                </a:lnTo>
                <a:lnTo>
                  <a:pt x="461" y="0"/>
                </a:lnTo>
                <a:lnTo>
                  <a:pt x="468" y="0"/>
                </a:lnTo>
                <a:lnTo>
                  <a:pt x="468" y="0"/>
                </a:lnTo>
                <a:lnTo>
                  <a:pt x="476" y="0"/>
                </a:lnTo>
                <a:lnTo>
                  <a:pt x="476" y="0"/>
                </a:lnTo>
                <a:lnTo>
                  <a:pt x="483" y="0"/>
                </a:lnTo>
                <a:lnTo>
                  <a:pt x="483" y="0"/>
                </a:lnTo>
                <a:lnTo>
                  <a:pt x="491" y="0"/>
                </a:lnTo>
                <a:lnTo>
                  <a:pt x="491" y="0"/>
                </a:lnTo>
                <a:lnTo>
                  <a:pt x="499" y="0"/>
                </a:lnTo>
                <a:lnTo>
                  <a:pt x="499" y="0"/>
                </a:lnTo>
                <a:lnTo>
                  <a:pt x="506" y="0"/>
                </a:lnTo>
                <a:lnTo>
                  <a:pt x="506" y="0"/>
                </a:lnTo>
                <a:lnTo>
                  <a:pt x="514" y="0"/>
                </a:lnTo>
                <a:lnTo>
                  <a:pt x="514" y="0"/>
                </a:lnTo>
                <a:lnTo>
                  <a:pt x="521" y="0"/>
                </a:lnTo>
                <a:lnTo>
                  <a:pt x="521" y="0"/>
                </a:lnTo>
                <a:lnTo>
                  <a:pt x="529" y="0"/>
                </a:lnTo>
                <a:lnTo>
                  <a:pt x="529" y="0"/>
                </a:lnTo>
                <a:lnTo>
                  <a:pt x="536" y="0"/>
                </a:lnTo>
                <a:lnTo>
                  <a:pt x="536" y="0"/>
                </a:lnTo>
                <a:lnTo>
                  <a:pt x="543" y="0"/>
                </a:lnTo>
                <a:lnTo>
                  <a:pt x="543" y="0"/>
                </a:lnTo>
                <a:lnTo>
                  <a:pt x="552" y="0"/>
                </a:lnTo>
                <a:lnTo>
                  <a:pt x="552" y="0"/>
                </a:lnTo>
                <a:lnTo>
                  <a:pt x="559" y="0"/>
                </a:lnTo>
                <a:lnTo>
                  <a:pt x="559" y="0"/>
                </a:lnTo>
                <a:lnTo>
                  <a:pt x="567" y="0"/>
                </a:lnTo>
                <a:lnTo>
                  <a:pt x="567" y="0"/>
                </a:lnTo>
                <a:lnTo>
                  <a:pt x="574" y="0"/>
                </a:lnTo>
                <a:lnTo>
                  <a:pt x="574" y="0"/>
                </a:lnTo>
                <a:lnTo>
                  <a:pt x="582" y="0"/>
                </a:lnTo>
                <a:lnTo>
                  <a:pt x="582" y="0"/>
                </a:lnTo>
                <a:lnTo>
                  <a:pt x="589" y="0"/>
                </a:lnTo>
                <a:lnTo>
                  <a:pt x="589" y="0"/>
                </a:lnTo>
                <a:lnTo>
                  <a:pt x="596" y="1"/>
                </a:lnTo>
                <a:lnTo>
                  <a:pt x="596" y="1"/>
                </a:lnTo>
                <a:lnTo>
                  <a:pt x="604" y="1"/>
                </a:lnTo>
                <a:lnTo>
                  <a:pt x="604" y="1"/>
                </a:lnTo>
                <a:lnTo>
                  <a:pt x="612" y="1"/>
                </a:lnTo>
                <a:lnTo>
                  <a:pt x="612" y="1"/>
                </a:lnTo>
                <a:lnTo>
                  <a:pt x="620" y="1"/>
                </a:lnTo>
                <a:lnTo>
                  <a:pt x="620" y="1"/>
                </a:lnTo>
                <a:lnTo>
                  <a:pt x="627" y="1"/>
                </a:lnTo>
                <a:lnTo>
                  <a:pt x="627" y="1"/>
                </a:lnTo>
                <a:lnTo>
                  <a:pt x="634" y="1"/>
                </a:lnTo>
                <a:lnTo>
                  <a:pt x="634" y="1"/>
                </a:lnTo>
                <a:lnTo>
                  <a:pt x="642" y="1"/>
                </a:lnTo>
                <a:lnTo>
                  <a:pt x="642" y="1"/>
                </a:lnTo>
                <a:lnTo>
                  <a:pt x="649" y="2"/>
                </a:lnTo>
                <a:lnTo>
                  <a:pt x="649" y="2"/>
                </a:lnTo>
                <a:lnTo>
                  <a:pt x="657" y="2"/>
                </a:lnTo>
                <a:lnTo>
                  <a:pt x="657" y="2"/>
                </a:lnTo>
                <a:lnTo>
                  <a:pt x="665" y="2"/>
                </a:lnTo>
                <a:lnTo>
                  <a:pt x="665" y="2"/>
                </a:lnTo>
                <a:lnTo>
                  <a:pt x="673" y="2"/>
                </a:lnTo>
                <a:lnTo>
                  <a:pt x="673" y="2"/>
                </a:lnTo>
                <a:lnTo>
                  <a:pt x="680" y="3"/>
                </a:lnTo>
                <a:lnTo>
                  <a:pt x="680" y="3"/>
                </a:lnTo>
                <a:lnTo>
                  <a:pt x="687" y="3"/>
                </a:lnTo>
                <a:lnTo>
                  <a:pt x="687" y="3"/>
                </a:lnTo>
                <a:lnTo>
                  <a:pt x="695" y="3"/>
                </a:lnTo>
                <a:lnTo>
                  <a:pt x="695" y="3"/>
                </a:lnTo>
                <a:lnTo>
                  <a:pt x="702" y="3"/>
                </a:lnTo>
                <a:lnTo>
                  <a:pt x="702" y="3"/>
                </a:lnTo>
                <a:lnTo>
                  <a:pt x="710" y="3"/>
                </a:lnTo>
                <a:lnTo>
                  <a:pt x="710" y="3"/>
                </a:lnTo>
                <a:lnTo>
                  <a:pt x="718" y="4"/>
                </a:lnTo>
                <a:lnTo>
                  <a:pt x="718" y="4"/>
                </a:lnTo>
                <a:lnTo>
                  <a:pt x="725" y="4"/>
                </a:lnTo>
                <a:lnTo>
                  <a:pt x="725" y="4"/>
                </a:lnTo>
                <a:lnTo>
                  <a:pt x="733" y="5"/>
                </a:lnTo>
                <a:lnTo>
                  <a:pt x="733" y="5"/>
                </a:lnTo>
                <a:lnTo>
                  <a:pt x="740" y="5"/>
                </a:lnTo>
                <a:lnTo>
                  <a:pt x="740" y="5"/>
                </a:lnTo>
                <a:lnTo>
                  <a:pt x="748" y="6"/>
                </a:lnTo>
                <a:lnTo>
                  <a:pt x="748" y="6"/>
                </a:lnTo>
                <a:lnTo>
                  <a:pt x="755" y="7"/>
                </a:lnTo>
                <a:lnTo>
                  <a:pt x="755" y="7"/>
                </a:lnTo>
                <a:lnTo>
                  <a:pt x="763" y="8"/>
                </a:lnTo>
                <a:lnTo>
                  <a:pt x="763" y="8"/>
                </a:lnTo>
                <a:lnTo>
                  <a:pt x="771" y="8"/>
                </a:lnTo>
                <a:lnTo>
                  <a:pt x="771" y="8"/>
                </a:lnTo>
                <a:lnTo>
                  <a:pt x="778" y="9"/>
                </a:lnTo>
                <a:lnTo>
                  <a:pt x="778" y="9"/>
                </a:lnTo>
                <a:lnTo>
                  <a:pt x="786" y="10"/>
                </a:lnTo>
                <a:lnTo>
                  <a:pt x="786" y="10"/>
                </a:lnTo>
                <a:lnTo>
                  <a:pt x="793" y="11"/>
                </a:lnTo>
                <a:lnTo>
                  <a:pt x="793" y="11"/>
                </a:lnTo>
                <a:lnTo>
                  <a:pt x="801" y="13"/>
                </a:lnTo>
                <a:lnTo>
                  <a:pt x="801" y="13"/>
                </a:lnTo>
                <a:lnTo>
                  <a:pt x="808" y="14"/>
                </a:lnTo>
                <a:lnTo>
                  <a:pt x="808" y="14"/>
                </a:lnTo>
                <a:lnTo>
                  <a:pt x="816" y="16"/>
                </a:lnTo>
                <a:lnTo>
                  <a:pt x="816" y="16"/>
                </a:lnTo>
                <a:lnTo>
                  <a:pt x="824" y="17"/>
                </a:lnTo>
                <a:lnTo>
                  <a:pt x="824" y="17"/>
                </a:lnTo>
                <a:lnTo>
                  <a:pt x="831" y="19"/>
                </a:lnTo>
                <a:lnTo>
                  <a:pt x="831" y="19"/>
                </a:lnTo>
                <a:lnTo>
                  <a:pt x="839" y="22"/>
                </a:lnTo>
                <a:lnTo>
                  <a:pt x="839" y="22"/>
                </a:lnTo>
                <a:lnTo>
                  <a:pt x="846" y="24"/>
                </a:lnTo>
                <a:lnTo>
                  <a:pt x="846" y="24"/>
                </a:lnTo>
                <a:lnTo>
                  <a:pt x="854" y="26"/>
                </a:lnTo>
                <a:lnTo>
                  <a:pt x="854" y="26"/>
                </a:lnTo>
                <a:lnTo>
                  <a:pt x="861" y="30"/>
                </a:lnTo>
                <a:lnTo>
                  <a:pt x="861" y="30"/>
                </a:lnTo>
                <a:lnTo>
                  <a:pt x="869" y="32"/>
                </a:lnTo>
                <a:lnTo>
                  <a:pt x="869" y="32"/>
                </a:lnTo>
                <a:lnTo>
                  <a:pt x="877" y="36"/>
                </a:lnTo>
                <a:lnTo>
                  <a:pt x="877" y="36"/>
                </a:lnTo>
                <a:lnTo>
                  <a:pt x="884" y="40"/>
                </a:lnTo>
                <a:lnTo>
                  <a:pt x="884" y="40"/>
                </a:lnTo>
                <a:lnTo>
                  <a:pt x="892" y="45"/>
                </a:lnTo>
                <a:lnTo>
                  <a:pt x="892" y="45"/>
                </a:lnTo>
                <a:lnTo>
                  <a:pt x="899" y="49"/>
                </a:lnTo>
                <a:lnTo>
                  <a:pt x="899" y="49"/>
                </a:lnTo>
                <a:lnTo>
                  <a:pt x="906" y="54"/>
                </a:lnTo>
                <a:lnTo>
                  <a:pt x="906" y="54"/>
                </a:lnTo>
                <a:lnTo>
                  <a:pt x="915" y="61"/>
                </a:lnTo>
                <a:lnTo>
                  <a:pt x="915" y="61"/>
                </a:lnTo>
                <a:lnTo>
                  <a:pt x="922" y="66"/>
                </a:lnTo>
                <a:lnTo>
                  <a:pt x="922" y="66"/>
                </a:lnTo>
                <a:lnTo>
                  <a:pt x="930" y="74"/>
                </a:lnTo>
                <a:lnTo>
                  <a:pt x="930" y="74"/>
                </a:lnTo>
                <a:lnTo>
                  <a:pt x="937" y="82"/>
                </a:lnTo>
                <a:lnTo>
                  <a:pt x="937" y="82"/>
                </a:lnTo>
                <a:lnTo>
                  <a:pt x="945" y="90"/>
                </a:lnTo>
                <a:lnTo>
                  <a:pt x="945" y="90"/>
                </a:lnTo>
                <a:lnTo>
                  <a:pt x="952" y="99"/>
                </a:lnTo>
                <a:lnTo>
                  <a:pt x="952" y="99"/>
                </a:lnTo>
                <a:lnTo>
                  <a:pt x="959" y="109"/>
                </a:lnTo>
                <a:lnTo>
                  <a:pt x="959" y="109"/>
                </a:lnTo>
                <a:lnTo>
                  <a:pt x="967" y="120"/>
                </a:lnTo>
                <a:lnTo>
                  <a:pt x="967" y="120"/>
                </a:lnTo>
                <a:lnTo>
                  <a:pt x="975" y="131"/>
                </a:lnTo>
                <a:lnTo>
                  <a:pt x="975" y="131"/>
                </a:lnTo>
                <a:lnTo>
                  <a:pt x="983" y="144"/>
                </a:lnTo>
                <a:lnTo>
                  <a:pt x="983" y="144"/>
                </a:lnTo>
                <a:lnTo>
                  <a:pt x="990" y="157"/>
                </a:lnTo>
                <a:lnTo>
                  <a:pt x="990" y="157"/>
                </a:lnTo>
                <a:lnTo>
                  <a:pt x="997" y="173"/>
                </a:lnTo>
                <a:lnTo>
                  <a:pt x="997" y="173"/>
                </a:lnTo>
                <a:lnTo>
                  <a:pt x="1005" y="188"/>
                </a:lnTo>
                <a:lnTo>
                  <a:pt x="1005" y="188"/>
                </a:lnTo>
                <a:lnTo>
                  <a:pt x="1012" y="205"/>
                </a:lnTo>
                <a:lnTo>
                  <a:pt x="1012" y="205"/>
                </a:lnTo>
                <a:lnTo>
                  <a:pt x="1020" y="222"/>
                </a:lnTo>
                <a:lnTo>
                  <a:pt x="1020" y="222"/>
                </a:lnTo>
                <a:lnTo>
                  <a:pt x="1028" y="241"/>
                </a:lnTo>
                <a:lnTo>
                  <a:pt x="1028" y="241"/>
                </a:lnTo>
                <a:lnTo>
                  <a:pt x="1036" y="260"/>
                </a:lnTo>
                <a:lnTo>
                  <a:pt x="1036" y="260"/>
                </a:lnTo>
                <a:lnTo>
                  <a:pt x="1043" y="281"/>
                </a:lnTo>
                <a:lnTo>
                  <a:pt x="1043" y="281"/>
                </a:lnTo>
                <a:lnTo>
                  <a:pt x="1050" y="302"/>
                </a:lnTo>
                <a:lnTo>
                  <a:pt x="1050" y="302"/>
                </a:lnTo>
                <a:lnTo>
                  <a:pt x="1058" y="324"/>
                </a:lnTo>
                <a:lnTo>
                  <a:pt x="1058" y="324"/>
                </a:lnTo>
                <a:lnTo>
                  <a:pt x="1065" y="346"/>
                </a:lnTo>
                <a:lnTo>
                  <a:pt x="1065" y="346"/>
                </a:lnTo>
                <a:lnTo>
                  <a:pt x="1073" y="370"/>
                </a:lnTo>
                <a:lnTo>
                  <a:pt x="1073" y="370"/>
                </a:lnTo>
                <a:lnTo>
                  <a:pt x="1081" y="394"/>
                </a:lnTo>
                <a:lnTo>
                  <a:pt x="1081" y="394"/>
                </a:lnTo>
                <a:lnTo>
                  <a:pt x="1088" y="418"/>
                </a:lnTo>
                <a:lnTo>
                  <a:pt x="1088" y="418"/>
                </a:lnTo>
                <a:lnTo>
                  <a:pt x="1096" y="442"/>
                </a:lnTo>
                <a:lnTo>
                  <a:pt x="1096" y="442"/>
                </a:lnTo>
                <a:lnTo>
                  <a:pt x="1103" y="466"/>
                </a:lnTo>
                <a:lnTo>
                  <a:pt x="1103" y="466"/>
                </a:lnTo>
                <a:lnTo>
                  <a:pt x="1111" y="489"/>
                </a:lnTo>
                <a:lnTo>
                  <a:pt x="1111" y="489"/>
                </a:lnTo>
                <a:lnTo>
                  <a:pt x="1118" y="514"/>
                </a:lnTo>
                <a:lnTo>
                  <a:pt x="1118" y="514"/>
                </a:lnTo>
                <a:lnTo>
                  <a:pt x="1126" y="537"/>
                </a:lnTo>
              </a:path>
            </a:pathLst>
          </a:custGeom>
          <a:noFill/>
          <a:ln w="142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230" name="Rectangle 219"/>
          <p:cNvSpPr>
            <a:spLocks noChangeArrowheads="1"/>
          </p:cNvSpPr>
          <p:nvPr/>
        </p:nvSpPr>
        <p:spPr bwMode="auto">
          <a:xfrm>
            <a:off x="5969795" y="2626519"/>
            <a:ext cx="639599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Log Molar conc</a:t>
            </a:r>
            <a:endParaRPr lang="en-US" altLang="en-US" sz="675">
              <a:latin typeface="+mn-lt"/>
            </a:endParaRPr>
          </a:p>
        </p:txBody>
      </p:sp>
      <p:sp>
        <p:nvSpPr>
          <p:cNvPr id="256" name="Rectangle 255"/>
          <p:cNvSpPr/>
          <p:nvPr/>
        </p:nvSpPr>
        <p:spPr>
          <a:xfrm rot="16200000">
            <a:off x="2096702" y="1884665"/>
            <a:ext cx="148149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750" b="1" dirty="0"/>
              <a:t>RFU (Ex 340 nm/Em 460 nm)</a:t>
            </a:r>
            <a:endParaRPr lang="en-US" sz="750" b="1" dirty="0"/>
          </a:p>
        </p:txBody>
      </p:sp>
      <p:sp>
        <p:nvSpPr>
          <p:cNvPr id="257" name="Rectangle 256"/>
          <p:cNvSpPr/>
          <p:nvPr/>
        </p:nvSpPr>
        <p:spPr>
          <a:xfrm rot="16200000">
            <a:off x="4372332" y="1884665"/>
            <a:ext cx="148149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750" b="1" dirty="0"/>
              <a:t>RFU (Ex 340 nm/Em 460 nm)</a:t>
            </a:r>
            <a:endParaRPr lang="en-US" sz="750" b="1" dirty="0"/>
          </a:p>
        </p:txBody>
      </p:sp>
      <p:sp>
        <p:nvSpPr>
          <p:cNvPr id="262" name="Rectangle 249"/>
          <p:cNvSpPr>
            <a:spLocks noChangeArrowheads="1"/>
          </p:cNvSpPr>
          <p:nvPr/>
        </p:nvSpPr>
        <p:spPr bwMode="auto">
          <a:xfrm>
            <a:off x="1084660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8.5</a:t>
            </a:r>
            <a:endParaRPr lang="en-US" altLang="en-US" sz="1350"/>
          </a:p>
        </p:txBody>
      </p:sp>
      <p:sp>
        <p:nvSpPr>
          <p:cNvPr id="263" name="Rectangle 250"/>
          <p:cNvSpPr>
            <a:spLocks noChangeArrowheads="1"/>
          </p:cNvSpPr>
          <p:nvPr/>
        </p:nvSpPr>
        <p:spPr bwMode="auto">
          <a:xfrm>
            <a:off x="1258491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8.0</a:t>
            </a:r>
            <a:endParaRPr lang="en-US" altLang="en-US" sz="1350"/>
          </a:p>
        </p:txBody>
      </p:sp>
      <p:sp>
        <p:nvSpPr>
          <p:cNvPr id="264" name="Rectangle 251"/>
          <p:cNvSpPr>
            <a:spLocks noChangeArrowheads="1"/>
          </p:cNvSpPr>
          <p:nvPr/>
        </p:nvSpPr>
        <p:spPr bwMode="auto">
          <a:xfrm>
            <a:off x="1432322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7.5</a:t>
            </a:r>
            <a:endParaRPr lang="en-US" altLang="en-US" sz="1350"/>
          </a:p>
        </p:txBody>
      </p:sp>
      <p:sp>
        <p:nvSpPr>
          <p:cNvPr id="265" name="Rectangle 252"/>
          <p:cNvSpPr>
            <a:spLocks noChangeArrowheads="1"/>
          </p:cNvSpPr>
          <p:nvPr/>
        </p:nvSpPr>
        <p:spPr bwMode="auto">
          <a:xfrm>
            <a:off x="1606154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7.0</a:t>
            </a:r>
            <a:endParaRPr lang="en-US" altLang="en-US" sz="1350"/>
          </a:p>
        </p:txBody>
      </p:sp>
      <p:sp>
        <p:nvSpPr>
          <p:cNvPr id="266" name="Rectangle 253"/>
          <p:cNvSpPr>
            <a:spLocks noChangeArrowheads="1"/>
          </p:cNvSpPr>
          <p:nvPr/>
        </p:nvSpPr>
        <p:spPr bwMode="auto">
          <a:xfrm>
            <a:off x="1778794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6.5</a:t>
            </a:r>
            <a:endParaRPr lang="en-US" altLang="en-US" sz="1350"/>
          </a:p>
        </p:txBody>
      </p:sp>
      <p:sp>
        <p:nvSpPr>
          <p:cNvPr id="267" name="Rectangle 254"/>
          <p:cNvSpPr>
            <a:spLocks noChangeArrowheads="1"/>
          </p:cNvSpPr>
          <p:nvPr/>
        </p:nvSpPr>
        <p:spPr bwMode="auto">
          <a:xfrm>
            <a:off x="1952625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6.0</a:t>
            </a:r>
            <a:endParaRPr lang="en-US" altLang="en-US" sz="1350"/>
          </a:p>
        </p:txBody>
      </p:sp>
      <p:sp>
        <p:nvSpPr>
          <p:cNvPr id="268" name="Rectangle 255"/>
          <p:cNvSpPr>
            <a:spLocks noChangeArrowheads="1"/>
          </p:cNvSpPr>
          <p:nvPr/>
        </p:nvSpPr>
        <p:spPr bwMode="auto">
          <a:xfrm>
            <a:off x="2126456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5.5</a:t>
            </a:r>
            <a:endParaRPr lang="en-US" altLang="en-US" sz="1350"/>
          </a:p>
        </p:txBody>
      </p:sp>
      <p:sp>
        <p:nvSpPr>
          <p:cNvPr id="269" name="Rectangle 256"/>
          <p:cNvSpPr>
            <a:spLocks noChangeArrowheads="1"/>
          </p:cNvSpPr>
          <p:nvPr/>
        </p:nvSpPr>
        <p:spPr bwMode="auto">
          <a:xfrm>
            <a:off x="2300288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5.0</a:t>
            </a:r>
            <a:endParaRPr lang="en-US" altLang="en-US" sz="1350"/>
          </a:p>
        </p:txBody>
      </p:sp>
      <p:sp>
        <p:nvSpPr>
          <p:cNvPr id="270" name="Rectangle 257"/>
          <p:cNvSpPr>
            <a:spLocks noChangeArrowheads="1"/>
          </p:cNvSpPr>
          <p:nvPr/>
        </p:nvSpPr>
        <p:spPr bwMode="auto">
          <a:xfrm>
            <a:off x="2474119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4.5</a:t>
            </a:r>
            <a:endParaRPr lang="en-US" altLang="en-US" sz="1350"/>
          </a:p>
        </p:txBody>
      </p:sp>
      <p:sp>
        <p:nvSpPr>
          <p:cNvPr id="271" name="Rectangle 258"/>
          <p:cNvSpPr>
            <a:spLocks noChangeArrowheads="1"/>
          </p:cNvSpPr>
          <p:nvPr/>
        </p:nvSpPr>
        <p:spPr bwMode="auto">
          <a:xfrm>
            <a:off x="2647950" y="4100513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-4.0</a:t>
            </a:r>
            <a:endParaRPr lang="en-US" altLang="en-US" sz="1350"/>
          </a:p>
        </p:txBody>
      </p:sp>
      <p:sp>
        <p:nvSpPr>
          <p:cNvPr id="272" name="Freeform 259"/>
          <p:cNvSpPr>
            <a:spLocks noEditPoints="1"/>
          </p:cNvSpPr>
          <p:nvPr/>
        </p:nvSpPr>
        <p:spPr bwMode="auto">
          <a:xfrm>
            <a:off x="1146572" y="4055269"/>
            <a:ext cx="1572816" cy="32147"/>
          </a:xfrm>
          <a:custGeom>
            <a:avLst/>
            <a:gdLst>
              <a:gd name="T0" fmla="*/ 0 w 1321"/>
              <a:gd name="T1" fmla="*/ 0 h 27"/>
              <a:gd name="T2" fmla="*/ 1321 w 1321"/>
              <a:gd name="T3" fmla="*/ 0 h 27"/>
              <a:gd name="T4" fmla="*/ 4 w 1321"/>
              <a:gd name="T5" fmla="*/ 0 h 27"/>
              <a:gd name="T6" fmla="*/ 4 w 1321"/>
              <a:gd name="T7" fmla="*/ 27 h 27"/>
              <a:gd name="T8" fmla="*/ 150 w 1321"/>
              <a:gd name="T9" fmla="*/ 0 h 27"/>
              <a:gd name="T10" fmla="*/ 150 w 1321"/>
              <a:gd name="T11" fmla="*/ 27 h 27"/>
              <a:gd name="T12" fmla="*/ 296 w 1321"/>
              <a:gd name="T13" fmla="*/ 0 h 27"/>
              <a:gd name="T14" fmla="*/ 296 w 1321"/>
              <a:gd name="T15" fmla="*/ 27 h 27"/>
              <a:gd name="T16" fmla="*/ 442 w 1321"/>
              <a:gd name="T17" fmla="*/ 0 h 27"/>
              <a:gd name="T18" fmla="*/ 442 w 1321"/>
              <a:gd name="T19" fmla="*/ 27 h 27"/>
              <a:gd name="T20" fmla="*/ 588 w 1321"/>
              <a:gd name="T21" fmla="*/ 0 h 27"/>
              <a:gd name="T22" fmla="*/ 588 w 1321"/>
              <a:gd name="T23" fmla="*/ 27 h 27"/>
              <a:gd name="T24" fmla="*/ 733 w 1321"/>
              <a:gd name="T25" fmla="*/ 0 h 27"/>
              <a:gd name="T26" fmla="*/ 733 w 1321"/>
              <a:gd name="T27" fmla="*/ 27 h 27"/>
              <a:gd name="T28" fmla="*/ 879 w 1321"/>
              <a:gd name="T29" fmla="*/ 0 h 27"/>
              <a:gd name="T30" fmla="*/ 879 w 1321"/>
              <a:gd name="T31" fmla="*/ 27 h 27"/>
              <a:gd name="T32" fmla="*/ 1025 w 1321"/>
              <a:gd name="T33" fmla="*/ 0 h 27"/>
              <a:gd name="T34" fmla="*/ 1025 w 1321"/>
              <a:gd name="T35" fmla="*/ 27 h 27"/>
              <a:gd name="T36" fmla="*/ 1171 w 1321"/>
              <a:gd name="T37" fmla="*/ 0 h 27"/>
              <a:gd name="T38" fmla="*/ 1171 w 1321"/>
              <a:gd name="T39" fmla="*/ 27 h 27"/>
              <a:gd name="T40" fmla="*/ 1317 w 1321"/>
              <a:gd name="T41" fmla="*/ 0 h 27"/>
              <a:gd name="T42" fmla="*/ 1317 w 1321"/>
              <a:gd name="T43" fmla="*/ 27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321" h="27">
                <a:moveTo>
                  <a:pt x="0" y="0"/>
                </a:moveTo>
                <a:lnTo>
                  <a:pt x="1321" y="0"/>
                </a:lnTo>
                <a:moveTo>
                  <a:pt x="4" y="0"/>
                </a:moveTo>
                <a:lnTo>
                  <a:pt x="4" y="27"/>
                </a:lnTo>
                <a:moveTo>
                  <a:pt x="150" y="0"/>
                </a:moveTo>
                <a:lnTo>
                  <a:pt x="150" y="27"/>
                </a:lnTo>
                <a:moveTo>
                  <a:pt x="296" y="0"/>
                </a:moveTo>
                <a:lnTo>
                  <a:pt x="296" y="27"/>
                </a:lnTo>
                <a:moveTo>
                  <a:pt x="442" y="0"/>
                </a:moveTo>
                <a:lnTo>
                  <a:pt x="442" y="27"/>
                </a:lnTo>
                <a:moveTo>
                  <a:pt x="588" y="0"/>
                </a:moveTo>
                <a:lnTo>
                  <a:pt x="588" y="27"/>
                </a:lnTo>
                <a:moveTo>
                  <a:pt x="733" y="0"/>
                </a:moveTo>
                <a:lnTo>
                  <a:pt x="733" y="27"/>
                </a:lnTo>
                <a:moveTo>
                  <a:pt x="879" y="0"/>
                </a:moveTo>
                <a:lnTo>
                  <a:pt x="879" y="27"/>
                </a:lnTo>
                <a:moveTo>
                  <a:pt x="1025" y="0"/>
                </a:moveTo>
                <a:lnTo>
                  <a:pt x="1025" y="27"/>
                </a:lnTo>
                <a:moveTo>
                  <a:pt x="1171" y="0"/>
                </a:moveTo>
                <a:lnTo>
                  <a:pt x="1171" y="27"/>
                </a:lnTo>
                <a:moveTo>
                  <a:pt x="1317" y="0"/>
                </a:moveTo>
                <a:lnTo>
                  <a:pt x="1317" y="27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73" name="Rectangle 260"/>
          <p:cNvSpPr>
            <a:spLocks noChangeArrowheads="1"/>
          </p:cNvSpPr>
          <p:nvPr/>
        </p:nvSpPr>
        <p:spPr bwMode="auto">
          <a:xfrm>
            <a:off x="889397" y="4007644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20000</a:t>
            </a:r>
            <a:endParaRPr lang="en-US" altLang="en-US" sz="1350"/>
          </a:p>
        </p:txBody>
      </p:sp>
      <p:sp>
        <p:nvSpPr>
          <p:cNvPr id="274" name="Rectangle 261"/>
          <p:cNvSpPr>
            <a:spLocks noChangeArrowheads="1"/>
          </p:cNvSpPr>
          <p:nvPr/>
        </p:nvSpPr>
        <p:spPr bwMode="auto">
          <a:xfrm>
            <a:off x="889397" y="3659982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40000</a:t>
            </a:r>
            <a:endParaRPr lang="en-US" altLang="en-US" sz="1350"/>
          </a:p>
        </p:txBody>
      </p:sp>
      <p:sp>
        <p:nvSpPr>
          <p:cNvPr id="275" name="Rectangle 262"/>
          <p:cNvSpPr>
            <a:spLocks noChangeArrowheads="1"/>
          </p:cNvSpPr>
          <p:nvPr/>
        </p:nvSpPr>
        <p:spPr bwMode="auto">
          <a:xfrm>
            <a:off x="889397" y="3312319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60000</a:t>
            </a:r>
            <a:endParaRPr lang="en-US" altLang="en-US" sz="1350"/>
          </a:p>
        </p:txBody>
      </p:sp>
      <p:sp>
        <p:nvSpPr>
          <p:cNvPr id="276" name="Rectangle 263"/>
          <p:cNvSpPr>
            <a:spLocks noChangeArrowheads="1"/>
          </p:cNvSpPr>
          <p:nvPr/>
        </p:nvSpPr>
        <p:spPr bwMode="auto">
          <a:xfrm>
            <a:off x="889397" y="2963467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80000</a:t>
            </a:r>
            <a:endParaRPr lang="en-US" altLang="en-US" sz="1350"/>
          </a:p>
        </p:txBody>
      </p:sp>
      <p:sp>
        <p:nvSpPr>
          <p:cNvPr id="277" name="Freeform 264"/>
          <p:cNvSpPr>
            <a:spLocks noEditPoints="1"/>
          </p:cNvSpPr>
          <p:nvPr/>
        </p:nvSpPr>
        <p:spPr bwMode="auto">
          <a:xfrm>
            <a:off x="1120379" y="3006329"/>
            <a:ext cx="30956" cy="1054894"/>
          </a:xfrm>
          <a:custGeom>
            <a:avLst/>
            <a:gdLst>
              <a:gd name="T0" fmla="*/ 26 w 26"/>
              <a:gd name="T1" fmla="*/ 886 h 886"/>
              <a:gd name="T2" fmla="*/ 26 w 26"/>
              <a:gd name="T3" fmla="*/ 0 h 886"/>
              <a:gd name="T4" fmla="*/ 26 w 26"/>
              <a:gd name="T5" fmla="*/ 881 h 886"/>
              <a:gd name="T6" fmla="*/ 0 w 26"/>
              <a:gd name="T7" fmla="*/ 881 h 886"/>
              <a:gd name="T8" fmla="*/ 26 w 26"/>
              <a:gd name="T9" fmla="*/ 589 h 886"/>
              <a:gd name="T10" fmla="*/ 0 w 26"/>
              <a:gd name="T11" fmla="*/ 589 h 886"/>
              <a:gd name="T12" fmla="*/ 26 w 26"/>
              <a:gd name="T13" fmla="*/ 297 h 886"/>
              <a:gd name="T14" fmla="*/ 0 w 26"/>
              <a:gd name="T15" fmla="*/ 297 h 886"/>
              <a:gd name="T16" fmla="*/ 26 w 26"/>
              <a:gd name="T17" fmla="*/ 5 h 886"/>
              <a:gd name="T18" fmla="*/ 0 w 26"/>
              <a:gd name="T19" fmla="*/ 5 h 8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6" h="886">
                <a:moveTo>
                  <a:pt x="26" y="886"/>
                </a:moveTo>
                <a:lnTo>
                  <a:pt x="26" y="0"/>
                </a:lnTo>
                <a:moveTo>
                  <a:pt x="26" y="881"/>
                </a:moveTo>
                <a:lnTo>
                  <a:pt x="0" y="881"/>
                </a:lnTo>
                <a:moveTo>
                  <a:pt x="26" y="589"/>
                </a:moveTo>
                <a:lnTo>
                  <a:pt x="0" y="589"/>
                </a:lnTo>
                <a:moveTo>
                  <a:pt x="26" y="297"/>
                </a:moveTo>
                <a:lnTo>
                  <a:pt x="0" y="297"/>
                </a:lnTo>
                <a:moveTo>
                  <a:pt x="26" y="5"/>
                </a:moveTo>
                <a:lnTo>
                  <a:pt x="0" y="5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78" name="Freeform 265"/>
          <p:cNvSpPr>
            <a:spLocks/>
          </p:cNvSpPr>
          <p:nvPr/>
        </p:nvSpPr>
        <p:spPr bwMode="auto">
          <a:xfrm>
            <a:off x="1325166" y="3206354"/>
            <a:ext cx="1347788" cy="794147"/>
          </a:xfrm>
          <a:custGeom>
            <a:avLst/>
            <a:gdLst>
              <a:gd name="T0" fmla="*/ 7 w 1132"/>
              <a:gd name="T1" fmla="*/ 0 h 667"/>
              <a:gd name="T2" fmla="*/ 30 w 1132"/>
              <a:gd name="T3" fmla="*/ 0 h 667"/>
              <a:gd name="T4" fmla="*/ 45 w 1132"/>
              <a:gd name="T5" fmla="*/ 0 h 667"/>
              <a:gd name="T6" fmla="*/ 68 w 1132"/>
              <a:gd name="T7" fmla="*/ 0 h 667"/>
              <a:gd name="T8" fmla="*/ 83 w 1132"/>
              <a:gd name="T9" fmla="*/ 0 h 667"/>
              <a:gd name="T10" fmla="*/ 106 w 1132"/>
              <a:gd name="T11" fmla="*/ 0 h 667"/>
              <a:gd name="T12" fmla="*/ 121 w 1132"/>
              <a:gd name="T13" fmla="*/ 0 h 667"/>
              <a:gd name="T14" fmla="*/ 143 w 1132"/>
              <a:gd name="T15" fmla="*/ 0 h 667"/>
              <a:gd name="T16" fmla="*/ 159 w 1132"/>
              <a:gd name="T17" fmla="*/ 0 h 667"/>
              <a:gd name="T18" fmla="*/ 181 w 1132"/>
              <a:gd name="T19" fmla="*/ 0 h 667"/>
              <a:gd name="T20" fmla="*/ 197 w 1132"/>
              <a:gd name="T21" fmla="*/ 0 h 667"/>
              <a:gd name="T22" fmla="*/ 220 w 1132"/>
              <a:gd name="T23" fmla="*/ 0 h 667"/>
              <a:gd name="T24" fmla="*/ 235 w 1132"/>
              <a:gd name="T25" fmla="*/ 0 h 667"/>
              <a:gd name="T26" fmla="*/ 258 w 1132"/>
              <a:gd name="T27" fmla="*/ 0 h 667"/>
              <a:gd name="T28" fmla="*/ 273 w 1132"/>
              <a:gd name="T29" fmla="*/ 0 h 667"/>
              <a:gd name="T30" fmla="*/ 296 w 1132"/>
              <a:gd name="T31" fmla="*/ 0 h 667"/>
              <a:gd name="T32" fmla="*/ 311 w 1132"/>
              <a:gd name="T33" fmla="*/ 0 h 667"/>
              <a:gd name="T34" fmla="*/ 334 w 1132"/>
              <a:gd name="T35" fmla="*/ 0 h 667"/>
              <a:gd name="T36" fmla="*/ 349 w 1132"/>
              <a:gd name="T37" fmla="*/ 0 h 667"/>
              <a:gd name="T38" fmla="*/ 372 w 1132"/>
              <a:gd name="T39" fmla="*/ 0 h 667"/>
              <a:gd name="T40" fmla="*/ 387 w 1132"/>
              <a:gd name="T41" fmla="*/ 0 h 667"/>
              <a:gd name="T42" fmla="*/ 410 w 1132"/>
              <a:gd name="T43" fmla="*/ 0 h 667"/>
              <a:gd name="T44" fmla="*/ 425 w 1132"/>
              <a:gd name="T45" fmla="*/ 0 h 667"/>
              <a:gd name="T46" fmla="*/ 448 w 1132"/>
              <a:gd name="T47" fmla="*/ 0 h 667"/>
              <a:gd name="T48" fmla="*/ 463 w 1132"/>
              <a:gd name="T49" fmla="*/ 0 h 667"/>
              <a:gd name="T50" fmla="*/ 486 w 1132"/>
              <a:gd name="T51" fmla="*/ 0 h 667"/>
              <a:gd name="T52" fmla="*/ 501 w 1132"/>
              <a:gd name="T53" fmla="*/ 0 h 667"/>
              <a:gd name="T54" fmla="*/ 524 w 1132"/>
              <a:gd name="T55" fmla="*/ 0 h 667"/>
              <a:gd name="T56" fmla="*/ 539 w 1132"/>
              <a:gd name="T57" fmla="*/ 1 h 667"/>
              <a:gd name="T58" fmla="*/ 562 w 1132"/>
              <a:gd name="T59" fmla="*/ 1 h 667"/>
              <a:gd name="T60" fmla="*/ 577 w 1132"/>
              <a:gd name="T61" fmla="*/ 2 h 667"/>
              <a:gd name="T62" fmla="*/ 599 w 1132"/>
              <a:gd name="T63" fmla="*/ 2 h 667"/>
              <a:gd name="T64" fmla="*/ 615 w 1132"/>
              <a:gd name="T65" fmla="*/ 3 h 667"/>
              <a:gd name="T66" fmla="*/ 637 w 1132"/>
              <a:gd name="T67" fmla="*/ 4 h 667"/>
              <a:gd name="T68" fmla="*/ 653 w 1132"/>
              <a:gd name="T69" fmla="*/ 5 h 667"/>
              <a:gd name="T70" fmla="*/ 676 w 1132"/>
              <a:gd name="T71" fmla="*/ 8 h 667"/>
              <a:gd name="T72" fmla="*/ 691 w 1132"/>
              <a:gd name="T73" fmla="*/ 9 h 667"/>
              <a:gd name="T74" fmla="*/ 714 w 1132"/>
              <a:gd name="T75" fmla="*/ 12 h 667"/>
              <a:gd name="T76" fmla="*/ 729 w 1132"/>
              <a:gd name="T77" fmla="*/ 14 h 667"/>
              <a:gd name="T78" fmla="*/ 752 w 1132"/>
              <a:gd name="T79" fmla="*/ 19 h 667"/>
              <a:gd name="T80" fmla="*/ 767 w 1132"/>
              <a:gd name="T81" fmla="*/ 23 h 667"/>
              <a:gd name="T82" fmla="*/ 790 w 1132"/>
              <a:gd name="T83" fmla="*/ 30 h 667"/>
              <a:gd name="T84" fmla="*/ 805 w 1132"/>
              <a:gd name="T85" fmla="*/ 36 h 667"/>
              <a:gd name="T86" fmla="*/ 828 w 1132"/>
              <a:gd name="T87" fmla="*/ 48 h 667"/>
              <a:gd name="T88" fmla="*/ 843 w 1132"/>
              <a:gd name="T89" fmla="*/ 56 h 667"/>
              <a:gd name="T90" fmla="*/ 866 w 1132"/>
              <a:gd name="T91" fmla="*/ 73 h 667"/>
              <a:gd name="T92" fmla="*/ 881 w 1132"/>
              <a:gd name="T93" fmla="*/ 87 h 667"/>
              <a:gd name="T94" fmla="*/ 904 w 1132"/>
              <a:gd name="T95" fmla="*/ 112 h 667"/>
              <a:gd name="T96" fmla="*/ 919 w 1132"/>
              <a:gd name="T97" fmla="*/ 132 h 667"/>
              <a:gd name="T98" fmla="*/ 942 w 1132"/>
              <a:gd name="T99" fmla="*/ 166 h 667"/>
              <a:gd name="T100" fmla="*/ 957 w 1132"/>
              <a:gd name="T101" fmla="*/ 194 h 667"/>
              <a:gd name="T102" fmla="*/ 980 w 1132"/>
              <a:gd name="T103" fmla="*/ 240 h 667"/>
              <a:gd name="T104" fmla="*/ 995 w 1132"/>
              <a:gd name="T105" fmla="*/ 276 h 667"/>
              <a:gd name="T106" fmla="*/ 1017 w 1132"/>
              <a:gd name="T107" fmla="*/ 334 h 667"/>
              <a:gd name="T108" fmla="*/ 1033 w 1132"/>
              <a:gd name="T109" fmla="*/ 376 h 667"/>
              <a:gd name="T110" fmla="*/ 1055 w 1132"/>
              <a:gd name="T111" fmla="*/ 443 h 667"/>
              <a:gd name="T112" fmla="*/ 1071 w 1132"/>
              <a:gd name="T113" fmla="*/ 489 h 667"/>
              <a:gd name="T114" fmla="*/ 1093 w 1132"/>
              <a:gd name="T115" fmla="*/ 558 h 667"/>
              <a:gd name="T116" fmla="*/ 1109 w 1132"/>
              <a:gd name="T117" fmla="*/ 603 h 667"/>
              <a:gd name="T118" fmla="*/ 1132 w 1132"/>
              <a:gd name="T119" fmla="*/ 667 h 6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132" h="667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7" y="0"/>
                </a:lnTo>
                <a:lnTo>
                  <a:pt x="7" y="0"/>
                </a:lnTo>
                <a:lnTo>
                  <a:pt x="14" y="0"/>
                </a:lnTo>
                <a:lnTo>
                  <a:pt x="14" y="0"/>
                </a:lnTo>
                <a:lnTo>
                  <a:pt x="22" y="0"/>
                </a:lnTo>
                <a:lnTo>
                  <a:pt x="22" y="0"/>
                </a:lnTo>
                <a:lnTo>
                  <a:pt x="30" y="0"/>
                </a:lnTo>
                <a:lnTo>
                  <a:pt x="30" y="0"/>
                </a:lnTo>
                <a:lnTo>
                  <a:pt x="38" y="0"/>
                </a:lnTo>
                <a:lnTo>
                  <a:pt x="38" y="0"/>
                </a:lnTo>
                <a:lnTo>
                  <a:pt x="45" y="0"/>
                </a:lnTo>
                <a:lnTo>
                  <a:pt x="45" y="0"/>
                </a:lnTo>
                <a:lnTo>
                  <a:pt x="52" y="0"/>
                </a:lnTo>
                <a:lnTo>
                  <a:pt x="52" y="0"/>
                </a:lnTo>
                <a:lnTo>
                  <a:pt x="60" y="0"/>
                </a:lnTo>
                <a:lnTo>
                  <a:pt x="60" y="0"/>
                </a:lnTo>
                <a:lnTo>
                  <a:pt x="68" y="0"/>
                </a:lnTo>
                <a:lnTo>
                  <a:pt x="68" y="0"/>
                </a:lnTo>
                <a:lnTo>
                  <a:pt x="76" y="0"/>
                </a:lnTo>
                <a:lnTo>
                  <a:pt x="76" y="0"/>
                </a:lnTo>
                <a:lnTo>
                  <a:pt x="83" y="0"/>
                </a:lnTo>
                <a:lnTo>
                  <a:pt x="83" y="0"/>
                </a:lnTo>
                <a:lnTo>
                  <a:pt x="90" y="0"/>
                </a:lnTo>
                <a:lnTo>
                  <a:pt x="90" y="0"/>
                </a:lnTo>
                <a:lnTo>
                  <a:pt x="98" y="0"/>
                </a:lnTo>
                <a:lnTo>
                  <a:pt x="98" y="0"/>
                </a:lnTo>
                <a:lnTo>
                  <a:pt x="106" y="0"/>
                </a:lnTo>
                <a:lnTo>
                  <a:pt x="106" y="0"/>
                </a:lnTo>
                <a:lnTo>
                  <a:pt x="114" y="0"/>
                </a:lnTo>
                <a:lnTo>
                  <a:pt x="114" y="0"/>
                </a:lnTo>
                <a:lnTo>
                  <a:pt x="121" y="0"/>
                </a:lnTo>
                <a:lnTo>
                  <a:pt x="121" y="0"/>
                </a:lnTo>
                <a:lnTo>
                  <a:pt x="129" y="0"/>
                </a:lnTo>
                <a:lnTo>
                  <a:pt x="129" y="0"/>
                </a:lnTo>
                <a:lnTo>
                  <a:pt x="136" y="0"/>
                </a:lnTo>
                <a:lnTo>
                  <a:pt x="136" y="0"/>
                </a:lnTo>
                <a:lnTo>
                  <a:pt x="143" y="0"/>
                </a:lnTo>
                <a:lnTo>
                  <a:pt x="143" y="0"/>
                </a:lnTo>
                <a:lnTo>
                  <a:pt x="151" y="0"/>
                </a:lnTo>
                <a:lnTo>
                  <a:pt x="151" y="0"/>
                </a:lnTo>
                <a:lnTo>
                  <a:pt x="159" y="0"/>
                </a:lnTo>
                <a:lnTo>
                  <a:pt x="159" y="0"/>
                </a:lnTo>
                <a:lnTo>
                  <a:pt x="167" y="0"/>
                </a:lnTo>
                <a:lnTo>
                  <a:pt x="167" y="0"/>
                </a:lnTo>
                <a:lnTo>
                  <a:pt x="174" y="0"/>
                </a:lnTo>
                <a:lnTo>
                  <a:pt x="174" y="0"/>
                </a:lnTo>
                <a:lnTo>
                  <a:pt x="181" y="0"/>
                </a:lnTo>
                <a:lnTo>
                  <a:pt x="181" y="0"/>
                </a:lnTo>
                <a:lnTo>
                  <a:pt x="190" y="0"/>
                </a:lnTo>
                <a:lnTo>
                  <a:pt x="190" y="0"/>
                </a:lnTo>
                <a:lnTo>
                  <a:pt x="197" y="0"/>
                </a:lnTo>
                <a:lnTo>
                  <a:pt x="197" y="0"/>
                </a:lnTo>
                <a:lnTo>
                  <a:pt x="205" y="0"/>
                </a:lnTo>
                <a:lnTo>
                  <a:pt x="205" y="0"/>
                </a:lnTo>
                <a:lnTo>
                  <a:pt x="212" y="0"/>
                </a:lnTo>
                <a:lnTo>
                  <a:pt x="212" y="0"/>
                </a:lnTo>
                <a:lnTo>
                  <a:pt x="220" y="0"/>
                </a:lnTo>
                <a:lnTo>
                  <a:pt x="220" y="0"/>
                </a:lnTo>
                <a:lnTo>
                  <a:pt x="228" y="0"/>
                </a:lnTo>
                <a:lnTo>
                  <a:pt x="228" y="0"/>
                </a:lnTo>
                <a:lnTo>
                  <a:pt x="235" y="0"/>
                </a:lnTo>
                <a:lnTo>
                  <a:pt x="235" y="0"/>
                </a:lnTo>
                <a:lnTo>
                  <a:pt x="243" y="0"/>
                </a:lnTo>
                <a:lnTo>
                  <a:pt x="243" y="0"/>
                </a:lnTo>
                <a:lnTo>
                  <a:pt x="250" y="0"/>
                </a:lnTo>
                <a:lnTo>
                  <a:pt x="250" y="0"/>
                </a:lnTo>
                <a:lnTo>
                  <a:pt x="258" y="0"/>
                </a:lnTo>
                <a:lnTo>
                  <a:pt x="258" y="0"/>
                </a:lnTo>
                <a:lnTo>
                  <a:pt x="265" y="0"/>
                </a:lnTo>
                <a:lnTo>
                  <a:pt x="265" y="0"/>
                </a:lnTo>
                <a:lnTo>
                  <a:pt x="273" y="0"/>
                </a:lnTo>
                <a:lnTo>
                  <a:pt x="273" y="0"/>
                </a:lnTo>
                <a:lnTo>
                  <a:pt x="281" y="0"/>
                </a:lnTo>
                <a:lnTo>
                  <a:pt x="281" y="0"/>
                </a:lnTo>
                <a:lnTo>
                  <a:pt x="288" y="0"/>
                </a:lnTo>
                <a:lnTo>
                  <a:pt x="288" y="0"/>
                </a:lnTo>
                <a:lnTo>
                  <a:pt x="296" y="0"/>
                </a:lnTo>
                <a:lnTo>
                  <a:pt x="296" y="0"/>
                </a:lnTo>
                <a:lnTo>
                  <a:pt x="303" y="0"/>
                </a:lnTo>
                <a:lnTo>
                  <a:pt x="303" y="0"/>
                </a:lnTo>
                <a:lnTo>
                  <a:pt x="311" y="0"/>
                </a:lnTo>
                <a:lnTo>
                  <a:pt x="311" y="0"/>
                </a:lnTo>
                <a:lnTo>
                  <a:pt x="319" y="0"/>
                </a:lnTo>
                <a:lnTo>
                  <a:pt x="319" y="0"/>
                </a:lnTo>
                <a:lnTo>
                  <a:pt x="326" y="0"/>
                </a:lnTo>
                <a:lnTo>
                  <a:pt x="326" y="0"/>
                </a:lnTo>
                <a:lnTo>
                  <a:pt x="334" y="0"/>
                </a:lnTo>
                <a:lnTo>
                  <a:pt x="334" y="0"/>
                </a:lnTo>
                <a:lnTo>
                  <a:pt x="341" y="0"/>
                </a:lnTo>
                <a:lnTo>
                  <a:pt x="341" y="0"/>
                </a:lnTo>
                <a:lnTo>
                  <a:pt x="349" y="0"/>
                </a:lnTo>
                <a:lnTo>
                  <a:pt x="349" y="0"/>
                </a:lnTo>
                <a:lnTo>
                  <a:pt x="357" y="0"/>
                </a:lnTo>
                <a:lnTo>
                  <a:pt x="357" y="0"/>
                </a:lnTo>
                <a:lnTo>
                  <a:pt x="364" y="0"/>
                </a:lnTo>
                <a:lnTo>
                  <a:pt x="364" y="0"/>
                </a:lnTo>
                <a:lnTo>
                  <a:pt x="372" y="0"/>
                </a:lnTo>
                <a:lnTo>
                  <a:pt x="372" y="0"/>
                </a:lnTo>
                <a:lnTo>
                  <a:pt x="379" y="0"/>
                </a:lnTo>
                <a:lnTo>
                  <a:pt x="379" y="0"/>
                </a:lnTo>
                <a:lnTo>
                  <a:pt x="387" y="0"/>
                </a:lnTo>
                <a:lnTo>
                  <a:pt x="387" y="0"/>
                </a:lnTo>
                <a:lnTo>
                  <a:pt x="395" y="0"/>
                </a:lnTo>
                <a:lnTo>
                  <a:pt x="395" y="0"/>
                </a:lnTo>
                <a:lnTo>
                  <a:pt x="403" y="0"/>
                </a:lnTo>
                <a:lnTo>
                  <a:pt x="403" y="0"/>
                </a:lnTo>
                <a:lnTo>
                  <a:pt x="410" y="0"/>
                </a:lnTo>
                <a:lnTo>
                  <a:pt x="410" y="0"/>
                </a:lnTo>
                <a:lnTo>
                  <a:pt x="417" y="0"/>
                </a:lnTo>
                <a:lnTo>
                  <a:pt x="417" y="0"/>
                </a:lnTo>
                <a:lnTo>
                  <a:pt x="425" y="0"/>
                </a:lnTo>
                <a:lnTo>
                  <a:pt x="425" y="0"/>
                </a:lnTo>
                <a:lnTo>
                  <a:pt x="432" y="0"/>
                </a:lnTo>
                <a:lnTo>
                  <a:pt x="432" y="0"/>
                </a:lnTo>
                <a:lnTo>
                  <a:pt x="440" y="0"/>
                </a:lnTo>
                <a:lnTo>
                  <a:pt x="440" y="0"/>
                </a:lnTo>
                <a:lnTo>
                  <a:pt x="448" y="0"/>
                </a:lnTo>
                <a:lnTo>
                  <a:pt x="448" y="0"/>
                </a:lnTo>
                <a:lnTo>
                  <a:pt x="455" y="0"/>
                </a:lnTo>
                <a:lnTo>
                  <a:pt x="455" y="0"/>
                </a:lnTo>
                <a:lnTo>
                  <a:pt x="463" y="0"/>
                </a:lnTo>
                <a:lnTo>
                  <a:pt x="463" y="0"/>
                </a:lnTo>
                <a:lnTo>
                  <a:pt x="470" y="0"/>
                </a:lnTo>
                <a:lnTo>
                  <a:pt x="470" y="0"/>
                </a:lnTo>
                <a:lnTo>
                  <a:pt x="478" y="0"/>
                </a:lnTo>
                <a:lnTo>
                  <a:pt x="478" y="0"/>
                </a:lnTo>
                <a:lnTo>
                  <a:pt x="486" y="0"/>
                </a:lnTo>
                <a:lnTo>
                  <a:pt x="486" y="0"/>
                </a:lnTo>
                <a:lnTo>
                  <a:pt x="494" y="0"/>
                </a:lnTo>
                <a:lnTo>
                  <a:pt x="494" y="0"/>
                </a:lnTo>
                <a:lnTo>
                  <a:pt x="501" y="0"/>
                </a:lnTo>
                <a:lnTo>
                  <a:pt x="501" y="0"/>
                </a:lnTo>
                <a:lnTo>
                  <a:pt x="508" y="0"/>
                </a:lnTo>
                <a:lnTo>
                  <a:pt x="508" y="0"/>
                </a:lnTo>
                <a:lnTo>
                  <a:pt x="516" y="0"/>
                </a:lnTo>
                <a:lnTo>
                  <a:pt x="516" y="0"/>
                </a:lnTo>
                <a:lnTo>
                  <a:pt x="524" y="0"/>
                </a:lnTo>
                <a:lnTo>
                  <a:pt x="524" y="0"/>
                </a:lnTo>
                <a:lnTo>
                  <a:pt x="532" y="1"/>
                </a:lnTo>
                <a:lnTo>
                  <a:pt x="532" y="1"/>
                </a:lnTo>
                <a:lnTo>
                  <a:pt x="539" y="1"/>
                </a:lnTo>
                <a:lnTo>
                  <a:pt x="539" y="1"/>
                </a:lnTo>
                <a:lnTo>
                  <a:pt x="546" y="1"/>
                </a:lnTo>
                <a:lnTo>
                  <a:pt x="546" y="1"/>
                </a:lnTo>
                <a:lnTo>
                  <a:pt x="554" y="1"/>
                </a:lnTo>
                <a:lnTo>
                  <a:pt x="554" y="1"/>
                </a:lnTo>
                <a:lnTo>
                  <a:pt x="562" y="1"/>
                </a:lnTo>
                <a:lnTo>
                  <a:pt x="562" y="1"/>
                </a:lnTo>
                <a:lnTo>
                  <a:pt x="569" y="2"/>
                </a:lnTo>
                <a:lnTo>
                  <a:pt x="569" y="2"/>
                </a:lnTo>
                <a:lnTo>
                  <a:pt x="577" y="2"/>
                </a:lnTo>
                <a:lnTo>
                  <a:pt x="577" y="2"/>
                </a:lnTo>
                <a:lnTo>
                  <a:pt x="585" y="2"/>
                </a:lnTo>
                <a:lnTo>
                  <a:pt x="585" y="2"/>
                </a:lnTo>
                <a:lnTo>
                  <a:pt x="592" y="2"/>
                </a:lnTo>
                <a:lnTo>
                  <a:pt x="592" y="2"/>
                </a:lnTo>
                <a:lnTo>
                  <a:pt x="599" y="2"/>
                </a:lnTo>
                <a:lnTo>
                  <a:pt x="599" y="2"/>
                </a:lnTo>
                <a:lnTo>
                  <a:pt x="607" y="3"/>
                </a:lnTo>
                <a:lnTo>
                  <a:pt x="607" y="3"/>
                </a:lnTo>
                <a:lnTo>
                  <a:pt x="615" y="3"/>
                </a:lnTo>
                <a:lnTo>
                  <a:pt x="615" y="3"/>
                </a:lnTo>
                <a:lnTo>
                  <a:pt x="623" y="3"/>
                </a:lnTo>
                <a:lnTo>
                  <a:pt x="623" y="3"/>
                </a:lnTo>
                <a:lnTo>
                  <a:pt x="630" y="4"/>
                </a:lnTo>
                <a:lnTo>
                  <a:pt x="630" y="4"/>
                </a:lnTo>
                <a:lnTo>
                  <a:pt x="637" y="4"/>
                </a:lnTo>
                <a:lnTo>
                  <a:pt x="637" y="4"/>
                </a:lnTo>
                <a:lnTo>
                  <a:pt x="646" y="4"/>
                </a:lnTo>
                <a:lnTo>
                  <a:pt x="646" y="4"/>
                </a:lnTo>
                <a:lnTo>
                  <a:pt x="653" y="5"/>
                </a:lnTo>
                <a:lnTo>
                  <a:pt x="653" y="5"/>
                </a:lnTo>
                <a:lnTo>
                  <a:pt x="661" y="6"/>
                </a:lnTo>
                <a:lnTo>
                  <a:pt x="661" y="6"/>
                </a:lnTo>
                <a:lnTo>
                  <a:pt x="668" y="7"/>
                </a:lnTo>
                <a:lnTo>
                  <a:pt x="668" y="7"/>
                </a:lnTo>
                <a:lnTo>
                  <a:pt x="676" y="8"/>
                </a:lnTo>
                <a:lnTo>
                  <a:pt x="676" y="8"/>
                </a:lnTo>
                <a:lnTo>
                  <a:pt x="683" y="8"/>
                </a:lnTo>
                <a:lnTo>
                  <a:pt x="683" y="8"/>
                </a:lnTo>
                <a:lnTo>
                  <a:pt x="691" y="9"/>
                </a:lnTo>
                <a:lnTo>
                  <a:pt x="691" y="9"/>
                </a:lnTo>
                <a:lnTo>
                  <a:pt x="699" y="10"/>
                </a:lnTo>
                <a:lnTo>
                  <a:pt x="699" y="10"/>
                </a:lnTo>
                <a:lnTo>
                  <a:pt x="706" y="10"/>
                </a:lnTo>
                <a:lnTo>
                  <a:pt x="706" y="10"/>
                </a:lnTo>
                <a:lnTo>
                  <a:pt x="714" y="12"/>
                </a:lnTo>
                <a:lnTo>
                  <a:pt x="714" y="12"/>
                </a:lnTo>
                <a:lnTo>
                  <a:pt x="721" y="13"/>
                </a:lnTo>
                <a:lnTo>
                  <a:pt x="721" y="13"/>
                </a:lnTo>
                <a:lnTo>
                  <a:pt x="729" y="14"/>
                </a:lnTo>
                <a:lnTo>
                  <a:pt x="729" y="14"/>
                </a:lnTo>
                <a:lnTo>
                  <a:pt x="737" y="16"/>
                </a:lnTo>
                <a:lnTo>
                  <a:pt x="737" y="16"/>
                </a:lnTo>
                <a:lnTo>
                  <a:pt x="744" y="17"/>
                </a:lnTo>
                <a:lnTo>
                  <a:pt x="744" y="17"/>
                </a:lnTo>
                <a:lnTo>
                  <a:pt x="752" y="19"/>
                </a:lnTo>
                <a:lnTo>
                  <a:pt x="752" y="19"/>
                </a:lnTo>
                <a:lnTo>
                  <a:pt x="759" y="21"/>
                </a:lnTo>
                <a:lnTo>
                  <a:pt x="759" y="21"/>
                </a:lnTo>
                <a:lnTo>
                  <a:pt x="767" y="23"/>
                </a:lnTo>
                <a:lnTo>
                  <a:pt x="767" y="23"/>
                </a:lnTo>
                <a:lnTo>
                  <a:pt x="775" y="25"/>
                </a:lnTo>
                <a:lnTo>
                  <a:pt x="775" y="25"/>
                </a:lnTo>
                <a:lnTo>
                  <a:pt x="782" y="27"/>
                </a:lnTo>
                <a:lnTo>
                  <a:pt x="782" y="27"/>
                </a:lnTo>
                <a:lnTo>
                  <a:pt x="790" y="30"/>
                </a:lnTo>
                <a:lnTo>
                  <a:pt x="790" y="30"/>
                </a:lnTo>
                <a:lnTo>
                  <a:pt x="797" y="33"/>
                </a:lnTo>
                <a:lnTo>
                  <a:pt x="797" y="33"/>
                </a:lnTo>
                <a:lnTo>
                  <a:pt x="805" y="36"/>
                </a:lnTo>
                <a:lnTo>
                  <a:pt x="805" y="36"/>
                </a:lnTo>
                <a:lnTo>
                  <a:pt x="813" y="40"/>
                </a:lnTo>
                <a:lnTo>
                  <a:pt x="813" y="40"/>
                </a:lnTo>
                <a:lnTo>
                  <a:pt x="820" y="43"/>
                </a:lnTo>
                <a:lnTo>
                  <a:pt x="820" y="43"/>
                </a:lnTo>
                <a:lnTo>
                  <a:pt x="828" y="48"/>
                </a:lnTo>
                <a:lnTo>
                  <a:pt x="828" y="48"/>
                </a:lnTo>
                <a:lnTo>
                  <a:pt x="835" y="52"/>
                </a:lnTo>
                <a:lnTo>
                  <a:pt x="835" y="52"/>
                </a:lnTo>
                <a:lnTo>
                  <a:pt x="843" y="56"/>
                </a:lnTo>
                <a:lnTo>
                  <a:pt x="843" y="56"/>
                </a:lnTo>
                <a:lnTo>
                  <a:pt x="850" y="62"/>
                </a:lnTo>
                <a:lnTo>
                  <a:pt x="850" y="62"/>
                </a:lnTo>
                <a:lnTo>
                  <a:pt x="858" y="68"/>
                </a:lnTo>
                <a:lnTo>
                  <a:pt x="858" y="68"/>
                </a:lnTo>
                <a:lnTo>
                  <a:pt x="866" y="73"/>
                </a:lnTo>
                <a:lnTo>
                  <a:pt x="866" y="73"/>
                </a:lnTo>
                <a:lnTo>
                  <a:pt x="873" y="80"/>
                </a:lnTo>
                <a:lnTo>
                  <a:pt x="873" y="80"/>
                </a:lnTo>
                <a:lnTo>
                  <a:pt x="881" y="87"/>
                </a:lnTo>
                <a:lnTo>
                  <a:pt x="881" y="87"/>
                </a:lnTo>
                <a:lnTo>
                  <a:pt x="888" y="94"/>
                </a:lnTo>
                <a:lnTo>
                  <a:pt x="888" y="94"/>
                </a:lnTo>
                <a:lnTo>
                  <a:pt x="896" y="103"/>
                </a:lnTo>
                <a:lnTo>
                  <a:pt x="896" y="103"/>
                </a:lnTo>
                <a:lnTo>
                  <a:pt x="904" y="112"/>
                </a:lnTo>
                <a:lnTo>
                  <a:pt x="904" y="112"/>
                </a:lnTo>
                <a:lnTo>
                  <a:pt x="911" y="121"/>
                </a:lnTo>
                <a:lnTo>
                  <a:pt x="911" y="121"/>
                </a:lnTo>
                <a:lnTo>
                  <a:pt x="919" y="132"/>
                </a:lnTo>
                <a:lnTo>
                  <a:pt x="919" y="132"/>
                </a:lnTo>
                <a:lnTo>
                  <a:pt x="926" y="142"/>
                </a:lnTo>
                <a:lnTo>
                  <a:pt x="926" y="142"/>
                </a:lnTo>
                <a:lnTo>
                  <a:pt x="934" y="154"/>
                </a:lnTo>
                <a:lnTo>
                  <a:pt x="934" y="154"/>
                </a:lnTo>
                <a:lnTo>
                  <a:pt x="942" y="166"/>
                </a:lnTo>
                <a:lnTo>
                  <a:pt x="942" y="166"/>
                </a:lnTo>
                <a:lnTo>
                  <a:pt x="950" y="179"/>
                </a:lnTo>
                <a:lnTo>
                  <a:pt x="950" y="179"/>
                </a:lnTo>
                <a:lnTo>
                  <a:pt x="957" y="194"/>
                </a:lnTo>
                <a:lnTo>
                  <a:pt x="957" y="194"/>
                </a:lnTo>
                <a:lnTo>
                  <a:pt x="964" y="208"/>
                </a:lnTo>
                <a:lnTo>
                  <a:pt x="964" y="208"/>
                </a:lnTo>
                <a:lnTo>
                  <a:pt x="972" y="224"/>
                </a:lnTo>
                <a:lnTo>
                  <a:pt x="972" y="224"/>
                </a:lnTo>
                <a:lnTo>
                  <a:pt x="980" y="240"/>
                </a:lnTo>
                <a:lnTo>
                  <a:pt x="980" y="240"/>
                </a:lnTo>
                <a:lnTo>
                  <a:pt x="988" y="257"/>
                </a:lnTo>
                <a:lnTo>
                  <a:pt x="988" y="257"/>
                </a:lnTo>
                <a:lnTo>
                  <a:pt x="995" y="276"/>
                </a:lnTo>
                <a:lnTo>
                  <a:pt x="995" y="276"/>
                </a:lnTo>
                <a:lnTo>
                  <a:pt x="1002" y="295"/>
                </a:lnTo>
                <a:lnTo>
                  <a:pt x="1002" y="295"/>
                </a:lnTo>
                <a:lnTo>
                  <a:pt x="1010" y="313"/>
                </a:lnTo>
                <a:lnTo>
                  <a:pt x="1010" y="313"/>
                </a:lnTo>
                <a:lnTo>
                  <a:pt x="1017" y="334"/>
                </a:lnTo>
                <a:lnTo>
                  <a:pt x="1017" y="334"/>
                </a:lnTo>
                <a:lnTo>
                  <a:pt x="1025" y="355"/>
                </a:lnTo>
                <a:lnTo>
                  <a:pt x="1025" y="355"/>
                </a:lnTo>
                <a:lnTo>
                  <a:pt x="1033" y="376"/>
                </a:lnTo>
                <a:lnTo>
                  <a:pt x="1033" y="376"/>
                </a:lnTo>
                <a:lnTo>
                  <a:pt x="1041" y="398"/>
                </a:lnTo>
                <a:lnTo>
                  <a:pt x="1041" y="398"/>
                </a:lnTo>
                <a:lnTo>
                  <a:pt x="1048" y="420"/>
                </a:lnTo>
                <a:lnTo>
                  <a:pt x="1048" y="420"/>
                </a:lnTo>
                <a:lnTo>
                  <a:pt x="1055" y="443"/>
                </a:lnTo>
                <a:lnTo>
                  <a:pt x="1055" y="443"/>
                </a:lnTo>
                <a:lnTo>
                  <a:pt x="1063" y="466"/>
                </a:lnTo>
                <a:lnTo>
                  <a:pt x="1063" y="466"/>
                </a:lnTo>
                <a:lnTo>
                  <a:pt x="1071" y="489"/>
                </a:lnTo>
                <a:lnTo>
                  <a:pt x="1071" y="489"/>
                </a:lnTo>
                <a:lnTo>
                  <a:pt x="1079" y="512"/>
                </a:lnTo>
                <a:lnTo>
                  <a:pt x="1079" y="512"/>
                </a:lnTo>
                <a:lnTo>
                  <a:pt x="1086" y="535"/>
                </a:lnTo>
                <a:lnTo>
                  <a:pt x="1086" y="535"/>
                </a:lnTo>
                <a:lnTo>
                  <a:pt x="1093" y="558"/>
                </a:lnTo>
                <a:lnTo>
                  <a:pt x="1093" y="558"/>
                </a:lnTo>
                <a:lnTo>
                  <a:pt x="1102" y="581"/>
                </a:lnTo>
                <a:lnTo>
                  <a:pt x="1102" y="581"/>
                </a:lnTo>
                <a:lnTo>
                  <a:pt x="1109" y="603"/>
                </a:lnTo>
                <a:lnTo>
                  <a:pt x="1109" y="603"/>
                </a:lnTo>
                <a:lnTo>
                  <a:pt x="1117" y="625"/>
                </a:lnTo>
                <a:lnTo>
                  <a:pt x="1117" y="625"/>
                </a:lnTo>
                <a:lnTo>
                  <a:pt x="1124" y="647"/>
                </a:lnTo>
                <a:lnTo>
                  <a:pt x="1124" y="647"/>
                </a:lnTo>
                <a:lnTo>
                  <a:pt x="1132" y="667"/>
                </a:lnTo>
              </a:path>
            </a:pathLst>
          </a:custGeom>
          <a:noFill/>
          <a:ln w="142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79" name="Line 266"/>
          <p:cNvSpPr>
            <a:spLocks noChangeShapeType="1"/>
          </p:cNvSpPr>
          <p:nvPr/>
        </p:nvSpPr>
        <p:spPr bwMode="auto">
          <a:xfrm>
            <a:off x="1325166" y="3240882"/>
            <a:ext cx="0" cy="22622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0" name="Line 267"/>
          <p:cNvSpPr>
            <a:spLocks noChangeShapeType="1"/>
          </p:cNvSpPr>
          <p:nvPr/>
        </p:nvSpPr>
        <p:spPr bwMode="auto">
          <a:xfrm>
            <a:off x="1325166" y="3263503"/>
            <a:ext cx="0" cy="23813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1" name="Line 268"/>
          <p:cNvSpPr>
            <a:spLocks noChangeShapeType="1"/>
          </p:cNvSpPr>
          <p:nvPr/>
        </p:nvSpPr>
        <p:spPr bwMode="auto">
          <a:xfrm>
            <a:off x="1301354" y="3240881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2" name="Line 269"/>
          <p:cNvSpPr>
            <a:spLocks noChangeShapeType="1"/>
          </p:cNvSpPr>
          <p:nvPr/>
        </p:nvSpPr>
        <p:spPr bwMode="auto">
          <a:xfrm>
            <a:off x="1301354" y="3287316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3" name="Line 270"/>
          <p:cNvSpPr>
            <a:spLocks noChangeShapeType="1"/>
          </p:cNvSpPr>
          <p:nvPr/>
        </p:nvSpPr>
        <p:spPr bwMode="auto">
          <a:xfrm>
            <a:off x="1568054" y="3138488"/>
            <a:ext cx="0" cy="54769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4" name="Line 271"/>
          <p:cNvSpPr>
            <a:spLocks noChangeShapeType="1"/>
          </p:cNvSpPr>
          <p:nvPr/>
        </p:nvSpPr>
        <p:spPr bwMode="auto">
          <a:xfrm>
            <a:off x="1568054" y="3193257"/>
            <a:ext cx="0" cy="5596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5" name="Line 272"/>
          <p:cNvSpPr>
            <a:spLocks noChangeShapeType="1"/>
          </p:cNvSpPr>
          <p:nvPr/>
        </p:nvSpPr>
        <p:spPr bwMode="auto">
          <a:xfrm>
            <a:off x="1545432" y="3138488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6" name="Line 273"/>
          <p:cNvSpPr>
            <a:spLocks noChangeShapeType="1"/>
          </p:cNvSpPr>
          <p:nvPr/>
        </p:nvSpPr>
        <p:spPr bwMode="auto">
          <a:xfrm>
            <a:off x="1545432" y="3249216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7" name="Line 274"/>
          <p:cNvSpPr>
            <a:spLocks noChangeShapeType="1"/>
          </p:cNvSpPr>
          <p:nvPr/>
        </p:nvSpPr>
        <p:spPr bwMode="auto">
          <a:xfrm>
            <a:off x="2019300" y="3208735"/>
            <a:ext cx="0" cy="23813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8" name="Line 275"/>
          <p:cNvSpPr>
            <a:spLocks noChangeShapeType="1"/>
          </p:cNvSpPr>
          <p:nvPr/>
        </p:nvSpPr>
        <p:spPr bwMode="auto">
          <a:xfrm>
            <a:off x="2019300" y="3232547"/>
            <a:ext cx="0" cy="23813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89" name="Line 276"/>
          <p:cNvSpPr>
            <a:spLocks noChangeShapeType="1"/>
          </p:cNvSpPr>
          <p:nvPr/>
        </p:nvSpPr>
        <p:spPr bwMode="auto">
          <a:xfrm>
            <a:off x="1996679" y="3208735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0" name="Line 277"/>
          <p:cNvSpPr>
            <a:spLocks noChangeShapeType="1"/>
          </p:cNvSpPr>
          <p:nvPr/>
        </p:nvSpPr>
        <p:spPr bwMode="auto">
          <a:xfrm>
            <a:off x="1996679" y="3256360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1" name="Line 278"/>
          <p:cNvSpPr>
            <a:spLocks noChangeShapeType="1"/>
          </p:cNvSpPr>
          <p:nvPr/>
        </p:nvSpPr>
        <p:spPr bwMode="auto">
          <a:xfrm>
            <a:off x="2366963" y="3333751"/>
            <a:ext cx="0" cy="41672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2" name="Line 279"/>
          <p:cNvSpPr>
            <a:spLocks noChangeShapeType="1"/>
          </p:cNvSpPr>
          <p:nvPr/>
        </p:nvSpPr>
        <p:spPr bwMode="auto">
          <a:xfrm>
            <a:off x="2366963" y="3375423"/>
            <a:ext cx="0" cy="40481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3" name="Line 280"/>
          <p:cNvSpPr>
            <a:spLocks noChangeShapeType="1"/>
          </p:cNvSpPr>
          <p:nvPr/>
        </p:nvSpPr>
        <p:spPr bwMode="auto">
          <a:xfrm>
            <a:off x="2344341" y="3333750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4" name="Line 281"/>
          <p:cNvSpPr>
            <a:spLocks noChangeShapeType="1"/>
          </p:cNvSpPr>
          <p:nvPr/>
        </p:nvSpPr>
        <p:spPr bwMode="auto">
          <a:xfrm>
            <a:off x="2344341" y="3415904"/>
            <a:ext cx="4643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5" name="Line 282"/>
          <p:cNvSpPr>
            <a:spLocks noChangeShapeType="1"/>
          </p:cNvSpPr>
          <p:nvPr/>
        </p:nvSpPr>
        <p:spPr bwMode="auto">
          <a:xfrm>
            <a:off x="2672954" y="3930254"/>
            <a:ext cx="0" cy="32147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6" name="Line 283"/>
          <p:cNvSpPr>
            <a:spLocks noChangeShapeType="1"/>
          </p:cNvSpPr>
          <p:nvPr/>
        </p:nvSpPr>
        <p:spPr bwMode="auto">
          <a:xfrm>
            <a:off x="2672954" y="3962401"/>
            <a:ext cx="0" cy="32147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7" name="Line 284"/>
          <p:cNvSpPr>
            <a:spLocks noChangeShapeType="1"/>
          </p:cNvSpPr>
          <p:nvPr/>
        </p:nvSpPr>
        <p:spPr bwMode="auto">
          <a:xfrm>
            <a:off x="2649141" y="3930254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8" name="Line 285"/>
          <p:cNvSpPr>
            <a:spLocks noChangeShapeType="1"/>
          </p:cNvSpPr>
          <p:nvPr/>
        </p:nvSpPr>
        <p:spPr bwMode="auto">
          <a:xfrm>
            <a:off x="2649141" y="3994547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299" name="Oval 286"/>
          <p:cNvSpPr>
            <a:spLocks noChangeArrowheads="1"/>
          </p:cNvSpPr>
          <p:nvPr/>
        </p:nvSpPr>
        <p:spPr bwMode="auto">
          <a:xfrm>
            <a:off x="1304926" y="3243263"/>
            <a:ext cx="40481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0" name="Oval 287"/>
          <p:cNvSpPr>
            <a:spLocks noChangeArrowheads="1"/>
          </p:cNvSpPr>
          <p:nvPr/>
        </p:nvSpPr>
        <p:spPr bwMode="auto">
          <a:xfrm>
            <a:off x="1303735" y="3243263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1" name="Oval 288"/>
          <p:cNvSpPr>
            <a:spLocks noChangeArrowheads="1"/>
          </p:cNvSpPr>
          <p:nvPr/>
        </p:nvSpPr>
        <p:spPr bwMode="auto">
          <a:xfrm>
            <a:off x="1547813" y="3173017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2" name="Oval 289"/>
          <p:cNvSpPr>
            <a:spLocks noChangeArrowheads="1"/>
          </p:cNvSpPr>
          <p:nvPr/>
        </p:nvSpPr>
        <p:spPr bwMode="auto">
          <a:xfrm>
            <a:off x="1547813" y="3173017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3" name="Oval 290"/>
          <p:cNvSpPr>
            <a:spLocks noChangeArrowheads="1"/>
          </p:cNvSpPr>
          <p:nvPr/>
        </p:nvSpPr>
        <p:spPr bwMode="auto">
          <a:xfrm>
            <a:off x="1651398" y="3086100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4" name="Oval 291"/>
          <p:cNvSpPr>
            <a:spLocks noChangeArrowheads="1"/>
          </p:cNvSpPr>
          <p:nvPr/>
        </p:nvSpPr>
        <p:spPr bwMode="auto">
          <a:xfrm>
            <a:off x="1651398" y="3086100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5" name="Oval 292"/>
          <p:cNvSpPr>
            <a:spLocks noChangeArrowheads="1"/>
          </p:cNvSpPr>
          <p:nvPr/>
        </p:nvSpPr>
        <p:spPr bwMode="auto">
          <a:xfrm>
            <a:off x="1999060" y="3211116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6" name="Oval 293"/>
          <p:cNvSpPr>
            <a:spLocks noChangeArrowheads="1"/>
          </p:cNvSpPr>
          <p:nvPr/>
        </p:nvSpPr>
        <p:spPr bwMode="auto">
          <a:xfrm>
            <a:off x="1999060" y="3211116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7" name="Oval 294"/>
          <p:cNvSpPr>
            <a:spLocks noChangeArrowheads="1"/>
          </p:cNvSpPr>
          <p:nvPr/>
        </p:nvSpPr>
        <p:spPr bwMode="auto">
          <a:xfrm>
            <a:off x="2346723" y="3353992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8" name="Oval 295"/>
          <p:cNvSpPr>
            <a:spLocks noChangeArrowheads="1"/>
          </p:cNvSpPr>
          <p:nvPr/>
        </p:nvSpPr>
        <p:spPr bwMode="auto">
          <a:xfrm>
            <a:off x="2346723" y="3353992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09" name="Oval 296"/>
          <p:cNvSpPr>
            <a:spLocks noChangeArrowheads="1"/>
          </p:cNvSpPr>
          <p:nvPr/>
        </p:nvSpPr>
        <p:spPr bwMode="auto">
          <a:xfrm>
            <a:off x="2484835" y="3412331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0" name="Oval 297"/>
          <p:cNvSpPr>
            <a:spLocks noChangeArrowheads="1"/>
          </p:cNvSpPr>
          <p:nvPr/>
        </p:nvSpPr>
        <p:spPr bwMode="auto">
          <a:xfrm>
            <a:off x="2484835" y="3412332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1" name="Oval 298"/>
          <p:cNvSpPr>
            <a:spLocks noChangeArrowheads="1"/>
          </p:cNvSpPr>
          <p:nvPr/>
        </p:nvSpPr>
        <p:spPr bwMode="auto">
          <a:xfrm>
            <a:off x="2589610" y="3881438"/>
            <a:ext cx="41672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2" name="Oval 299"/>
          <p:cNvSpPr>
            <a:spLocks noChangeArrowheads="1"/>
          </p:cNvSpPr>
          <p:nvPr/>
        </p:nvSpPr>
        <p:spPr bwMode="auto">
          <a:xfrm>
            <a:off x="2589610" y="3881438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3" name="Oval 300"/>
          <p:cNvSpPr>
            <a:spLocks noChangeArrowheads="1"/>
          </p:cNvSpPr>
          <p:nvPr/>
        </p:nvSpPr>
        <p:spPr bwMode="auto">
          <a:xfrm>
            <a:off x="2652713" y="3940969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4" name="Oval 301"/>
          <p:cNvSpPr>
            <a:spLocks noChangeArrowheads="1"/>
          </p:cNvSpPr>
          <p:nvPr/>
        </p:nvSpPr>
        <p:spPr bwMode="auto">
          <a:xfrm>
            <a:off x="2652713" y="3940969"/>
            <a:ext cx="41672" cy="41672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1350"/>
          </a:p>
        </p:txBody>
      </p:sp>
      <p:sp>
        <p:nvSpPr>
          <p:cNvPr id="315" name="Rectangle 302"/>
          <p:cNvSpPr>
            <a:spLocks noChangeArrowheads="1"/>
          </p:cNvSpPr>
          <p:nvPr/>
        </p:nvSpPr>
        <p:spPr bwMode="auto">
          <a:xfrm>
            <a:off x="1610917" y="4204098"/>
            <a:ext cx="639599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</a:rPr>
              <a:t>Log Molar conc</a:t>
            </a:r>
            <a:endParaRPr lang="en-US" altLang="en-US" sz="1350"/>
          </a:p>
        </p:txBody>
      </p:sp>
      <p:sp>
        <p:nvSpPr>
          <p:cNvPr id="341" name="Rectangle 340"/>
          <p:cNvSpPr/>
          <p:nvPr/>
        </p:nvSpPr>
        <p:spPr>
          <a:xfrm rot="16200000">
            <a:off x="9502" y="3491814"/>
            <a:ext cx="148149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750" b="1" dirty="0"/>
              <a:t>RFU (Ex 340 nm/Em 460 nm)</a:t>
            </a:r>
            <a:endParaRPr lang="en-US" sz="750" b="1" dirty="0"/>
          </a:p>
        </p:txBody>
      </p:sp>
      <p:sp>
        <p:nvSpPr>
          <p:cNvPr id="348" name="Rectangle 332"/>
          <p:cNvSpPr>
            <a:spLocks noChangeArrowheads="1"/>
          </p:cNvSpPr>
          <p:nvPr/>
        </p:nvSpPr>
        <p:spPr bwMode="auto">
          <a:xfrm>
            <a:off x="3250406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8.5</a:t>
            </a:r>
            <a:endParaRPr lang="en-US" altLang="en-US" sz="675">
              <a:latin typeface="+mn-lt"/>
            </a:endParaRPr>
          </a:p>
        </p:txBody>
      </p:sp>
      <p:sp>
        <p:nvSpPr>
          <p:cNvPr id="349" name="Rectangle 333"/>
          <p:cNvSpPr>
            <a:spLocks noChangeArrowheads="1"/>
          </p:cNvSpPr>
          <p:nvPr/>
        </p:nvSpPr>
        <p:spPr bwMode="auto">
          <a:xfrm>
            <a:off x="3427810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8.0</a:t>
            </a:r>
            <a:endParaRPr lang="en-US" altLang="en-US" sz="675">
              <a:latin typeface="+mn-lt"/>
            </a:endParaRPr>
          </a:p>
        </p:txBody>
      </p:sp>
      <p:sp>
        <p:nvSpPr>
          <p:cNvPr id="350" name="Rectangle 334"/>
          <p:cNvSpPr>
            <a:spLocks noChangeArrowheads="1"/>
          </p:cNvSpPr>
          <p:nvPr/>
        </p:nvSpPr>
        <p:spPr bwMode="auto">
          <a:xfrm>
            <a:off x="3605213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7.5</a:t>
            </a:r>
            <a:endParaRPr lang="en-US" altLang="en-US" sz="675">
              <a:latin typeface="+mn-lt"/>
            </a:endParaRPr>
          </a:p>
        </p:txBody>
      </p:sp>
      <p:sp>
        <p:nvSpPr>
          <p:cNvPr id="351" name="Rectangle 335"/>
          <p:cNvSpPr>
            <a:spLocks noChangeArrowheads="1"/>
          </p:cNvSpPr>
          <p:nvPr/>
        </p:nvSpPr>
        <p:spPr bwMode="auto">
          <a:xfrm>
            <a:off x="3783806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7.0</a:t>
            </a:r>
            <a:endParaRPr lang="en-US" altLang="en-US" sz="675">
              <a:latin typeface="+mn-lt"/>
            </a:endParaRPr>
          </a:p>
        </p:txBody>
      </p:sp>
      <p:sp>
        <p:nvSpPr>
          <p:cNvPr id="352" name="Rectangle 336"/>
          <p:cNvSpPr>
            <a:spLocks noChangeArrowheads="1"/>
          </p:cNvSpPr>
          <p:nvPr/>
        </p:nvSpPr>
        <p:spPr bwMode="auto">
          <a:xfrm>
            <a:off x="3961210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6.5</a:t>
            </a:r>
            <a:endParaRPr lang="en-US" altLang="en-US" sz="675">
              <a:latin typeface="+mn-lt"/>
            </a:endParaRPr>
          </a:p>
        </p:txBody>
      </p:sp>
      <p:sp>
        <p:nvSpPr>
          <p:cNvPr id="353" name="Rectangle 337"/>
          <p:cNvSpPr>
            <a:spLocks noChangeArrowheads="1"/>
          </p:cNvSpPr>
          <p:nvPr/>
        </p:nvSpPr>
        <p:spPr bwMode="auto">
          <a:xfrm>
            <a:off x="4138613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6.0</a:t>
            </a:r>
            <a:endParaRPr lang="en-US" altLang="en-US" sz="675">
              <a:latin typeface="+mn-lt"/>
            </a:endParaRPr>
          </a:p>
        </p:txBody>
      </p:sp>
      <p:sp>
        <p:nvSpPr>
          <p:cNvPr id="354" name="Rectangle 338"/>
          <p:cNvSpPr>
            <a:spLocks noChangeArrowheads="1"/>
          </p:cNvSpPr>
          <p:nvPr/>
        </p:nvSpPr>
        <p:spPr bwMode="auto">
          <a:xfrm>
            <a:off x="4317206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5.5</a:t>
            </a:r>
            <a:endParaRPr lang="en-US" altLang="en-US" sz="675">
              <a:latin typeface="+mn-lt"/>
            </a:endParaRPr>
          </a:p>
        </p:txBody>
      </p:sp>
      <p:sp>
        <p:nvSpPr>
          <p:cNvPr id="355" name="Rectangle 339"/>
          <p:cNvSpPr>
            <a:spLocks noChangeArrowheads="1"/>
          </p:cNvSpPr>
          <p:nvPr/>
        </p:nvSpPr>
        <p:spPr bwMode="auto">
          <a:xfrm>
            <a:off x="4494610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5.0</a:t>
            </a:r>
            <a:endParaRPr lang="en-US" altLang="en-US" sz="675">
              <a:latin typeface="+mn-lt"/>
            </a:endParaRPr>
          </a:p>
        </p:txBody>
      </p:sp>
      <p:sp>
        <p:nvSpPr>
          <p:cNvPr id="356" name="Rectangle 340"/>
          <p:cNvSpPr>
            <a:spLocks noChangeArrowheads="1"/>
          </p:cNvSpPr>
          <p:nvPr/>
        </p:nvSpPr>
        <p:spPr bwMode="auto">
          <a:xfrm>
            <a:off x="4672013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4.5</a:t>
            </a:r>
            <a:endParaRPr lang="en-US" altLang="en-US" sz="675">
              <a:latin typeface="+mn-lt"/>
            </a:endParaRPr>
          </a:p>
        </p:txBody>
      </p:sp>
      <p:sp>
        <p:nvSpPr>
          <p:cNvPr id="357" name="Rectangle 341"/>
          <p:cNvSpPr>
            <a:spLocks noChangeArrowheads="1"/>
          </p:cNvSpPr>
          <p:nvPr/>
        </p:nvSpPr>
        <p:spPr bwMode="auto">
          <a:xfrm>
            <a:off x="4850606" y="4113610"/>
            <a:ext cx="14908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-4.0</a:t>
            </a:r>
            <a:endParaRPr lang="en-US" altLang="en-US" sz="675">
              <a:latin typeface="+mn-lt"/>
            </a:endParaRPr>
          </a:p>
        </p:txBody>
      </p:sp>
      <p:sp>
        <p:nvSpPr>
          <p:cNvPr id="358" name="Freeform 342"/>
          <p:cNvSpPr>
            <a:spLocks noEditPoints="1"/>
          </p:cNvSpPr>
          <p:nvPr/>
        </p:nvSpPr>
        <p:spPr bwMode="auto">
          <a:xfrm>
            <a:off x="3313510" y="4068367"/>
            <a:ext cx="1610915" cy="32147"/>
          </a:xfrm>
          <a:custGeom>
            <a:avLst/>
            <a:gdLst>
              <a:gd name="T0" fmla="*/ 0 w 1353"/>
              <a:gd name="T1" fmla="*/ 0 h 27"/>
              <a:gd name="T2" fmla="*/ 1353 w 1353"/>
              <a:gd name="T3" fmla="*/ 0 h 27"/>
              <a:gd name="T4" fmla="*/ 4 w 1353"/>
              <a:gd name="T5" fmla="*/ 0 h 27"/>
              <a:gd name="T6" fmla="*/ 4 w 1353"/>
              <a:gd name="T7" fmla="*/ 27 h 27"/>
              <a:gd name="T8" fmla="*/ 154 w 1353"/>
              <a:gd name="T9" fmla="*/ 0 h 27"/>
              <a:gd name="T10" fmla="*/ 154 w 1353"/>
              <a:gd name="T11" fmla="*/ 27 h 27"/>
              <a:gd name="T12" fmla="*/ 303 w 1353"/>
              <a:gd name="T13" fmla="*/ 0 h 27"/>
              <a:gd name="T14" fmla="*/ 303 w 1353"/>
              <a:gd name="T15" fmla="*/ 27 h 27"/>
              <a:gd name="T16" fmla="*/ 452 w 1353"/>
              <a:gd name="T17" fmla="*/ 0 h 27"/>
              <a:gd name="T18" fmla="*/ 452 w 1353"/>
              <a:gd name="T19" fmla="*/ 27 h 27"/>
              <a:gd name="T20" fmla="*/ 602 w 1353"/>
              <a:gd name="T21" fmla="*/ 0 h 27"/>
              <a:gd name="T22" fmla="*/ 602 w 1353"/>
              <a:gd name="T23" fmla="*/ 27 h 27"/>
              <a:gd name="T24" fmla="*/ 751 w 1353"/>
              <a:gd name="T25" fmla="*/ 0 h 27"/>
              <a:gd name="T26" fmla="*/ 751 w 1353"/>
              <a:gd name="T27" fmla="*/ 27 h 27"/>
              <a:gd name="T28" fmla="*/ 900 w 1353"/>
              <a:gd name="T29" fmla="*/ 0 h 27"/>
              <a:gd name="T30" fmla="*/ 900 w 1353"/>
              <a:gd name="T31" fmla="*/ 27 h 27"/>
              <a:gd name="T32" fmla="*/ 1050 w 1353"/>
              <a:gd name="T33" fmla="*/ 0 h 27"/>
              <a:gd name="T34" fmla="*/ 1050 w 1353"/>
              <a:gd name="T35" fmla="*/ 27 h 27"/>
              <a:gd name="T36" fmla="*/ 1199 w 1353"/>
              <a:gd name="T37" fmla="*/ 0 h 27"/>
              <a:gd name="T38" fmla="*/ 1199 w 1353"/>
              <a:gd name="T39" fmla="*/ 27 h 27"/>
              <a:gd name="T40" fmla="*/ 1348 w 1353"/>
              <a:gd name="T41" fmla="*/ 0 h 27"/>
              <a:gd name="T42" fmla="*/ 1348 w 1353"/>
              <a:gd name="T43" fmla="*/ 27 h 2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1353" h="27">
                <a:moveTo>
                  <a:pt x="0" y="0"/>
                </a:moveTo>
                <a:lnTo>
                  <a:pt x="1353" y="0"/>
                </a:lnTo>
                <a:moveTo>
                  <a:pt x="4" y="0"/>
                </a:moveTo>
                <a:lnTo>
                  <a:pt x="4" y="27"/>
                </a:lnTo>
                <a:moveTo>
                  <a:pt x="154" y="0"/>
                </a:moveTo>
                <a:lnTo>
                  <a:pt x="154" y="27"/>
                </a:lnTo>
                <a:moveTo>
                  <a:pt x="303" y="0"/>
                </a:moveTo>
                <a:lnTo>
                  <a:pt x="303" y="27"/>
                </a:lnTo>
                <a:moveTo>
                  <a:pt x="452" y="0"/>
                </a:moveTo>
                <a:lnTo>
                  <a:pt x="452" y="27"/>
                </a:lnTo>
                <a:moveTo>
                  <a:pt x="602" y="0"/>
                </a:moveTo>
                <a:lnTo>
                  <a:pt x="602" y="27"/>
                </a:lnTo>
                <a:moveTo>
                  <a:pt x="751" y="0"/>
                </a:moveTo>
                <a:lnTo>
                  <a:pt x="751" y="27"/>
                </a:lnTo>
                <a:moveTo>
                  <a:pt x="900" y="0"/>
                </a:moveTo>
                <a:lnTo>
                  <a:pt x="900" y="27"/>
                </a:lnTo>
                <a:moveTo>
                  <a:pt x="1050" y="0"/>
                </a:moveTo>
                <a:lnTo>
                  <a:pt x="1050" y="27"/>
                </a:lnTo>
                <a:moveTo>
                  <a:pt x="1199" y="0"/>
                </a:moveTo>
                <a:lnTo>
                  <a:pt x="1199" y="27"/>
                </a:lnTo>
                <a:moveTo>
                  <a:pt x="1348" y="0"/>
                </a:moveTo>
                <a:lnTo>
                  <a:pt x="1348" y="27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59" name="Rectangle 343"/>
          <p:cNvSpPr>
            <a:spLocks noChangeArrowheads="1"/>
          </p:cNvSpPr>
          <p:nvPr/>
        </p:nvSpPr>
        <p:spPr bwMode="auto">
          <a:xfrm>
            <a:off x="3050381" y="4019551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20000</a:t>
            </a:r>
            <a:endParaRPr lang="en-US" altLang="en-US" sz="675">
              <a:latin typeface="+mn-lt"/>
            </a:endParaRPr>
          </a:p>
        </p:txBody>
      </p:sp>
      <p:sp>
        <p:nvSpPr>
          <p:cNvPr id="360" name="Rectangle 344"/>
          <p:cNvSpPr>
            <a:spLocks noChangeArrowheads="1"/>
          </p:cNvSpPr>
          <p:nvPr/>
        </p:nvSpPr>
        <p:spPr bwMode="auto">
          <a:xfrm>
            <a:off x="3050381" y="3663554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40000</a:t>
            </a:r>
            <a:endParaRPr lang="en-US" altLang="en-US" sz="675">
              <a:latin typeface="+mn-lt"/>
            </a:endParaRPr>
          </a:p>
        </p:txBody>
      </p:sp>
      <p:sp>
        <p:nvSpPr>
          <p:cNvPr id="361" name="Rectangle 345"/>
          <p:cNvSpPr>
            <a:spLocks noChangeArrowheads="1"/>
          </p:cNvSpPr>
          <p:nvPr/>
        </p:nvSpPr>
        <p:spPr bwMode="auto">
          <a:xfrm>
            <a:off x="3050381" y="3307557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60000</a:t>
            </a:r>
            <a:endParaRPr lang="en-US" altLang="en-US" sz="675">
              <a:latin typeface="+mn-lt"/>
            </a:endParaRPr>
          </a:p>
        </p:txBody>
      </p:sp>
      <p:sp>
        <p:nvSpPr>
          <p:cNvPr id="362" name="Rectangle 346"/>
          <p:cNvSpPr>
            <a:spLocks noChangeArrowheads="1"/>
          </p:cNvSpPr>
          <p:nvPr/>
        </p:nvSpPr>
        <p:spPr bwMode="auto">
          <a:xfrm>
            <a:off x="3050381" y="2951560"/>
            <a:ext cx="240450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80000</a:t>
            </a:r>
            <a:endParaRPr lang="en-US" altLang="en-US" sz="675">
              <a:latin typeface="+mn-lt"/>
            </a:endParaRPr>
          </a:p>
        </p:txBody>
      </p:sp>
      <p:sp>
        <p:nvSpPr>
          <p:cNvPr id="363" name="Freeform 347"/>
          <p:cNvSpPr>
            <a:spLocks noEditPoints="1"/>
          </p:cNvSpPr>
          <p:nvPr/>
        </p:nvSpPr>
        <p:spPr bwMode="auto">
          <a:xfrm>
            <a:off x="3286125" y="2994423"/>
            <a:ext cx="32147" cy="1078706"/>
          </a:xfrm>
          <a:custGeom>
            <a:avLst/>
            <a:gdLst>
              <a:gd name="T0" fmla="*/ 27 w 27"/>
              <a:gd name="T1" fmla="*/ 906 h 906"/>
              <a:gd name="T2" fmla="*/ 27 w 27"/>
              <a:gd name="T3" fmla="*/ 0 h 906"/>
              <a:gd name="T4" fmla="*/ 27 w 27"/>
              <a:gd name="T5" fmla="*/ 902 h 906"/>
              <a:gd name="T6" fmla="*/ 0 w 27"/>
              <a:gd name="T7" fmla="*/ 902 h 906"/>
              <a:gd name="T8" fmla="*/ 27 w 27"/>
              <a:gd name="T9" fmla="*/ 603 h 906"/>
              <a:gd name="T10" fmla="*/ 0 w 27"/>
              <a:gd name="T11" fmla="*/ 603 h 906"/>
              <a:gd name="T12" fmla="*/ 27 w 27"/>
              <a:gd name="T13" fmla="*/ 304 h 906"/>
              <a:gd name="T14" fmla="*/ 0 w 27"/>
              <a:gd name="T15" fmla="*/ 304 h 906"/>
              <a:gd name="T16" fmla="*/ 27 w 27"/>
              <a:gd name="T17" fmla="*/ 4 h 906"/>
              <a:gd name="T18" fmla="*/ 0 w 27"/>
              <a:gd name="T19" fmla="*/ 4 h 9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7" h="906">
                <a:moveTo>
                  <a:pt x="27" y="906"/>
                </a:moveTo>
                <a:lnTo>
                  <a:pt x="27" y="0"/>
                </a:lnTo>
                <a:moveTo>
                  <a:pt x="27" y="902"/>
                </a:moveTo>
                <a:lnTo>
                  <a:pt x="0" y="902"/>
                </a:lnTo>
                <a:moveTo>
                  <a:pt x="27" y="603"/>
                </a:moveTo>
                <a:lnTo>
                  <a:pt x="0" y="603"/>
                </a:lnTo>
                <a:moveTo>
                  <a:pt x="27" y="304"/>
                </a:moveTo>
                <a:lnTo>
                  <a:pt x="0" y="304"/>
                </a:lnTo>
                <a:moveTo>
                  <a:pt x="27" y="4"/>
                </a:moveTo>
                <a:lnTo>
                  <a:pt x="0" y="4"/>
                </a:lnTo>
              </a:path>
            </a:pathLst>
          </a:custGeom>
          <a:noFill/>
          <a:ln w="142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4" name="Freeform 348"/>
          <p:cNvSpPr>
            <a:spLocks/>
          </p:cNvSpPr>
          <p:nvPr/>
        </p:nvSpPr>
        <p:spPr bwMode="auto">
          <a:xfrm>
            <a:off x="3496866" y="3334941"/>
            <a:ext cx="1378744" cy="521494"/>
          </a:xfrm>
          <a:custGeom>
            <a:avLst/>
            <a:gdLst>
              <a:gd name="T0" fmla="*/ 7 w 1158"/>
              <a:gd name="T1" fmla="*/ 0 h 438"/>
              <a:gd name="T2" fmla="*/ 30 w 1158"/>
              <a:gd name="T3" fmla="*/ 0 h 438"/>
              <a:gd name="T4" fmla="*/ 46 w 1158"/>
              <a:gd name="T5" fmla="*/ 0 h 438"/>
              <a:gd name="T6" fmla="*/ 69 w 1158"/>
              <a:gd name="T7" fmla="*/ 0 h 438"/>
              <a:gd name="T8" fmla="*/ 85 w 1158"/>
              <a:gd name="T9" fmla="*/ 0 h 438"/>
              <a:gd name="T10" fmla="*/ 108 w 1158"/>
              <a:gd name="T11" fmla="*/ 0 h 438"/>
              <a:gd name="T12" fmla="*/ 123 w 1158"/>
              <a:gd name="T13" fmla="*/ 0 h 438"/>
              <a:gd name="T14" fmla="*/ 147 w 1158"/>
              <a:gd name="T15" fmla="*/ 0 h 438"/>
              <a:gd name="T16" fmla="*/ 162 w 1158"/>
              <a:gd name="T17" fmla="*/ 0 h 438"/>
              <a:gd name="T18" fmla="*/ 185 w 1158"/>
              <a:gd name="T19" fmla="*/ 0 h 438"/>
              <a:gd name="T20" fmla="*/ 201 w 1158"/>
              <a:gd name="T21" fmla="*/ 0 h 438"/>
              <a:gd name="T22" fmla="*/ 225 w 1158"/>
              <a:gd name="T23" fmla="*/ 0 h 438"/>
              <a:gd name="T24" fmla="*/ 240 w 1158"/>
              <a:gd name="T25" fmla="*/ 0 h 438"/>
              <a:gd name="T26" fmla="*/ 264 w 1158"/>
              <a:gd name="T27" fmla="*/ 0 h 438"/>
              <a:gd name="T28" fmla="*/ 279 w 1158"/>
              <a:gd name="T29" fmla="*/ 0 h 438"/>
              <a:gd name="T30" fmla="*/ 303 w 1158"/>
              <a:gd name="T31" fmla="*/ 0 h 438"/>
              <a:gd name="T32" fmla="*/ 318 w 1158"/>
              <a:gd name="T33" fmla="*/ 0 h 438"/>
              <a:gd name="T34" fmla="*/ 341 w 1158"/>
              <a:gd name="T35" fmla="*/ 0 h 438"/>
              <a:gd name="T36" fmla="*/ 357 w 1158"/>
              <a:gd name="T37" fmla="*/ 0 h 438"/>
              <a:gd name="T38" fmla="*/ 380 w 1158"/>
              <a:gd name="T39" fmla="*/ 0 h 438"/>
              <a:gd name="T40" fmla="*/ 396 w 1158"/>
              <a:gd name="T41" fmla="*/ 0 h 438"/>
              <a:gd name="T42" fmla="*/ 419 w 1158"/>
              <a:gd name="T43" fmla="*/ 0 h 438"/>
              <a:gd name="T44" fmla="*/ 435 w 1158"/>
              <a:gd name="T45" fmla="*/ 0 h 438"/>
              <a:gd name="T46" fmla="*/ 458 w 1158"/>
              <a:gd name="T47" fmla="*/ 0 h 438"/>
              <a:gd name="T48" fmla="*/ 474 w 1158"/>
              <a:gd name="T49" fmla="*/ 0 h 438"/>
              <a:gd name="T50" fmla="*/ 497 w 1158"/>
              <a:gd name="T51" fmla="*/ 0 h 438"/>
              <a:gd name="T52" fmla="*/ 513 w 1158"/>
              <a:gd name="T53" fmla="*/ 0 h 438"/>
              <a:gd name="T54" fmla="*/ 536 w 1158"/>
              <a:gd name="T55" fmla="*/ 0 h 438"/>
              <a:gd name="T56" fmla="*/ 551 w 1158"/>
              <a:gd name="T57" fmla="*/ 0 h 438"/>
              <a:gd name="T58" fmla="*/ 574 w 1158"/>
              <a:gd name="T59" fmla="*/ 0 h 438"/>
              <a:gd name="T60" fmla="*/ 590 w 1158"/>
              <a:gd name="T61" fmla="*/ 0 h 438"/>
              <a:gd name="T62" fmla="*/ 613 w 1158"/>
              <a:gd name="T63" fmla="*/ 0 h 438"/>
              <a:gd name="T64" fmla="*/ 629 w 1158"/>
              <a:gd name="T65" fmla="*/ 0 h 438"/>
              <a:gd name="T66" fmla="*/ 652 w 1158"/>
              <a:gd name="T67" fmla="*/ 0 h 438"/>
              <a:gd name="T68" fmla="*/ 668 w 1158"/>
              <a:gd name="T69" fmla="*/ 1 h 438"/>
              <a:gd name="T70" fmla="*/ 692 w 1158"/>
              <a:gd name="T71" fmla="*/ 1 h 438"/>
              <a:gd name="T72" fmla="*/ 707 w 1158"/>
              <a:gd name="T73" fmla="*/ 1 h 438"/>
              <a:gd name="T74" fmla="*/ 730 w 1158"/>
              <a:gd name="T75" fmla="*/ 1 h 438"/>
              <a:gd name="T76" fmla="*/ 745 w 1158"/>
              <a:gd name="T77" fmla="*/ 2 h 438"/>
              <a:gd name="T78" fmla="*/ 769 w 1158"/>
              <a:gd name="T79" fmla="*/ 2 h 438"/>
              <a:gd name="T80" fmla="*/ 785 w 1158"/>
              <a:gd name="T81" fmla="*/ 2 h 438"/>
              <a:gd name="T82" fmla="*/ 808 w 1158"/>
              <a:gd name="T83" fmla="*/ 3 h 438"/>
              <a:gd name="T84" fmla="*/ 824 w 1158"/>
              <a:gd name="T85" fmla="*/ 4 h 438"/>
              <a:gd name="T86" fmla="*/ 847 w 1158"/>
              <a:gd name="T87" fmla="*/ 6 h 438"/>
              <a:gd name="T88" fmla="*/ 863 w 1158"/>
              <a:gd name="T89" fmla="*/ 8 h 438"/>
              <a:gd name="T90" fmla="*/ 886 w 1158"/>
              <a:gd name="T91" fmla="*/ 11 h 438"/>
              <a:gd name="T92" fmla="*/ 901 w 1158"/>
              <a:gd name="T93" fmla="*/ 14 h 438"/>
              <a:gd name="T94" fmla="*/ 925 w 1158"/>
              <a:gd name="T95" fmla="*/ 20 h 438"/>
              <a:gd name="T96" fmla="*/ 941 w 1158"/>
              <a:gd name="T97" fmla="*/ 26 h 438"/>
              <a:gd name="T98" fmla="*/ 964 w 1158"/>
              <a:gd name="T99" fmla="*/ 36 h 438"/>
              <a:gd name="T100" fmla="*/ 979 w 1158"/>
              <a:gd name="T101" fmla="*/ 46 h 438"/>
              <a:gd name="T102" fmla="*/ 1002 w 1158"/>
              <a:gd name="T103" fmla="*/ 65 h 438"/>
              <a:gd name="T104" fmla="*/ 1018 w 1158"/>
              <a:gd name="T105" fmla="*/ 82 h 438"/>
              <a:gd name="T106" fmla="*/ 1041 w 1158"/>
              <a:gd name="T107" fmla="*/ 114 h 438"/>
              <a:gd name="T108" fmla="*/ 1057 w 1158"/>
              <a:gd name="T109" fmla="*/ 142 h 438"/>
              <a:gd name="T110" fmla="*/ 1080 w 1158"/>
              <a:gd name="T111" fmla="*/ 192 h 438"/>
              <a:gd name="T112" fmla="*/ 1096 w 1158"/>
              <a:gd name="T113" fmla="*/ 232 h 438"/>
              <a:gd name="T114" fmla="*/ 1119 w 1158"/>
              <a:gd name="T115" fmla="*/ 302 h 438"/>
              <a:gd name="T116" fmla="*/ 1134 w 1158"/>
              <a:gd name="T117" fmla="*/ 355 h 438"/>
              <a:gd name="T118" fmla="*/ 1158 w 1158"/>
              <a:gd name="T119" fmla="*/ 438 h 4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  <a:cxn ang="0">
                <a:pos x="T90" y="T91"/>
              </a:cxn>
              <a:cxn ang="0">
                <a:pos x="T92" y="T93"/>
              </a:cxn>
              <a:cxn ang="0">
                <a:pos x="T94" y="T95"/>
              </a:cxn>
              <a:cxn ang="0">
                <a:pos x="T96" y="T97"/>
              </a:cxn>
              <a:cxn ang="0">
                <a:pos x="T98" y="T99"/>
              </a:cxn>
              <a:cxn ang="0">
                <a:pos x="T100" y="T101"/>
              </a:cxn>
              <a:cxn ang="0">
                <a:pos x="T102" y="T103"/>
              </a:cxn>
              <a:cxn ang="0">
                <a:pos x="T104" y="T105"/>
              </a:cxn>
              <a:cxn ang="0">
                <a:pos x="T106" y="T107"/>
              </a:cxn>
              <a:cxn ang="0">
                <a:pos x="T108" y="T109"/>
              </a:cxn>
              <a:cxn ang="0">
                <a:pos x="T110" y="T111"/>
              </a:cxn>
              <a:cxn ang="0">
                <a:pos x="T112" y="T113"/>
              </a:cxn>
              <a:cxn ang="0">
                <a:pos x="T114" y="T115"/>
              </a:cxn>
              <a:cxn ang="0">
                <a:pos x="T116" y="T117"/>
              </a:cxn>
              <a:cxn ang="0">
                <a:pos x="T118" y="T119"/>
              </a:cxn>
            </a:cxnLst>
            <a:rect l="0" t="0" r="r" b="b"/>
            <a:pathLst>
              <a:path w="1158" h="438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7" y="0"/>
                </a:lnTo>
                <a:lnTo>
                  <a:pt x="7" y="0"/>
                </a:lnTo>
                <a:lnTo>
                  <a:pt x="14" y="0"/>
                </a:lnTo>
                <a:lnTo>
                  <a:pt x="14" y="0"/>
                </a:lnTo>
                <a:lnTo>
                  <a:pt x="23" y="0"/>
                </a:lnTo>
                <a:lnTo>
                  <a:pt x="23" y="0"/>
                </a:lnTo>
                <a:lnTo>
                  <a:pt x="30" y="0"/>
                </a:lnTo>
                <a:lnTo>
                  <a:pt x="30" y="0"/>
                </a:lnTo>
                <a:lnTo>
                  <a:pt x="38" y="0"/>
                </a:lnTo>
                <a:lnTo>
                  <a:pt x="38" y="0"/>
                </a:lnTo>
                <a:lnTo>
                  <a:pt x="46" y="0"/>
                </a:lnTo>
                <a:lnTo>
                  <a:pt x="46" y="0"/>
                </a:lnTo>
                <a:lnTo>
                  <a:pt x="53" y="0"/>
                </a:lnTo>
                <a:lnTo>
                  <a:pt x="53" y="0"/>
                </a:lnTo>
                <a:lnTo>
                  <a:pt x="61" y="0"/>
                </a:lnTo>
                <a:lnTo>
                  <a:pt x="61" y="0"/>
                </a:lnTo>
                <a:lnTo>
                  <a:pt x="69" y="0"/>
                </a:lnTo>
                <a:lnTo>
                  <a:pt x="69" y="0"/>
                </a:lnTo>
                <a:lnTo>
                  <a:pt x="77" y="0"/>
                </a:lnTo>
                <a:lnTo>
                  <a:pt x="77" y="0"/>
                </a:lnTo>
                <a:lnTo>
                  <a:pt x="85" y="0"/>
                </a:lnTo>
                <a:lnTo>
                  <a:pt x="85" y="0"/>
                </a:lnTo>
                <a:lnTo>
                  <a:pt x="92" y="0"/>
                </a:lnTo>
                <a:lnTo>
                  <a:pt x="92" y="0"/>
                </a:lnTo>
                <a:lnTo>
                  <a:pt x="100" y="0"/>
                </a:lnTo>
                <a:lnTo>
                  <a:pt x="100" y="0"/>
                </a:lnTo>
                <a:lnTo>
                  <a:pt x="108" y="0"/>
                </a:lnTo>
                <a:lnTo>
                  <a:pt x="108" y="0"/>
                </a:lnTo>
                <a:lnTo>
                  <a:pt x="116" y="0"/>
                </a:lnTo>
                <a:lnTo>
                  <a:pt x="116" y="0"/>
                </a:lnTo>
                <a:lnTo>
                  <a:pt x="123" y="0"/>
                </a:lnTo>
                <a:lnTo>
                  <a:pt x="123" y="0"/>
                </a:lnTo>
                <a:lnTo>
                  <a:pt x="132" y="0"/>
                </a:lnTo>
                <a:lnTo>
                  <a:pt x="132" y="0"/>
                </a:lnTo>
                <a:lnTo>
                  <a:pt x="139" y="0"/>
                </a:lnTo>
                <a:lnTo>
                  <a:pt x="139" y="0"/>
                </a:lnTo>
                <a:lnTo>
                  <a:pt x="147" y="0"/>
                </a:lnTo>
                <a:lnTo>
                  <a:pt x="147" y="0"/>
                </a:lnTo>
                <a:lnTo>
                  <a:pt x="155" y="0"/>
                </a:lnTo>
                <a:lnTo>
                  <a:pt x="155" y="0"/>
                </a:lnTo>
                <a:lnTo>
                  <a:pt x="162" y="0"/>
                </a:lnTo>
                <a:lnTo>
                  <a:pt x="162" y="0"/>
                </a:lnTo>
                <a:lnTo>
                  <a:pt x="170" y="0"/>
                </a:lnTo>
                <a:lnTo>
                  <a:pt x="170" y="0"/>
                </a:lnTo>
                <a:lnTo>
                  <a:pt x="178" y="0"/>
                </a:lnTo>
                <a:lnTo>
                  <a:pt x="178" y="0"/>
                </a:lnTo>
                <a:lnTo>
                  <a:pt x="185" y="0"/>
                </a:lnTo>
                <a:lnTo>
                  <a:pt x="185" y="0"/>
                </a:lnTo>
                <a:lnTo>
                  <a:pt x="194" y="0"/>
                </a:lnTo>
                <a:lnTo>
                  <a:pt x="194" y="0"/>
                </a:lnTo>
                <a:lnTo>
                  <a:pt x="201" y="0"/>
                </a:lnTo>
                <a:lnTo>
                  <a:pt x="201" y="0"/>
                </a:lnTo>
                <a:lnTo>
                  <a:pt x="209" y="0"/>
                </a:lnTo>
                <a:lnTo>
                  <a:pt x="209" y="0"/>
                </a:lnTo>
                <a:lnTo>
                  <a:pt x="217" y="0"/>
                </a:lnTo>
                <a:lnTo>
                  <a:pt x="217" y="0"/>
                </a:lnTo>
                <a:lnTo>
                  <a:pt x="225" y="0"/>
                </a:lnTo>
                <a:lnTo>
                  <a:pt x="225" y="0"/>
                </a:lnTo>
                <a:lnTo>
                  <a:pt x="233" y="0"/>
                </a:lnTo>
                <a:lnTo>
                  <a:pt x="233" y="0"/>
                </a:lnTo>
                <a:lnTo>
                  <a:pt x="240" y="0"/>
                </a:lnTo>
                <a:lnTo>
                  <a:pt x="240" y="0"/>
                </a:lnTo>
                <a:lnTo>
                  <a:pt x="248" y="0"/>
                </a:lnTo>
                <a:lnTo>
                  <a:pt x="248" y="0"/>
                </a:lnTo>
                <a:lnTo>
                  <a:pt x="256" y="0"/>
                </a:lnTo>
                <a:lnTo>
                  <a:pt x="256" y="0"/>
                </a:lnTo>
                <a:lnTo>
                  <a:pt x="264" y="0"/>
                </a:lnTo>
                <a:lnTo>
                  <a:pt x="264" y="0"/>
                </a:lnTo>
                <a:lnTo>
                  <a:pt x="271" y="0"/>
                </a:lnTo>
                <a:lnTo>
                  <a:pt x="271" y="0"/>
                </a:lnTo>
                <a:lnTo>
                  <a:pt x="279" y="0"/>
                </a:lnTo>
                <a:lnTo>
                  <a:pt x="279" y="0"/>
                </a:lnTo>
                <a:lnTo>
                  <a:pt x="287" y="0"/>
                </a:lnTo>
                <a:lnTo>
                  <a:pt x="287" y="0"/>
                </a:lnTo>
                <a:lnTo>
                  <a:pt x="294" y="0"/>
                </a:lnTo>
                <a:lnTo>
                  <a:pt x="294" y="0"/>
                </a:lnTo>
                <a:lnTo>
                  <a:pt x="303" y="0"/>
                </a:lnTo>
                <a:lnTo>
                  <a:pt x="303" y="0"/>
                </a:lnTo>
                <a:lnTo>
                  <a:pt x="310" y="0"/>
                </a:lnTo>
                <a:lnTo>
                  <a:pt x="310" y="0"/>
                </a:lnTo>
                <a:lnTo>
                  <a:pt x="318" y="0"/>
                </a:lnTo>
                <a:lnTo>
                  <a:pt x="318" y="0"/>
                </a:lnTo>
                <a:lnTo>
                  <a:pt x="326" y="0"/>
                </a:lnTo>
                <a:lnTo>
                  <a:pt x="326" y="0"/>
                </a:lnTo>
                <a:lnTo>
                  <a:pt x="333" y="0"/>
                </a:lnTo>
                <a:lnTo>
                  <a:pt x="333" y="0"/>
                </a:lnTo>
                <a:lnTo>
                  <a:pt x="341" y="0"/>
                </a:lnTo>
                <a:lnTo>
                  <a:pt x="341" y="0"/>
                </a:lnTo>
                <a:lnTo>
                  <a:pt x="349" y="0"/>
                </a:lnTo>
                <a:lnTo>
                  <a:pt x="349" y="0"/>
                </a:lnTo>
                <a:lnTo>
                  <a:pt x="357" y="0"/>
                </a:lnTo>
                <a:lnTo>
                  <a:pt x="357" y="0"/>
                </a:lnTo>
                <a:lnTo>
                  <a:pt x="365" y="0"/>
                </a:lnTo>
                <a:lnTo>
                  <a:pt x="365" y="0"/>
                </a:lnTo>
                <a:lnTo>
                  <a:pt x="372" y="0"/>
                </a:lnTo>
                <a:lnTo>
                  <a:pt x="372" y="0"/>
                </a:lnTo>
                <a:lnTo>
                  <a:pt x="380" y="0"/>
                </a:lnTo>
                <a:lnTo>
                  <a:pt x="380" y="0"/>
                </a:lnTo>
                <a:lnTo>
                  <a:pt x="388" y="0"/>
                </a:lnTo>
                <a:lnTo>
                  <a:pt x="388" y="0"/>
                </a:lnTo>
                <a:lnTo>
                  <a:pt x="396" y="0"/>
                </a:lnTo>
                <a:lnTo>
                  <a:pt x="396" y="0"/>
                </a:lnTo>
                <a:lnTo>
                  <a:pt x="404" y="0"/>
                </a:lnTo>
                <a:lnTo>
                  <a:pt x="404" y="0"/>
                </a:lnTo>
                <a:lnTo>
                  <a:pt x="412" y="0"/>
                </a:lnTo>
                <a:lnTo>
                  <a:pt x="412" y="0"/>
                </a:lnTo>
                <a:lnTo>
                  <a:pt x="419" y="0"/>
                </a:lnTo>
                <a:lnTo>
                  <a:pt x="419" y="0"/>
                </a:lnTo>
                <a:lnTo>
                  <a:pt x="427" y="0"/>
                </a:lnTo>
                <a:lnTo>
                  <a:pt x="427" y="0"/>
                </a:lnTo>
                <a:lnTo>
                  <a:pt x="435" y="0"/>
                </a:lnTo>
                <a:lnTo>
                  <a:pt x="435" y="0"/>
                </a:lnTo>
                <a:lnTo>
                  <a:pt x="442" y="0"/>
                </a:lnTo>
                <a:lnTo>
                  <a:pt x="442" y="0"/>
                </a:lnTo>
                <a:lnTo>
                  <a:pt x="450" y="0"/>
                </a:lnTo>
                <a:lnTo>
                  <a:pt x="450" y="0"/>
                </a:lnTo>
                <a:lnTo>
                  <a:pt x="458" y="0"/>
                </a:lnTo>
                <a:lnTo>
                  <a:pt x="458" y="0"/>
                </a:lnTo>
                <a:lnTo>
                  <a:pt x="465" y="0"/>
                </a:lnTo>
                <a:lnTo>
                  <a:pt x="465" y="0"/>
                </a:lnTo>
                <a:lnTo>
                  <a:pt x="474" y="0"/>
                </a:lnTo>
                <a:lnTo>
                  <a:pt x="474" y="0"/>
                </a:lnTo>
                <a:lnTo>
                  <a:pt x="481" y="0"/>
                </a:lnTo>
                <a:lnTo>
                  <a:pt x="481" y="0"/>
                </a:lnTo>
                <a:lnTo>
                  <a:pt x="489" y="0"/>
                </a:lnTo>
                <a:lnTo>
                  <a:pt x="489" y="0"/>
                </a:lnTo>
                <a:lnTo>
                  <a:pt x="497" y="0"/>
                </a:lnTo>
                <a:lnTo>
                  <a:pt x="497" y="0"/>
                </a:lnTo>
                <a:lnTo>
                  <a:pt x="505" y="0"/>
                </a:lnTo>
                <a:lnTo>
                  <a:pt x="505" y="0"/>
                </a:lnTo>
                <a:lnTo>
                  <a:pt x="513" y="0"/>
                </a:lnTo>
                <a:lnTo>
                  <a:pt x="513" y="0"/>
                </a:lnTo>
                <a:lnTo>
                  <a:pt x="520" y="0"/>
                </a:lnTo>
                <a:lnTo>
                  <a:pt x="520" y="0"/>
                </a:lnTo>
                <a:lnTo>
                  <a:pt x="528" y="0"/>
                </a:lnTo>
                <a:lnTo>
                  <a:pt x="528" y="0"/>
                </a:lnTo>
                <a:lnTo>
                  <a:pt x="536" y="0"/>
                </a:lnTo>
                <a:lnTo>
                  <a:pt x="536" y="0"/>
                </a:lnTo>
                <a:lnTo>
                  <a:pt x="544" y="0"/>
                </a:lnTo>
                <a:lnTo>
                  <a:pt x="544" y="0"/>
                </a:lnTo>
                <a:lnTo>
                  <a:pt x="551" y="0"/>
                </a:lnTo>
                <a:lnTo>
                  <a:pt x="551" y="0"/>
                </a:lnTo>
                <a:lnTo>
                  <a:pt x="559" y="0"/>
                </a:lnTo>
                <a:lnTo>
                  <a:pt x="559" y="0"/>
                </a:lnTo>
                <a:lnTo>
                  <a:pt x="567" y="0"/>
                </a:lnTo>
                <a:lnTo>
                  <a:pt x="567" y="0"/>
                </a:lnTo>
                <a:lnTo>
                  <a:pt x="574" y="0"/>
                </a:lnTo>
                <a:lnTo>
                  <a:pt x="574" y="0"/>
                </a:lnTo>
                <a:lnTo>
                  <a:pt x="583" y="0"/>
                </a:lnTo>
                <a:lnTo>
                  <a:pt x="583" y="0"/>
                </a:lnTo>
                <a:lnTo>
                  <a:pt x="590" y="0"/>
                </a:lnTo>
                <a:lnTo>
                  <a:pt x="590" y="0"/>
                </a:lnTo>
                <a:lnTo>
                  <a:pt x="598" y="0"/>
                </a:lnTo>
                <a:lnTo>
                  <a:pt x="598" y="0"/>
                </a:lnTo>
                <a:lnTo>
                  <a:pt x="606" y="0"/>
                </a:lnTo>
                <a:lnTo>
                  <a:pt x="606" y="0"/>
                </a:lnTo>
                <a:lnTo>
                  <a:pt x="613" y="0"/>
                </a:lnTo>
                <a:lnTo>
                  <a:pt x="613" y="0"/>
                </a:lnTo>
                <a:lnTo>
                  <a:pt x="621" y="0"/>
                </a:lnTo>
                <a:lnTo>
                  <a:pt x="621" y="0"/>
                </a:lnTo>
                <a:lnTo>
                  <a:pt x="629" y="0"/>
                </a:lnTo>
                <a:lnTo>
                  <a:pt x="629" y="0"/>
                </a:lnTo>
                <a:lnTo>
                  <a:pt x="637" y="0"/>
                </a:lnTo>
                <a:lnTo>
                  <a:pt x="637" y="0"/>
                </a:lnTo>
                <a:lnTo>
                  <a:pt x="645" y="0"/>
                </a:lnTo>
                <a:lnTo>
                  <a:pt x="645" y="0"/>
                </a:lnTo>
                <a:lnTo>
                  <a:pt x="652" y="0"/>
                </a:lnTo>
                <a:lnTo>
                  <a:pt x="652" y="0"/>
                </a:lnTo>
                <a:lnTo>
                  <a:pt x="660" y="0"/>
                </a:lnTo>
                <a:lnTo>
                  <a:pt x="660" y="0"/>
                </a:lnTo>
                <a:lnTo>
                  <a:pt x="668" y="1"/>
                </a:lnTo>
                <a:lnTo>
                  <a:pt x="668" y="1"/>
                </a:lnTo>
                <a:lnTo>
                  <a:pt x="676" y="1"/>
                </a:lnTo>
                <a:lnTo>
                  <a:pt x="676" y="1"/>
                </a:lnTo>
                <a:lnTo>
                  <a:pt x="684" y="1"/>
                </a:lnTo>
                <a:lnTo>
                  <a:pt x="684" y="1"/>
                </a:lnTo>
                <a:lnTo>
                  <a:pt x="692" y="1"/>
                </a:lnTo>
                <a:lnTo>
                  <a:pt x="692" y="1"/>
                </a:lnTo>
                <a:lnTo>
                  <a:pt x="699" y="1"/>
                </a:lnTo>
                <a:lnTo>
                  <a:pt x="699" y="1"/>
                </a:lnTo>
                <a:lnTo>
                  <a:pt x="707" y="1"/>
                </a:lnTo>
                <a:lnTo>
                  <a:pt x="707" y="1"/>
                </a:lnTo>
                <a:lnTo>
                  <a:pt x="715" y="1"/>
                </a:lnTo>
                <a:lnTo>
                  <a:pt x="715" y="1"/>
                </a:lnTo>
                <a:lnTo>
                  <a:pt x="722" y="1"/>
                </a:lnTo>
                <a:lnTo>
                  <a:pt x="722" y="1"/>
                </a:lnTo>
                <a:lnTo>
                  <a:pt x="730" y="1"/>
                </a:lnTo>
                <a:lnTo>
                  <a:pt x="730" y="1"/>
                </a:lnTo>
                <a:lnTo>
                  <a:pt x="738" y="1"/>
                </a:lnTo>
                <a:lnTo>
                  <a:pt x="738" y="1"/>
                </a:lnTo>
                <a:lnTo>
                  <a:pt x="745" y="2"/>
                </a:lnTo>
                <a:lnTo>
                  <a:pt x="745" y="2"/>
                </a:lnTo>
                <a:lnTo>
                  <a:pt x="754" y="2"/>
                </a:lnTo>
                <a:lnTo>
                  <a:pt x="754" y="2"/>
                </a:lnTo>
                <a:lnTo>
                  <a:pt x="761" y="2"/>
                </a:lnTo>
                <a:lnTo>
                  <a:pt x="761" y="2"/>
                </a:lnTo>
                <a:lnTo>
                  <a:pt x="769" y="2"/>
                </a:lnTo>
                <a:lnTo>
                  <a:pt x="769" y="2"/>
                </a:lnTo>
                <a:lnTo>
                  <a:pt x="777" y="2"/>
                </a:lnTo>
                <a:lnTo>
                  <a:pt x="777" y="2"/>
                </a:lnTo>
                <a:lnTo>
                  <a:pt x="785" y="2"/>
                </a:lnTo>
                <a:lnTo>
                  <a:pt x="785" y="2"/>
                </a:lnTo>
                <a:lnTo>
                  <a:pt x="793" y="2"/>
                </a:lnTo>
                <a:lnTo>
                  <a:pt x="793" y="2"/>
                </a:lnTo>
                <a:lnTo>
                  <a:pt x="800" y="3"/>
                </a:lnTo>
                <a:lnTo>
                  <a:pt x="800" y="3"/>
                </a:lnTo>
                <a:lnTo>
                  <a:pt x="808" y="3"/>
                </a:lnTo>
                <a:lnTo>
                  <a:pt x="808" y="3"/>
                </a:lnTo>
                <a:lnTo>
                  <a:pt x="816" y="4"/>
                </a:lnTo>
                <a:lnTo>
                  <a:pt x="816" y="4"/>
                </a:lnTo>
                <a:lnTo>
                  <a:pt x="824" y="4"/>
                </a:lnTo>
                <a:lnTo>
                  <a:pt x="824" y="4"/>
                </a:lnTo>
                <a:lnTo>
                  <a:pt x="831" y="5"/>
                </a:lnTo>
                <a:lnTo>
                  <a:pt x="831" y="5"/>
                </a:lnTo>
                <a:lnTo>
                  <a:pt x="839" y="6"/>
                </a:lnTo>
                <a:lnTo>
                  <a:pt x="839" y="6"/>
                </a:lnTo>
                <a:lnTo>
                  <a:pt x="847" y="6"/>
                </a:lnTo>
                <a:lnTo>
                  <a:pt x="847" y="6"/>
                </a:lnTo>
                <a:lnTo>
                  <a:pt x="854" y="7"/>
                </a:lnTo>
                <a:lnTo>
                  <a:pt x="854" y="7"/>
                </a:lnTo>
                <a:lnTo>
                  <a:pt x="863" y="8"/>
                </a:lnTo>
                <a:lnTo>
                  <a:pt x="863" y="8"/>
                </a:lnTo>
                <a:lnTo>
                  <a:pt x="870" y="9"/>
                </a:lnTo>
                <a:lnTo>
                  <a:pt x="870" y="9"/>
                </a:lnTo>
                <a:lnTo>
                  <a:pt x="878" y="10"/>
                </a:lnTo>
                <a:lnTo>
                  <a:pt x="878" y="10"/>
                </a:lnTo>
                <a:lnTo>
                  <a:pt x="886" y="11"/>
                </a:lnTo>
                <a:lnTo>
                  <a:pt x="886" y="11"/>
                </a:lnTo>
                <a:lnTo>
                  <a:pt x="893" y="12"/>
                </a:lnTo>
                <a:lnTo>
                  <a:pt x="893" y="12"/>
                </a:lnTo>
                <a:lnTo>
                  <a:pt x="901" y="14"/>
                </a:lnTo>
                <a:lnTo>
                  <a:pt x="901" y="14"/>
                </a:lnTo>
                <a:lnTo>
                  <a:pt x="909" y="16"/>
                </a:lnTo>
                <a:lnTo>
                  <a:pt x="909" y="16"/>
                </a:lnTo>
                <a:lnTo>
                  <a:pt x="917" y="18"/>
                </a:lnTo>
                <a:lnTo>
                  <a:pt x="917" y="18"/>
                </a:lnTo>
                <a:lnTo>
                  <a:pt x="925" y="20"/>
                </a:lnTo>
                <a:lnTo>
                  <a:pt x="925" y="20"/>
                </a:lnTo>
                <a:lnTo>
                  <a:pt x="932" y="23"/>
                </a:lnTo>
                <a:lnTo>
                  <a:pt x="932" y="23"/>
                </a:lnTo>
                <a:lnTo>
                  <a:pt x="941" y="26"/>
                </a:lnTo>
                <a:lnTo>
                  <a:pt x="941" y="26"/>
                </a:lnTo>
                <a:lnTo>
                  <a:pt x="948" y="29"/>
                </a:lnTo>
                <a:lnTo>
                  <a:pt x="948" y="29"/>
                </a:lnTo>
                <a:lnTo>
                  <a:pt x="956" y="32"/>
                </a:lnTo>
                <a:lnTo>
                  <a:pt x="956" y="32"/>
                </a:lnTo>
                <a:lnTo>
                  <a:pt x="964" y="36"/>
                </a:lnTo>
                <a:lnTo>
                  <a:pt x="964" y="36"/>
                </a:lnTo>
                <a:lnTo>
                  <a:pt x="972" y="41"/>
                </a:lnTo>
                <a:lnTo>
                  <a:pt x="972" y="41"/>
                </a:lnTo>
                <a:lnTo>
                  <a:pt x="979" y="46"/>
                </a:lnTo>
                <a:lnTo>
                  <a:pt x="979" y="46"/>
                </a:lnTo>
                <a:lnTo>
                  <a:pt x="987" y="52"/>
                </a:lnTo>
                <a:lnTo>
                  <a:pt x="987" y="52"/>
                </a:lnTo>
                <a:lnTo>
                  <a:pt x="995" y="58"/>
                </a:lnTo>
                <a:lnTo>
                  <a:pt x="995" y="58"/>
                </a:lnTo>
                <a:lnTo>
                  <a:pt x="1002" y="65"/>
                </a:lnTo>
                <a:lnTo>
                  <a:pt x="1002" y="65"/>
                </a:lnTo>
                <a:lnTo>
                  <a:pt x="1011" y="74"/>
                </a:lnTo>
                <a:lnTo>
                  <a:pt x="1011" y="74"/>
                </a:lnTo>
                <a:lnTo>
                  <a:pt x="1018" y="82"/>
                </a:lnTo>
                <a:lnTo>
                  <a:pt x="1018" y="82"/>
                </a:lnTo>
                <a:lnTo>
                  <a:pt x="1025" y="91"/>
                </a:lnTo>
                <a:lnTo>
                  <a:pt x="1025" y="91"/>
                </a:lnTo>
                <a:lnTo>
                  <a:pt x="1034" y="103"/>
                </a:lnTo>
                <a:lnTo>
                  <a:pt x="1034" y="103"/>
                </a:lnTo>
                <a:lnTo>
                  <a:pt x="1041" y="114"/>
                </a:lnTo>
                <a:lnTo>
                  <a:pt x="1041" y="114"/>
                </a:lnTo>
                <a:lnTo>
                  <a:pt x="1049" y="127"/>
                </a:lnTo>
                <a:lnTo>
                  <a:pt x="1049" y="127"/>
                </a:lnTo>
                <a:lnTo>
                  <a:pt x="1057" y="142"/>
                </a:lnTo>
                <a:lnTo>
                  <a:pt x="1057" y="142"/>
                </a:lnTo>
                <a:lnTo>
                  <a:pt x="1065" y="157"/>
                </a:lnTo>
                <a:lnTo>
                  <a:pt x="1065" y="157"/>
                </a:lnTo>
                <a:lnTo>
                  <a:pt x="1073" y="174"/>
                </a:lnTo>
                <a:lnTo>
                  <a:pt x="1073" y="174"/>
                </a:lnTo>
                <a:lnTo>
                  <a:pt x="1080" y="192"/>
                </a:lnTo>
                <a:lnTo>
                  <a:pt x="1080" y="192"/>
                </a:lnTo>
                <a:lnTo>
                  <a:pt x="1088" y="211"/>
                </a:lnTo>
                <a:lnTo>
                  <a:pt x="1088" y="211"/>
                </a:lnTo>
                <a:lnTo>
                  <a:pt x="1096" y="232"/>
                </a:lnTo>
                <a:lnTo>
                  <a:pt x="1096" y="232"/>
                </a:lnTo>
                <a:lnTo>
                  <a:pt x="1104" y="254"/>
                </a:lnTo>
                <a:lnTo>
                  <a:pt x="1104" y="254"/>
                </a:lnTo>
                <a:lnTo>
                  <a:pt x="1111" y="278"/>
                </a:lnTo>
                <a:lnTo>
                  <a:pt x="1111" y="278"/>
                </a:lnTo>
                <a:lnTo>
                  <a:pt x="1119" y="302"/>
                </a:lnTo>
                <a:lnTo>
                  <a:pt x="1119" y="302"/>
                </a:lnTo>
                <a:lnTo>
                  <a:pt x="1127" y="329"/>
                </a:lnTo>
                <a:lnTo>
                  <a:pt x="1127" y="329"/>
                </a:lnTo>
                <a:lnTo>
                  <a:pt x="1134" y="355"/>
                </a:lnTo>
                <a:lnTo>
                  <a:pt x="1134" y="355"/>
                </a:lnTo>
                <a:lnTo>
                  <a:pt x="1143" y="382"/>
                </a:lnTo>
                <a:lnTo>
                  <a:pt x="1143" y="382"/>
                </a:lnTo>
                <a:lnTo>
                  <a:pt x="1150" y="410"/>
                </a:lnTo>
                <a:lnTo>
                  <a:pt x="1150" y="410"/>
                </a:lnTo>
                <a:lnTo>
                  <a:pt x="1158" y="438"/>
                </a:lnTo>
              </a:path>
            </a:pathLst>
          </a:custGeom>
          <a:noFill/>
          <a:ln w="142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5" name="Line 349"/>
          <p:cNvSpPr>
            <a:spLocks noChangeShapeType="1"/>
          </p:cNvSpPr>
          <p:nvPr/>
        </p:nvSpPr>
        <p:spPr bwMode="auto">
          <a:xfrm>
            <a:off x="3745706" y="3389710"/>
            <a:ext cx="0" cy="2619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6" name="Line 350"/>
          <p:cNvSpPr>
            <a:spLocks noChangeShapeType="1"/>
          </p:cNvSpPr>
          <p:nvPr/>
        </p:nvSpPr>
        <p:spPr bwMode="auto">
          <a:xfrm>
            <a:off x="3745706" y="3415903"/>
            <a:ext cx="0" cy="25004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7" name="Line 351"/>
          <p:cNvSpPr>
            <a:spLocks noChangeShapeType="1"/>
          </p:cNvSpPr>
          <p:nvPr/>
        </p:nvSpPr>
        <p:spPr bwMode="auto">
          <a:xfrm>
            <a:off x="3721894" y="3389710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8" name="Line 352"/>
          <p:cNvSpPr>
            <a:spLocks noChangeShapeType="1"/>
          </p:cNvSpPr>
          <p:nvPr/>
        </p:nvSpPr>
        <p:spPr bwMode="auto">
          <a:xfrm>
            <a:off x="3721894" y="3440906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69" name="Line 353"/>
          <p:cNvSpPr>
            <a:spLocks noChangeShapeType="1"/>
          </p:cNvSpPr>
          <p:nvPr/>
        </p:nvSpPr>
        <p:spPr bwMode="auto">
          <a:xfrm>
            <a:off x="4563666" y="3227785"/>
            <a:ext cx="0" cy="5596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0" name="Line 354"/>
          <p:cNvSpPr>
            <a:spLocks noChangeShapeType="1"/>
          </p:cNvSpPr>
          <p:nvPr/>
        </p:nvSpPr>
        <p:spPr bwMode="auto">
          <a:xfrm>
            <a:off x="4563666" y="3283744"/>
            <a:ext cx="0" cy="5596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1" name="Line 355"/>
          <p:cNvSpPr>
            <a:spLocks noChangeShapeType="1"/>
          </p:cNvSpPr>
          <p:nvPr/>
        </p:nvSpPr>
        <p:spPr bwMode="auto">
          <a:xfrm>
            <a:off x="4538663" y="3227785"/>
            <a:ext cx="4881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2" name="Line 356"/>
          <p:cNvSpPr>
            <a:spLocks noChangeShapeType="1"/>
          </p:cNvSpPr>
          <p:nvPr/>
        </p:nvSpPr>
        <p:spPr bwMode="auto">
          <a:xfrm>
            <a:off x="4538663" y="3339704"/>
            <a:ext cx="4881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3" name="Line 357"/>
          <p:cNvSpPr>
            <a:spLocks noChangeShapeType="1"/>
          </p:cNvSpPr>
          <p:nvPr/>
        </p:nvSpPr>
        <p:spPr bwMode="auto">
          <a:xfrm>
            <a:off x="4705350" y="3332560"/>
            <a:ext cx="0" cy="2738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4" name="Line 358"/>
          <p:cNvSpPr>
            <a:spLocks noChangeShapeType="1"/>
          </p:cNvSpPr>
          <p:nvPr/>
        </p:nvSpPr>
        <p:spPr bwMode="auto">
          <a:xfrm>
            <a:off x="4705350" y="3359944"/>
            <a:ext cx="0" cy="27385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5" name="Line 359"/>
          <p:cNvSpPr>
            <a:spLocks noChangeShapeType="1"/>
          </p:cNvSpPr>
          <p:nvPr/>
        </p:nvSpPr>
        <p:spPr bwMode="auto">
          <a:xfrm>
            <a:off x="4681538" y="3332560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6" name="Line 360"/>
          <p:cNvSpPr>
            <a:spLocks noChangeShapeType="1"/>
          </p:cNvSpPr>
          <p:nvPr/>
        </p:nvSpPr>
        <p:spPr bwMode="auto">
          <a:xfrm>
            <a:off x="4681538" y="3387329"/>
            <a:ext cx="47625" cy="0"/>
          </a:xfrm>
          <a:prstGeom prst="line">
            <a:avLst/>
          </a:prstGeom>
          <a:noFill/>
          <a:ln w="2063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7" name="Oval 361"/>
          <p:cNvSpPr>
            <a:spLocks noChangeArrowheads="1"/>
          </p:cNvSpPr>
          <p:nvPr/>
        </p:nvSpPr>
        <p:spPr bwMode="auto">
          <a:xfrm>
            <a:off x="3475435" y="3327797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8" name="Oval 362"/>
          <p:cNvSpPr>
            <a:spLocks noChangeArrowheads="1"/>
          </p:cNvSpPr>
          <p:nvPr/>
        </p:nvSpPr>
        <p:spPr bwMode="auto">
          <a:xfrm>
            <a:off x="3475435" y="3327797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79" name="Oval 363"/>
          <p:cNvSpPr>
            <a:spLocks noChangeArrowheads="1"/>
          </p:cNvSpPr>
          <p:nvPr/>
        </p:nvSpPr>
        <p:spPr bwMode="auto">
          <a:xfrm>
            <a:off x="3724275" y="3394472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0" name="Oval 364"/>
          <p:cNvSpPr>
            <a:spLocks noChangeArrowheads="1"/>
          </p:cNvSpPr>
          <p:nvPr/>
        </p:nvSpPr>
        <p:spPr bwMode="auto">
          <a:xfrm>
            <a:off x="3724275" y="3394472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1" name="Oval 365"/>
          <p:cNvSpPr>
            <a:spLocks noChangeArrowheads="1"/>
          </p:cNvSpPr>
          <p:nvPr/>
        </p:nvSpPr>
        <p:spPr bwMode="auto">
          <a:xfrm>
            <a:off x="3830241" y="3281362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2" name="Oval 366"/>
          <p:cNvSpPr>
            <a:spLocks noChangeArrowheads="1"/>
          </p:cNvSpPr>
          <p:nvPr/>
        </p:nvSpPr>
        <p:spPr bwMode="auto">
          <a:xfrm>
            <a:off x="3830241" y="3281362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3" name="Oval 367"/>
          <p:cNvSpPr>
            <a:spLocks noChangeArrowheads="1"/>
          </p:cNvSpPr>
          <p:nvPr/>
        </p:nvSpPr>
        <p:spPr bwMode="auto">
          <a:xfrm>
            <a:off x="4186237" y="3339703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4" name="Oval 368"/>
          <p:cNvSpPr>
            <a:spLocks noChangeArrowheads="1"/>
          </p:cNvSpPr>
          <p:nvPr/>
        </p:nvSpPr>
        <p:spPr bwMode="auto">
          <a:xfrm>
            <a:off x="4186237" y="3339703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5" name="Oval 369"/>
          <p:cNvSpPr>
            <a:spLocks noChangeArrowheads="1"/>
          </p:cNvSpPr>
          <p:nvPr/>
        </p:nvSpPr>
        <p:spPr bwMode="auto">
          <a:xfrm>
            <a:off x="4542235" y="3262312"/>
            <a:ext cx="41672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6" name="Oval 370"/>
          <p:cNvSpPr>
            <a:spLocks noChangeArrowheads="1"/>
          </p:cNvSpPr>
          <p:nvPr/>
        </p:nvSpPr>
        <p:spPr bwMode="auto">
          <a:xfrm>
            <a:off x="4542235" y="3262312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7" name="Oval 371"/>
          <p:cNvSpPr>
            <a:spLocks noChangeArrowheads="1"/>
          </p:cNvSpPr>
          <p:nvPr/>
        </p:nvSpPr>
        <p:spPr bwMode="auto">
          <a:xfrm>
            <a:off x="4683919" y="3338512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8" name="Oval 372"/>
          <p:cNvSpPr>
            <a:spLocks noChangeArrowheads="1"/>
          </p:cNvSpPr>
          <p:nvPr/>
        </p:nvSpPr>
        <p:spPr bwMode="auto">
          <a:xfrm>
            <a:off x="4683919" y="3338512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89" name="Oval 373"/>
          <p:cNvSpPr>
            <a:spLocks noChangeArrowheads="1"/>
          </p:cNvSpPr>
          <p:nvPr/>
        </p:nvSpPr>
        <p:spPr bwMode="auto">
          <a:xfrm>
            <a:off x="4791075" y="3709987"/>
            <a:ext cx="42863" cy="42863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90" name="Oval 374"/>
          <p:cNvSpPr>
            <a:spLocks noChangeArrowheads="1"/>
          </p:cNvSpPr>
          <p:nvPr/>
        </p:nvSpPr>
        <p:spPr bwMode="auto">
          <a:xfrm>
            <a:off x="4791075" y="3709987"/>
            <a:ext cx="42863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91" name="Oval 375"/>
          <p:cNvSpPr>
            <a:spLocks noChangeArrowheads="1"/>
          </p:cNvSpPr>
          <p:nvPr/>
        </p:nvSpPr>
        <p:spPr bwMode="auto">
          <a:xfrm>
            <a:off x="4855369" y="3787379"/>
            <a:ext cx="42863" cy="41672"/>
          </a:xfrm>
          <a:prstGeom prst="ellipse">
            <a:avLst/>
          </a:prstGeom>
          <a:solidFill>
            <a:srgbClr val="FF8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92" name="Oval 376"/>
          <p:cNvSpPr>
            <a:spLocks noChangeArrowheads="1"/>
          </p:cNvSpPr>
          <p:nvPr/>
        </p:nvSpPr>
        <p:spPr bwMode="auto">
          <a:xfrm>
            <a:off x="4855369" y="3786187"/>
            <a:ext cx="41672" cy="42863"/>
          </a:xfrm>
          <a:prstGeom prst="ellipse">
            <a:avLst/>
          </a:prstGeom>
          <a:noFill/>
          <a:ln w="1588" cap="flat">
            <a:solidFill>
              <a:srgbClr val="FF8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endParaRPr lang="en-US" sz="675"/>
          </a:p>
        </p:txBody>
      </p:sp>
      <p:sp>
        <p:nvSpPr>
          <p:cNvPr id="393" name="Rectangle 377"/>
          <p:cNvSpPr>
            <a:spLocks noChangeArrowheads="1"/>
          </p:cNvSpPr>
          <p:nvPr/>
        </p:nvSpPr>
        <p:spPr bwMode="auto">
          <a:xfrm>
            <a:off x="3788569" y="4219576"/>
            <a:ext cx="639599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685800"/>
            <a:r>
              <a:rPr lang="en-US" altLang="en-US" sz="675" b="1">
                <a:solidFill>
                  <a:srgbClr val="000000"/>
                </a:solidFill>
                <a:latin typeface="+mn-lt"/>
              </a:rPr>
              <a:t>Log Molar conc</a:t>
            </a:r>
            <a:endParaRPr lang="en-US" altLang="en-US" sz="675">
              <a:latin typeface="+mn-lt"/>
            </a:endParaRPr>
          </a:p>
        </p:txBody>
      </p:sp>
      <p:sp>
        <p:nvSpPr>
          <p:cNvPr id="419" name="Rectangle 418"/>
          <p:cNvSpPr/>
          <p:nvPr/>
        </p:nvSpPr>
        <p:spPr>
          <a:xfrm rot="16200000">
            <a:off x="2218610" y="3491814"/>
            <a:ext cx="1481496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750" b="1" dirty="0"/>
              <a:t>RFU (Ex 340 nm/Em 460 nm)</a:t>
            </a:r>
            <a:endParaRPr lang="en-US" sz="750" b="1" dirty="0"/>
          </a:p>
        </p:txBody>
      </p:sp>
      <p:sp>
        <p:nvSpPr>
          <p:cNvPr id="316" name="Rectangle 5"/>
          <p:cNvSpPr>
            <a:spLocks noChangeArrowheads="1"/>
          </p:cNvSpPr>
          <p:nvPr/>
        </p:nvSpPr>
        <p:spPr bwMode="auto">
          <a:xfrm>
            <a:off x="626665" y="4578244"/>
            <a:ext cx="6445649" cy="615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upplementary Figure 1: AnAc inhibits the cell proliferation of ER+ and TNBC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cells. 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ach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C cell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ine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A-E) was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grown in 5% DCC-FBS-phenol red-free IMEM for 48 h prior to 48 h treatment with EtOH (vehicle control) or the indicated concentration of AnAc for 48 h prior to dsDNA Quantification assay.  Values are the mean + SEM of 4 replicates within one experiment.  </a:t>
            </a:r>
            <a:r>
              <a:rPr lang="en-US" altLang="en-US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IC</a:t>
            </a:r>
            <a:r>
              <a:rPr lang="en-US" altLang="en-US" sz="1000" baseline="-25000" dirty="0" smtClean="0">
                <a:solidFill>
                  <a:srgbClr val="000000"/>
                </a:solidFill>
                <a:cs typeface="Arial" panose="020B0604020202020204" pitchFamily="34" charset="0"/>
              </a:rPr>
              <a:t>50</a:t>
            </a:r>
            <a:r>
              <a:rPr lang="en-US" altLang="en-US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 values from repeated experiments are in Table 2.  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80811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5022" y="5244011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9C and D: Top 2 Pathway Maps for metabolites in MCF-7 cells treated with AnAc by MetaboAnalyst: C) “Immune </a:t>
            </a:r>
            <a:r>
              <a:rPr lang="en-US" sz="1200" b="1" dirty="0"/>
              <a:t>response: The effect of IDO1 on T cell metabolism” </a:t>
            </a:r>
            <a:r>
              <a:rPr lang="en-US" sz="1200" b="1" dirty="0" smtClean="0"/>
              <a:t>and </a:t>
            </a:r>
            <a:r>
              <a:rPr lang="en-US" sz="1200" b="1" dirty="0"/>
              <a:t>D</a:t>
            </a:r>
            <a:r>
              <a:rPr lang="en-US" sz="1200" b="1" dirty="0" smtClean="0"/>
              <a:t>) “</a:t>
            </a:r>
            <a:r>
              <a:rPr lang="en-US" sz="1200" b="1" dirty="0"/>
              <a:t>Pentose phosphate pathway</a:t>
            </a:r>
            <a:r>
              <a:rPr lang="en-US" sz="1200" b="1" dirty="0" smtClean="0"/>
              <a:t>”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Metabolites with a ‘blue thermometer’ indicate metabolites increased by AnAc in MCF-7 cells. </a:t>
            </a:r>
            <a:endParaRPr lang="en-US" sz="12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291" y="331736"/>
            <a:ext cx="4338290" cy="483046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2698" y="273106"/>
            <a:ext cx="3931920" cy="26903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97767" y="273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747254" y="21535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8691430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5023" y="4129314"/>
            <a:ext cx="8077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0A and B: Top 2 Pathway </a:t>
            </a:r>
            <a:r>
              <a:rPr lang="en-US" sz="1200" b="1" dirty="0"/>
              <a:t>Maps in </a:t>
            </a:r>
            <a:r>
              <a:rPr lang="en-US" sz="1200" b="1" dirty="0" smtClean="0"/>
              <a:t>HCC1806 </a:t>
            </a:r>
            <a:r>
              <a:rPr lang="en-US" sz="1200" b="1" dirty="0"/>
              <a:t>cells treated with </a:t>
            </a:r>
            <a:r>
              <a:rPr lang="en-US" sz="1200" b="1" dirty="0" smtClean="0"/>
              <a:t>AnAc: A</a:t>
            </a:r>
            <a:r>
              <a:rPr lang="en-US" sz="1200" b="1" dirty="0"/>
              <a:t>) “Glycogen </a:t>
            </a:r>
            <a:r>
              <a:rPr lang="en-US" sz="1200" b="1" dirty="0" smtClean="0"/>
              <a:t>metabolism” and </a:t>
            </a:r>
            <a:r>
              <a:rPr lang="en-US" sz="1200" b="1" dirty="0"/>
              <a:t>B) “Transport_GPR40 signaling pathway in beta cells</a:t>
            </a:r>
            <a:r>
              <a:rPr lang="en-US" sz="1200" b="1" dirty="0" smtClean="0"/>
              <a:t>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etabolites with a ‘red thermometer’ indicate metabolites increased by AnAc in HCC1806 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023" y="387079"/>
            <a:ext cx="4285476" cy="360144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6294" y="387079"/>
            <a:ext cx="3874662" cy="360144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47396" y="33960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839881" y="35623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8573483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5023" y="4129314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/>
              <a:t>10C </a:t>
            </a:r>
            <a:r>
              <a:rPr lang="en-US" sz="1200" b="1" dirty="0" smtClean="0"/>
              <a:t>and D: Top 2 Pathway </a:t>
            </a:r>
            <a:r>
              <a:rPr lang="en-US" sz="1200" b="1" dirty="0"/>
              <a:t>Maps in </a:t>
            </a:r>
            <a:r>
              <a:rPr lang="en-US" sz="1200" b="1" dirty="0" smtClean="0"/>
              <a:t>HCC1806 </a:t>
            </a:r>
            <a:r>
              <a:rPr lang="en-US" sz="1200" b="1" dirty="0"/>
              <a:t>cells treated with AnAc using metabolites identified as significant in Volcano Plots in </a:t>
            </a:r>
            <a:r>
              <a:rPr lang="en-US" sz="1200" b="1" dirty="0" smtClean="0"/>
              <a:t>MetaboAnalyst: C) </a:t>
            </a:r>
            <a:r>
              <a:rPr lang="en-US" sz="1200" b="1" dirty="0"/>
              <a:t>“Glycogen </a:t>
            </a:r>
            <a:r>
              <a:rPr lang="en-US" sz="1200" b="1" dirty="0" smtClean="0"/>
              <a:t>metabolism” and D) “</a:t>
            </a:r>
            <a:r>
              <a:rPr lang="it-IT" sz="1200" b="1" dirty="0"/>
              <a:t>Immune response_IL-13 signaling via PI3K-ERK pathway</a:t>
            </a:r>
            <a:r>
              <a:rPr lang="en-US" sz="1200" b="1" dirty="0" smtClean="0"/>
              <a:t>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etabolites with a ‘blue thermometer’ indicate metabolites increased by AnAc in HCC1806 cells. </a:t>
            </a:r>
            <a:endParaRPr lang="en-US" sz="12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694" y="481657"/>
            <a:ext cx="3996770" cy="335882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591" y="481657"/>
            <a:ext cx="3706202" cy="350426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94072" y="4176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705006" y="4176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860554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022" y="530801"/>
            <a:ext cx="4093258" cy="46148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7877" y="530801"/>
            <a:ext cx="4129695" cy="4598207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55022" y="5244011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1A and B: Top 2 Pathway </a:t>
            </a:r>
            <a:r>
              <a:rPr lang="en-US" sz="1200" b="1" dirty="0"/>
              <a:t>Maps </a:t>
            </a:r>
            <a:r>
              <a:rPr lang="en-US" sz="1200" b="1" dirty="0" smtClean="0"/>
              <a:t>in BT-20 cells treated </a:t>
            </a:r>
            <a:r>
              <a:rPr lang="en-US" sz="1200" b="1" dirty="0"/>
              <a:t>with AnAc: </a:t>
            </a:r>
            <a:r>
              <a:rPr lang="en-US" sz="1200" b="1" dirty="0" smtClean="0"/>
              <a:t> A) “</a:t>
            </a:r>
            <a:r>
              <a:rPr lang="en-US" sz="1200" dirty="0" smtClean="0"/>
              <a:t>Aminoacyl-tRNA </a:t>
            </a:r>
            <a:r>
              <a:rPr lang="en-US" sz="1200" dirty="0"/>
              <a:t>biosynthesis in </a:t>
            </a:r>
            <a:r>
              <a:rPr lang="en-US" sz="1200" dirty="0" smtClean="0"/>
              <a:t>mitochondrion” and </a:t>
            </a:r>
            <a:r>
              <a:rPr lang="en-US" sz="1200" b="1" dirty="0"/>
              <a:t>B</a:t>
            </a:r>
            <a:r>
              <a:rPr lang="en-US" sz="1200" dirty="0"/>
              <a:t>) </a:t>
            </a:r>
            <a:r>
              <a:rPr lang="en-US" sz="1200" dirty="0" smtClean="0"/>
              <a:t>“Aminoacyl-tRNA </a:t>
            </a:r>
            <a:r>
              <a:rPr lang="en-US" sz="1200" dirty="0"/>
              <a:t>biosynthesis in </a:t>
            </a:r>
            <a:r>
              <a:rPr lang="en-US" sz="1200" dirty="0" smtClean="0"/>
              <a:t>cytoplasm”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Metabolites with a ‘red thermometer’ and ‘blue thermometer” indicate metabolites increased or decreased by AnAc BT-20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cells. </a:t>
            </a:r>
            <a:endParaRPr lang="en-US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67617" y="5308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540622" y="5474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3685867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5022" y="5244011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1C and D: Top 2 Pathway </a:t>
            </a:r>
            <a:r>
              <a:rPr lang="en-US" sz="1200" b="1" dirty="0"/>
              <a:t>Maps </a:t>
            </a:r>
            <a:r>
              <a:rPr lang="en-US" sz="1200" b="1" dirty="0" smtClean="0"/>
              <a:t>in BT-20 cells treated </a:t>
            </a:r>
            <a:r>
              <a:rPr lang="en-US" sz="1200" b="1" dirty="0"/>
              <a:t>with </a:t>
            </a:r>
            <a:r>
              <a:rPr lang="en-US" sz="1200" b="1" dirty="0" smtClean="0"/>
              <a:t>AnAc</a:t>
            </a:r>
            <a:r>
              <a:rPr lang="en-US" sz="1200" b="1" dirty="0"/>
              <a:t> </a:t>
            </a:r>
            <a:r>
              <a:rPr lang="en-US" sz="1200" b="1" dirty="0" smtClean="0"/>
              <a:t>using metabolites identified as significant in Volcano Plots in MetaboAnalyst:  A) “</a:t>
            </a:r>
            <a:r>
              <a:rPr lang="en-US" sz="1200" dirty="0"/>
              <a:t>Immune response_Distinct metabolic pathways in naive and effector CD8+ T cells” </a:t>
            </a:r>
            <a:r>
              <a:rPr lang="en-US" sz="1200" dirty="0" smtClean="0"/>
              <a:t>and</a:t>
            </a:r>
            <a:r>
              <a:rPr lang="en-US" sz="1200" b="1" dirty="0" smtClean="0"/>
              <a:t> </a:t>
            </a:r>
            <a:r>
              <a:rPr lang="en-US" sz="1200" b="1" dirty="0"/>
              <a:t>B) “</a:t>
            </a:r>
            <a:r>
              <a:rPr lang="en-US" sz="1200" dirty="0"/>
              <a:t>Immune response: The effect of IDO1 on T cell metabolism”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Metabolites with a ‘red thermometer’ and ‘blue thermometer” indicate metabolites increased or decreased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by AnAc in BT-20 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8269" y="455201"/>
            <a:ext cx="3931920" cy="443293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4386" y="455201"/>
            <a:ext cx="3951173" cy="439943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94072" y="3013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630189" y="3013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41751516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0521" y="5383348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2A and B: Top 2 Pathway Maps for MDA-MB-231 cells treated with AnAc: A</a:t>
            </a:r>
            <a:r>
              <a:rPr lang="en-US" sz="1200" b="1" dirty="0"/>
              <a:t>) “Signal </a:t>
            </a:r>
            <a:r>
              <a:rPr lang="en-US" sz="1200" b="1" dirty="0" smtClean="0"/>
              <a:t>transduction: Amino </a:t>
            </a:r>
            <a:r>
              <a:rPr lang="en-US" sz="1200" b="1" dirty="0"/>
              <a:t>acid-dependent mTORC1 activation” </a:t>
            </a:r>
            <a:r>
              <a:rPr lang="en-US" sz="1200" b="1" dirty="0" smtClean="0"/>
              <a:t>and </a:t>
            </a:r>
            <a:r>
              <a:rPr lang="en-US" sz="1200" b="1" dirty="0"/>
              <a:t>B) </a:t>
            </a:r>
            <a:r>
              <a:rPr lang="en-US" sz="1200" b="1" dirty="0" smtClean="0"/>
              <a:t>“Urea Cycle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Metabolites with a ‘red thermometer’ indicate metabolites increased by AnAc in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DA-MB-231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cells. </a:t>
            </a:r>
            <a:endParaRPr lang="en-US" sz="12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513" y="235131"/>
            <a:ext cx="3953608" cy="496388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8789" y="235131"/>
            <a:ext cx="4180113" cy="449632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3266" y="1650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394558" y="1816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494816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9924" y="4762375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2C and D: Top 2 Pathway Maps for MDA-MB-231 cells treated with AnAc using metabolites identified in Volcano Plots in MetaboAnalyst: </a:t>
            </a:r>
            <a:r>
              <a:rPr lang="en-US" sz="1200" b="1" dirty="0"/>
              <a:t>C</a:t>
            </a:r>
            <a:r>
              <a:rPr lang="en-US" sz="1200" b="1" dirty="0" smtClean="0"/>
              <a:t>) </a:t>
            </a:r>
            <a:r>
              <a:rPr lang="en-US" sz="1200" b="1" dirty="0"/>
              <a:t>“Neurophysiological process_Role of CDK5 in presynaptic signaling” </a:t>
            </a:r>
            <a:r>
              <a:rPr lang="en-US" sz="1200" b="1" dirty="0" smtClean="0"/>
              <a:t>and D) </a:t>
            </a:r>
            <a:r>
              <a:rPr lang="en-US" sz="1200" b="1" dirty="0"/>
              <a:t>“Prolactin signaling in Prostate Cancer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Metabolites with a ‘red thermometer’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nd ‘blue thermometer” indicate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metabolites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increased or decreased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by AnAc in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DA-MB-231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56" y="661917"/>
            <a:ext cx="3921935" cy="329593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0992" y="614150"/>
            <a:ext cx="4156729" cy="393024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96550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307484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757494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50521" y="5383348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3: Top 2 Pathway </a:t>
            </a:r>
            <a:r>
              <a:rPr lang="en-US" sz="1200" b="1" dirty="0"/>
              <a:t>Maps </a:t>
            </a:r>
            <a:r>
              <a:rPr lang="en-US" sz="1200" b="1" dirty="0" smtClean="0"/>
              <a:t>MDA-MB-468 </a:t>
            </a:r>
            <a:r>
              <a:rPr lang="en-US" sz="1200" b="1" dirty="0"/>
              <a:t>cells treated with AnAc : </a:t>
            </a:r>
            <a:r>
              <a:rPr lang="en-US" sz="1200" b="1" dirty="0" smtClean="0"/>
              <a:t>A</a:t>
            </a:r>
            <a:r>
              <a:rPr lang="en-US" sz="1200" b="1" dirty="0"/>
              <a:t>) “Cholesterol and Sphingolipid transport” </a:t>
            </a:r>
            <a:r>
              <a:rPr lang="en-US" sz="1200" b="1" dirty="0" smtClean="0"/>
              <a:t>and </a:t>
            </a:r>
            <a:r>
              <a:rPr lang="en-US" sz="1200" b="1" dirty="0"/>
              <a:t>B) </a:t>
            </a:r>
            <a:r>
              <a:rPr lang="en-US" sz="1200" b="1" dirty="0" smtClean="0"/>
              <a:t>“Cholesterol </a:t>
            </a:r>
            <a:r>
              <a:rPr lang="en-US" sz="1200" b="1" dirty="0"/>
              <a:t>and Sphingolipid </a:t>
            </a:r>
            <a:r>
              <a:rPr lang="en-US" sz="1200" b="1" dirty="0" smtClean="0"/>
              <a:t>transport </a:t>
            </a:r>
            <a:r>
              <a:rPr lang="en-US" sz="1200" b="1" dirty="0"/>
              <a:t>/ Distribution to the intracellular membrane </a:t>
            </a:r>
            <a:r>
              <a:rPr lang="en-US" sz="1200" b="1" dirty="0" smtClean="0"/>
              <a:t>compartments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etabolites with a ‘red thermometer’ indicate metabolites increased by AnAc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in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DA-MB-468 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21" y="702491"/>
            <a:ext cx="4244277" cy="46808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320" y="702491"/>
            <a:ext cx="4166006" cy="437605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55773" y="6858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673447" y="7024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873758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4931" y="605837"/>
            <a:ext cx="4076363" cy="445317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78500" y="5059007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3C and D: Top 2 Pathway </a:t>
            </a:r>
            <a:r>
              <a:rPr lang="en-US" sz="1200" b="1" dirty="0"/>
              <a:t>Maps </a:t>
            </a:r>
            <a:r>
              <a:rPr lang="en-US" sz="1200" b="1" dirty="0" smtClean="0"/>
              <a:t>MDA-MB-468 </a:t>
            </a:r>
            <a:r>
              <a:rPr lang="en-US" sz="1200" b="1" dirty="0"/>
              <a:t>cells treated with AnAc using metabolites identified in Volcano Plots in </a:t>
            </a:r>
            <a:r>
              <a:rPr lang="en-US" sz="1200" b="1" dirty="0" smtClean="0"/>
              <a:t>MetaboAnalyst: C) </a:t>
            </a:r>
            <a:r>
              <a:rPr lang="en-US" sz="1200" b="1" dirty="0"/>
              <a:t>“Signal transduction_Role of Sphingosine 1-phosphate as an intracellular mediator” </a:t>
            </a:r>
            <a:r>
              <a:rPr lang="en-US" sz="1200" b="1" dirty="0" smtClean="0"/>
              <a:t>and </a:t>
            </a:r>
            <a:r>
              <a:rPr lang="en-US" sz="1200" b="1" dirty="0"/>
              <a:t>D</a:t>
            </a:r>
            <a:r>
              <a:rPr lang="en-US" sz="1200" b="1" dirty="0" smtClean="0"/>
              <a:t>) </a:t>
            </a:r>
            <a:r>
              <a:rPr lang="en-US" sz="1200" b="1" dirty="0"/>
              <a:t>“Apoptosis and survival_Ubiquitination and phosphorylation in TNF-alpha-induced NF-kB signaling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etabolites with a ‘blue thermometer’ indicate metabolite sphingosine that was decreased by AnAc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in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MDA-MB-468 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21" y="605837"/>
            <a:ext cx="4098673" cy="331440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21245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407964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593872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78500" y="5309618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4A and B: Pathway </a:t>
            </a:r>
            <a:r>
              <a:rPr lang="en-US" sz="1200" b="1" dirty="0"/>
              <a:t>Maps </a:t>
            </a:r>
            <a:r>
              <a:rPr lang="en-US" sz="1200" b="1" dirty="0" smtClean="0"/>
              <a:t>from integrating metabolomics and RNA-seq analysis of AnAc-treated MCF-7 cells. A</a:t>
            </a:r>
            <a:r>
              <a:rPr lang="en-US" sz="1200" b="1" dirty="0"/>
              <a:t>) “Regulation of lipid metabolism_Fatty acid-dependent regulation of lipidic metabolism”. </a:t>
            </a:r>
            <a:r>
              <a:rPr lang="en-US" sz="1200" b="1" dirty="0" smtClean="0"/>
              <a:t>B</a:t>
            </a:r>
            <a:r>
              <a:rPr lang="en-US" sz="1200" b="1" dirty="0"/>
              <a:t>) “Signal transduction_mTORC1 downstream signaling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objects with a ‘red or blue thermometer’ indicating metabolites or mRNA transcripts that were increased or decreased, respectively, by AnAc treatment in MCF-7 cells.</a:t>
            </a:r>
            <a:endParaRPr lang="en-US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321245" y="3506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397293" y="350626"/>
            <a:ext cx="316002" cy="308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23" y="658403"/>
            <a:ext cx="4144125" cy="3200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7294" y="658403"/>
            <a:ext cx="4450154" cy="4651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2408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7131" y="332509"/>
            <a:ext cx="6424700" cy="5710844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7292861" y="1897912"/>
            <a:ext cx="133981" cy="5635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3" name="TextBox 2"/>
          <p:cNvSpPr txBox="1"/>
          <p:nvPr/>
        </p:nvSpPr>
        <p:spPr>
          <a:xfrm>
            <a:off x="7205561" y="1819571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AnAc</a:t>
            </a:r>
            <a:endParaRPr lang="en-US" sz="1100" dirty="0"/>
          </a:p>
        </p:txBody>
      </p:sp>
      <p:sp>
        <p:nvSpPr>
          <p:cNvPr id="4" name="TextBox 3"/>
          <p:cNvSpPr txBox="1"/>
          <p:nvPr/>
        </p:nvSpPr>
        <p:spPr>
          <a:xfrm>
            <a:off x="7205561" y="2096569"/>
            <a:ext cx="5517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AnAc</a:t>
            </a:r>
            <a:endParaRPr lang="en-US" sz="1100" dirty="0"/>
          </a:p>
        </p:txBody>
      </p:sp>
      <p:sp>
        <p:nvSpPr>
          <p:cNvPr id="5" name="TextBox 4"/>
          <p:cNvSpPr txBox="1"/>
          <p:nvPr/>
        </p:nvSpPr>
        <p:spPr>
          <a:xfrm>
            <a:off x="7202373" y="1958070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Control</a:t>
            </a:r>
            <a:endParaRPr lang="en-US" sz="1100" dirty="0"/>
          </a:p>
        </p:txBody>
      </p:sp>
      <p:sp>
        <p:nvSpPr>
          <p:cNvPr id="6" name="TextBox 5"/>
          <p:cNvSpPr txBox="1"/>
          <p:nvPr/>
        </p:nvSpPr>
        <p:spPr>
          <a:xfrm>
            <a:off x="7202373" y="2256332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Control</a:t>
            </a:r>
            <a:endParaRPr lang="en-US" sz="1100" dirty="0"/>
          </a:p>
        </p:txBody>
      </p:sp>
      <p:sp>
        <p:nvSpPr>
          <p:cNvPr id="10" name="Rectangle 9"/>
          <p:cNvSpPr/>
          <p:nvPr/>
        </p:nvSpPr>
        <p:spPr>
          <a:xfrm>
            <a:off x="7099985" y="1335236"/>
            <a:ext cx="361507" cy="2551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7003927" y="1249902"/>
            <a:ext cx="5229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AnAc</a:t>
            </a:r>
            <a:endParaRPr lang="en-US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7000739" y="1388401"/>
            <a:ext cx="6399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Control</a:t>
            </a:r>
            <a:endParaRPr lang="en-US" sz="1100" dirty="0"/>
          </a:p>
        </p:txBody>
      </p:sp>
      <p:sp>
        <p:nvSpPr>
          <p:cNvPr id="13" name="Rectangle 5"/>
          <p:cNvSpPr>
            <a:spLocks noChangeArrowheads="1"/>
          </p:cNvSpPr>
          <p:nvPr/>
        </p:nvSpPr>
        <p:spPr bwMode="auto">
          <a:xfrm>
            <a:off x="345299" y="6158176"/>
            <a:ext cx="831212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upplementary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igure 2: </a:t>
            </a:r>
            <a:r>
              <a:rPr lang="en-US" altLang="en-US" sz="1000" b="1" dirty="0" smtClean="0"/>
              <a:t>PCA analysis of all 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dentified metabolites from the control (EtOH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)- 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nd 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nAc- 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reated cell lines.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ach </a:t>
            </a:r>
            <a:r>
              <a:rPr lang="en-US" altLang="en-US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BC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ell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ine was grown in 5% DCC-FBS-phenol red-free IMEM for 48 h prior to 24 h treatment with EtOH (vehicle control) or AnAc. There are five biological replicates/cell line.  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118334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03480" y="5405120"/>
            <a:ext cx="8077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</a:t>
            </a:r>
            <a:r>
              <a:rPr lang="en-US" sz="1200" b="1" dirty="0" smtClean="0"/>
              <a:t>15: SCD (SCD1) </a:t>
            </a:r>
            <a:r>
              <a:rPr lang="en-US" sz="1200" b="1" dirty="0"/>
              <a:t>protein abundance in control 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(EtOH) and AnAc-treated 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MDA-MB-231, MDA-MB-468, and MCF-7 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BC cells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 The cells were treated with vehicle control (EtOH), indicated by the minus (-) sign or with the indicated </a:t>
            </a:r>
            <a:r>
              <a:rPr lang="el-GR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μ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M concentrations of </a:t>
            </a:r>
            <a:r>
              <a:rPr lang="en-US" altLang="en-US" sz="1200" dirty="0" err="1">
                <a:solidFill>
                  <a:srgbClr val="000000"/>
                </a:solidFill>
                <a:cs typeface="Arial" panose="020B0604020202020204" pitchFamily="34" charset="0"/>
              </a:rPr>
              <a:t>AnAc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 for 48 h prior to western blot. 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blots were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stained with Ponceau S for normalization.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values of the SCD bands were normalized to the signal intensity in the Ponceau S stained blot for each land and then the average of the two control (EtOH (-)) lanes was set to one for normalization of SCD in each cell line.  </a:t>
            </a:r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5479" y="803488"/>
            <a:ext cx="5076514" cy="215389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3037" y="3131312"/>
            <a:ext cx="5134703" cy="20998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871031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6105" y="426074"/>
            <a:ext cx="3960615" cy="426022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493780" y="5583938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6A and B: Top 2 Pathway </a:t>
            </a:r>
            <a:r>
              <a:rPr lang="en-US" sz="1200" b="1" dirty="0"/>
              <a:t>Maps </a:t>
            </a:r>
            <a:r>
              <a:rPr lang="en-US" sz="1200" b="1" dirty="0" smtClean="0"/>
              <a:t>from integrating metabolomics and RNA-seq analysis of AnAc-treated MDA-MB-231 cells. A</a:t>
            </a:r>
            <a:r>
              <a:rPr lang="en-US" sz="1200" b="1" dirty="0"/>
              <a:t>) </a:t>
            </a:r>
            <a:r>
              <a:rPr lang="en-US" sz="1200" b="1" dirty="0" smtClean="0"/>
              <a:t>“Signal </a:t>
            </a:r>
            <a:r>
              <a:rPr lang="en-US" sz="1200" b="1" dirty="0"/>
              <a:t>transduction_Amino acid-dependent mTORC1 </a:t>
            </a:r>
            <a:r>
              <a:rPr lang="en-US" sz="1200" b="1" dirty="0" smtClean="0"/>
              <a:t>activation”. B</a:t>
            </a:r>
            <a:r>
              <a:rPr lang="en-US" sz="1200" b="1" dirty="0"/>
              <a:t>) “Mechanisms of drug resistance in multiple myeloma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objects with a ‘red thermometer’ or ‘blue thermometer’ indicate metabolites or mRNA transcripts that were respectively increased or decreased by AnAc treatment in MDA-MB-231 cells.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1245" y="4146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673245" y="4146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755" y="414645"/>
            <a:ext cx="4037490" cy="50692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00910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673" y="681804"/>
            <a:ext cx="4053680" cy="436033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3317" y="681804"/>
            <a:ext cx="4395442" cy="300073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04717" y="5118103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6C and D: Pathways 3 and 4 in Pathway </a:t>
            </a:r>
            <a:r>
              <a:rPr lang="en-US" sz="1200" b="1" dirty="0"/>
              <a:t>Maps </a:t>
            </a:r>
            <a:r>
              <a:rPr lang="en-US" sz="1200" b="1" dirty="0" smtClean="0"/>
              <a:t>from integrating metabolomics and RNA-seq analysis of AnAc-treated MDA-MB-231 cells. C) “Urea Cycle”. C) “</a:t>
            </a:r>
            <a:r>
              <a:rPr lang="en-US" sz="1200" b="1" i="1" dirty="0" smtClean="0"/>
              <a:t>De novo </a:t>
            </a:r>
            <a:r>
              <a:rPr lang="en-US" sz="1200" b="1" dirty="0" smtClean="0"/>
              <a:t>IMP Biosynthesis”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Th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objects with a ‘red thermometer’ or ‘blue thermometer’ indicate metabolites or mRNA transcripts that were respectively increased or decreased by AnAc treatment in MDA-MB-231 cells.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21245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673245" y="6058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748790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ounded Rectangle 1"/>
          <p:cNvSpPr/>
          <p:nvPr/>
        </p:nvSpPr>
        <p:spPr>
          <a:xfrm>
            <a:off x="2716800" y="1085558"/>
            <a:ext cx="2120188" cy="533801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3" name="TextBox 2"/>
          <p:cNvSpPr txBox="1"/>
          <p:nvPr/>
        </p:nvSpPr>
        <p:spPr>
          <a:xfrm>
            <a:off x="2649306" y="1096129"/>
            <a:ext cx="221727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5 BC cell lines</a:t>
            </a:r>
          </a:p>
          <a:p>
            <a:pPr algn="ctr"/>
            <a:r>
              <a:rPr lang="en-US" sz="1050" dirty="0"/>
              <a:t>+/- EtOH (vehicle control) or AnAc</a:t>
            </a:r>
          </a:p>
          <a:p>
            <a:pPr algn="ctr"/>
            <a:r>
              <a:rPr lang="en-US" sz="900" dirty="0"/>
              <a:t>(five biological replicates) </a:t>
            </a:r>
          </a:p>
        </p:txBody>
      </p:sp>
      <p:sp>
        <p:nvSpPr>
          <p:cNvPr id="6" name="Right Arrow 5"/>
          <p:cNvSpPr/>
          <p:nvPr/>
        </p:nvSpPr>
        <p:spPr>
          <a:xfrm rot="5400000">
            <a:off x="3530022" y="1666504"/>
            <a:ext cx="344446" cy="247892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7" name="Rectangle 6"/>
          <p:cNvSpPr/>
          <p:nvPr/>
        </p:nvSpPr>
        <p:spPr>
          <a:xfrm>
            <a:off x="3776893" y="1599210"/>
            <a:ext cx="447558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50" dirty="0"/>
              <a:t>24 h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304178" y="1962620"/>
            <a:ext cx="846707" cy="25391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050" dirty="0"/>
              <a:t>Cell pellets</a:t>
            </a:r>
          </a:p>
        </p:txBody>
      </p:sp>
      <p:sp>
        <p:nvSpPr>
          <p:cNvPr id="10" name="Right Arrow 9"/>
          <p:cNvSpPr/>
          <p:nvPr/>
        </p:nvSpPr>
        <p:spPr>
          <a:xfrm rot="5400000">
            <a:off x="3549901" y="2226641"/>
            <a:ext cx="301985" cy="24519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1" name="TextBox 10"/>
          <p:cNvSpPr txBox="1"/>
          <p:nvPr/>
        </p:nvSpPr>
        <p:spPr>
          <a:xfrm>
            <a:off x="2825492" y="2500228"/>
            <a:ext cx="1750800" cy="41549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GC/MS vs. standards</a:t>
            </a:r>
          </a:p>
          <a:p>
            <a:pPr algn="ctr"/>
            <a:r>
              <a:rPr lang="en-US" sz="1050" dirty="0"/>
              <a:t>West Coast Metabolomics</a:t>
            </a:r>
          </a:p>
        </p:txBody>
      </p:sp>
      <p:sp>
        <p:nvSpPr>
          <p:cNvPr id="12" name="Right Arrow 11"/>
          <p:cNvSpPr/>
          <p:nvPr/>
        </p:nvSpPr>
        <p:spPr>
          <a:xfrm rot="5400000">
            <a:off x="3540286" y="2928644"/>
            <a:ext cx="301985" cy="24519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13" name="TextBox 12"/>
          <p:cNvSpPr txBox="1"/>
          <p:nvPr/>
        </p:nvSpPr>
        <p:spPr>
          <a:xfrm>
            <a:off x="3088180" y="3214727"/>
            <a:ext cx="109998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/>
              <a:t>Metabolites</a:t>
            </a:r>
            <a:endParaRPr lang="en-US" sz="1400" dirty="0"/>
          </a:p>
        </p:txBody>
      </p:sp>
      <p:cxnSp>
        <p:nvCxnSpPr>
          <p:cNvPr id="17" name="Straight Arrow Connector 16"/>
          <p:cNvCxnSpPr>
            <a:endCxn id="19" idx="0"/>
          </p:cNvCxnSpPr>
          <p:nvPr/>
        </p:nvCxnSpPr>
        <p:spPr>
          <a:xfrm flipH="1">
            <a:off x="3213140" y="3562829"/>
            <a:ext cx="216" cy="252219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680821" y="3803298"/>
            <a:ext cx="107753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Metabolomes</a:t>
            </a:r>
          </a:p>
          <a:p>
            <a:pPr algn="ctr"/>
            <a:r>
              <a:rPr lang="en-US" sz="1050" dirty="0"/>
              <a:t>MetaboAnalyst</a:t>
            </a:r>
          </a:p>
        </p:txBody>
      </p:sp>
      <p:sp>
        <p:nvSpPr>
          <p:cNvPr id="19" name="Oval 18"/>
          <p:cNvSpPr/>
          <p:nvPr/>
        </p:nvSpPr>
        <p:spPr>
          <a:xfrm>
            <a:off x="2602792" y="3815048"/>
            <a:ext cx="1220697" cy="384806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1" name="Rounded Rectangle 20"/>
          <p:cNvSpPr/>
          <p:nvPr/>
        </p:nvSpPr>
        <p:spPr>
          <a:xfrm>
            <a:off x="1763294" y="2078036"/>
            <a:ext cx="1025210" cy="554407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2" name="TextBox 21"/>
          <p:cNvSpPr txBox="1"/>
          <p:nvPr/>
        </p:nvSpPr>
        <p:spPr>
          <a:xfrm>
            <a:off x="4155207" y="3819259"/>
            <a:ext cx="99578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Metabolomes</a:t>
            </a:r>
          </a:p>
          <a:p>
            <a:pPr algn="ctr"/>
            <a:r>
              <a:rPr lang="en-US" sz="1050" dirty="0"/>
              <a:t>MetaCore</a:t>
            </a: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4440863" y="3562829"/>
            <a:ext cx="0" cy="24373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Oval 23"/>
          <p:cNvSpPr/>
          <p:nvPr/>
        </p:nvSpPr>
        <p:spPr>
          <a:xfrm>
            <a:off x="4036326" y="3794821"/>
            <a:ext cx="1123061" cy="429549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cxnSp>
        <p:nvCxnSpPr>
          <p:cNvPr id="25" name="Straight Arrow Connector 24"/>
          <p:cNvCxnSpPr/>
          <p:nvPr/>
        </p:nvCxnSpPr>
        <p:spPr>
          <a:xfrm flipV="1">
            <a:off x="3660653" y="4013272"/>
            <a:ext cx="520442" cy="1421"/>
          </a:xfrm>
          <a:prstGeom prst="straightConnector1">
            <a:avLst/>
          </a:prstGeom>
          <a:ln w="19050">
            <a:solidFill>
              <a:schemeClr val="tx1"/>
            </a:solidFill>
            <a:headEnd type="arrow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3" idx="1"/>
            <a:endCxn id="29" idx="0"/>
          </p:cNvCxnSpPr>
          <p:nvPr/>
        </p:nvCxnSpPr>
        <p:spPr>
          <a:xfrm rot="10800000" flipV="1">
            <a:off x="2279614" y="1361586"/>
            <a:ext cx="399284" cy="716858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680731" y="2078445"/>
            <a:ext cx="1197765" cy="57708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50" dirty="0"/>
              <a:t>RNA </a:t>
            </a:r>
            <a:r>
              <a:rPr lang="en-US" sz="1050" dirty="0" err="1"/>
              <a:t>seq</a:t>
            </a:r>
            <a:endParaRPr lang="en-US" sz="1050" dirty="0"/>
          </a:p>
          <a:p>
            <a:pPr algn="ctr"/>
            <a:r>
              <a:rPr lang="en-US" sz="1050" dirty="0"/>
              <a:t>GSE78011</a:t>
            </a:r>
          </a:p>
          <a:p>
            <a:pPr algn="ctr"/>
            <a:r>
              <a:rPr lang="en-US" sz="1050" dirty="0"/>
              <a:t>PMID: 29795261</a:t>
            </a:r>
          </a:p>
        </p:txBody>
      </p:sp>
      <p:cxnSp>
        <p:nvCxnSpPr>
          <p:cNvPr id="33" name="Elbow Connector 32"/>
          <p:cNvCxnSpPr/>
          <p:nvPr/>
        </p:nvCxnSpPr>
        <p:spPr>
          <a:xfrm rot="16200000" flipH="1">
            <a:off x="1733406" y="3164178"/>
            <a:ext cx="1375009" cy="323178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2259321" y="4013271"/>
            <a:ext cx="0" cy="3727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2259321" y="4391784"/>
            <a:ext cx="2171989" cy="215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V="1">
            <a:off x="4431310" y="4235167"/>
            <a:ext cx="0" cy="1566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4666254" y="4221254"/>
            <a:ext cx="136619" cy="1238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4440864" y="4279424"/>
            <a:ext cx="86433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SCD western</a:t>
            </a:r>
          </a:p>
        </p:txBody>
      </p:sp>
      <p:sp>
        <p:nvSpPr>
          <p:cNvPr id="51" name="Rectangle 50"/>
          <p:cNvSpPr/>
          <p:nvPr/>
        </p:nvSpPr>
        <p:spPr>
          <a:xfrm>
            <a:off x="1993232" y="4626332"/>
            <a:ext cx="3396092" cy="415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50" b="1" dirty="0"/>
              <a:t>Supplementary Figure 17: Flowchart of the experimental design.</a:t>
            </a:r>
            <a:endParaRPr lang="en-US" sz="1050" dirty="0"/>
          </a:p>
        </p:txBody>
      </p:sp>
      <p:sp>
        <p:nvSpPr>
          <p:cNvPr id="63" name="Rounded Rectangle 62"/>
          <p:cNvSpPr/>
          <p:nvPr/>
        </p:nvSpPr>
        <p:spPr>
          <a:xfrm>
            <a:off x="2868321" y="3202233"/>
            <a:ext cx="1797934" cy="3615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</p:spTree>
    <p:extLst>
      <p:ext uri="{BB962C8B-B14F-4D97-AF65-F5344CB8AC3E}">
        <p14:creationId xmlns:p14="http://schemas.microsoft.com/office/powerpoint/2010/main" val="4611969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ChangeArrowheads="1"/>
          </p:cNvSpPr>
          <p:nvPr/>
        </p:nvSpPr>
        <p:spPr bwMode="auto">
          <a:xfrm>
            <a:off x="345299" y="6158176"/>
            <a:ext cx="831212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upplementary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Figure 3: </a:t>
            </a:r>
            <a:r>
              <a:rPr lang="en-US" altLang="en-US" sz="1000" b="1" dirty="0" smtClean="0"/>
              <a:t>Heatmap </a:t>
            </a:r>
            <a:r>
              <a:rPr kumimoji="0" lang="en-US" altLang="en-US" sz="1000" b="1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f all identified metabolites from the control (EtOH) and AnAc treated cell lines.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ach </a:t>
            </a:r>
            <a:r>
              <a:rPr lang="en-US" altLang="en-US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BC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ell </a:t>
            </a:r>
            <a:r>
              <a:rPr kumimoji="0" lang="en-US" altLang="en-US" sz="100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ine was grown in 5% DCC-FBS-phenol red-free IMEM for 48 h prior to 24 h treatment with EtOH (vehicle control) or AnAc. </a:t>
            </a:r>
            <a:endParaRPr kumimoji="0" lang="en-US" altLang="en-US" sz="10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1361" y="676274"/>
            <a:ext cx="4505325" cy="450532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964" y="676273"/>
            <a:ext cx="4505325" cy="45053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79940" y="409573"/>
            <a:ext cx="15240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ntrol EtOH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172200" y="400049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nAc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010620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25" y="717350"/>
            <a:ext cx="4086225" cy="40862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95325" y="4891385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4: Variable importance plot (</a:t>
            </a:r>
            <a:r>
              <a:rPr lang="en-US" sz="1200" b="1" dirty="0" smtClean="0"/>
              <a:t>VIP) </a:t>
            </a:r>
            <a:r>
              <a:rPr lang="en-US" sz="1200" b="1" dirty="0" smtClean="0"/>
              <a:t>of top 15 metabolites identified in OPLS-DA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of metabolites from the control (EtOH) and 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AnAc-treated BC cell lines in MetaboAnalyst 6.0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plots are based on component 1 (metabolites increased with AnAc treatment).  The top metabolites contribute more to the model than the bottom ones.  </a:t>
            </a:r>
            <a:endParaRPr lang="en-US" sz="12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1731" y="717350"/>
            <a:ext cx="4096494" cy="409649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389465" y="572985"/>
            <a:ext cx="15240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Control EtOH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6181725" y="563461"/>
            <a:ext cx="800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AnAc</a:t>
            </a:r>
            <a:endParaRPr lang="en-US" sz="1400" b="1" dirty="0"/>
          </a:p>
        </p:txBody>
      </p:sp>
      <p:sp>
        <p:nvSpPr>
          <p:cNvPr id="13" name="Rectangle 12"/>
          <p:cNvSpPr/>
          <p:nvPr/>
        </p:nvSpPr>
        <p:spPr>
          <a:xfrm>
            <a:off x="4751416" y="1791929"/>
            <a:ext cx="639119" cy="1696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4621149" y="1722843"/>
            <a:ext cx="899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i="1" dirty="0" smtClean="0"/>
              <a:t>trans</a:t>
            </a:r>
            <a:r>
              <a:rPr lang="en-US" sz="700" dirty="0" smtClean="0"/>
              <a:t>-4-hydroxyproline</a:t>
            </a:r>
            <a:endParaRPr lang="en-US" sz="700" dirty="0"/>
          </a:p>
        </p:txBody>
      </p:sp>
      <p:sp>
        <p:nvSpPr>
          <p:cNvPr id="15" name="Rectangle 14"/>
          <p:cNvSpPr/>
          <p:nvPr/>
        </p:nvSpPr>
        <p:spPr>
          <a:xfrm>
            <a:off x="545689" y="1231490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352425" y="1197737"/>
            <a:ext cx="9621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/>
              <a:t>4-aminobutyric acid</a:t>
            </a:r>
          </a:p>
        </p:txBody>
      </p:sp>
      <p:sp>
        <p:nvSpPr>
          <p:cNvPr id="18" name="Rectangle 17"/>
          <p:cNvSpPr/>
          <p:nvPr/>
        </p:nvSpPr>
        <p:spPr>
          <a:xfrm>
            <a:off x="523565" y="1630357"/>
            <a:ext cx="648929" cy="1615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429968" y="1591874"/>
            <a:ext cx="8803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 smtClean="0"/>
              <a:t>phytosphingosine</a:t>
            </a:r>
            <a:endParaRPr lang="en-US" sz="700" dirty="0"/>
          </a:p>
        </p:txBody>
      </p:sp>
      <p:sp>
        <p:nvSpPr>
          <p:cNvPr id="20" name="Rectangle 19"/>
          <p:cNvSpPr/>
          <p:nvPr/>
        </p:nvSpPr>
        <p:spPr>
          <a:xfrm>
            <a:off x="545689" y="2581847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229344" y="2515406"/>
            <a:ext cx="10871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 smtClean="0"/>
              <a:t>2,5-dihydroxypyrazine </a:t>
            </a:r>
            <a:endParaRPr lang="en-US" sz="700" dirty="0"/>
          </a:p>
        </p:txBody>
      </p:sp>
      <p:sp>
        <p:nvSpPr>
          <p:cNvPr id="22" name="Rectangle 21"/>
          <p:cNvSpPr/>
          <p:nvPr/>
        </p:nvSpPr>
        <p:spPr>
          <a:xfrm>
            <a:off x="545687" y="3111044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352425" y="3095819"/>
            <a:ext cx="947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/>
              <a:t>ethanol phosphate </a:t>
            </a:r>
          </a:p>
        </p:txBody>
      </p:sp>
      <p:sp>
        <p:nvSpPr>
          <p:cNvPr id="23" name="Rectangle 22"/>
          <p:cNvSpPr/>
          <p:nvPr/>
        </p:nvSpPr>
        <p:spPr>
          <a:xfrm>
            <a:off x="4751416" y="2184509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" name="Rectangle 23"/>
          <p:cNvSpPr/>
          <p:nvPr/>
        </p:nvSpPr>
        <p:spPr>
          <a:xfrm>
            <a:off x="4646438" y="2154061"/>
            <a:ext cx="8803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 smtClean="0"/>
              <a:t>phytosphingosine</a:t>
            </a:r>
            <a:endParaRPr lang="en-US" sz="700" dirty="0"/>
          </a:p>
        </p:txBody>
      </p:sp>
      <p:sp>
        <p:nvSpPr>
          <p:cNvPr id="25" name="Rectangle 24"/>
          <p:cNvSpPr/>
          <p:nvPr/>
        </p:nvSpPr>
        <p:spPr>
          <a:xfrm>
            <a:off x="4767898" y="2551594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>
            <a:off x="4589913" y="2536369"/>
            <a:ext cx="96212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/>
              <a:t>4-aminobutyric acid</a:t>
            </a:r>
          </a:p>
        </p:txBody>
      </p:sp>
      <p:sp>
        <p:nvSpPr>
          <p:cNvPr id="28" name="Rectangle 27"/>
          <p:cNvSpPr/>
          <p:nvPr/>
        </p:nvSpPr>
        <p:spPr>
          <a:xfrm>
            <a:off x="4783065" y="2720706"/>
            <a:ext cx="648929" cy="1696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>
            <a:off x="4503406" y="2705481"/>
            <a:ext cx="105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 dirty="0"/>
              <a:t>2-hydroxyglutaric aci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3523" y="5734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A</a:t>
            </a:r>
            <a:endParaRPr lang="en-US" sz="1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751416" y="573448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B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45132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51080" y="5252720"/>
            <a:ext cx="8077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5: </a:t>
            </a:r>
            <a:r>
              <a:rPr lang="en-US" sz="1200" b="1" dirty="0" smtClean="0"/>
              <a:t>VIP </a:t>
            </a:r>
            <a:r>
              <a:rPr lang="en-US" sz="1200" b="1" dirty="0" smtClean="0"/>
              <a:t>and Enrichment Analysis of the top 15 metabolites identified in OPLS-DA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of metabolites from the control (EtOH) and 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AnAc-treated MCF-7 and HCC1806 cell lines analyzed by MetaboAnalyst 6.0 software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VIP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re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based on component 1 (C1, metabolites increased with AnAc treatment) or component 2 (C2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, metabolites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decreased)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with AnAc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reatment (A,B,D,E0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top metabolites contribute more to the model than the bottom ones.  The Enrichment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nalysis (C and F)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included metabolites increased or decreased in each cell line after AnAc treatment. </a:t>
            </a:r>
            <a:endParaRPr lang="en-US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1198" y="380572"/>
            <a:ext cx="2368571" cy="240015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497" y="443632"/>
            <a:ext cx="2247510" cy="231330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633" y="623807"/>
            <a:ext cx="182880" cy="100888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35923" y="563228"/>
            <a:ext cx="9774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CF-7 C1 UP AnAc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458043" y="500168"/>
            <a:ext cx="1051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CF-7 </a:t>
            </a:r>
          </a:p>
          <a:p>
            <a:r>
              <a:rPr lang="en-US" sz="1200" b="1" dirty="0" smtClean="0"/>
              <a:t>C2 DOWN</a:t>
            </a:r>
          </a:p>
          <a:p>
            <a:r>
              <a:rPr lang="en-US" sz="1200" b="1" dirty="0" smtClean="0"/>
              <a:t>AnAc</a:t>
            </a:r>
            <a:endParaRPr lang="en-US" sz="1200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8907" y="2861357"/>
            <a:ext cx="2374709" cy="240015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433510" y="2974091"/>
            <a:ext cx="1051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CC1806 C2 DOWN AnAc</a:t>
            </a:r>
            <a:endParaRPr lang="en-US" sz="1200" b="1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011" y="2963670"/>
            <a:ext cx="2265705" cy="2246824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207340" y="3166230"/>
            <a:ext cx="105104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HCC1806 C1 UP AnAc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45947" y="3633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2999022" y="3633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5397341" y="3633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081228" y="28336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35638" y="283365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397341" y="283365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</a:t>
            </a:r>
            <a:endParaRPr lang="en-US" sz="1400" b="1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1851" y="363352"/>
            <a:ext cx="2096183" cy="2572352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5426651" y="623807"/>
            <a:ext cx="79121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MCF-7: Up + Down</a:t>
            </a:r>
            <a:endParaRPr lang="en-US" sz="1000" b="1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6019" y="2935704"/>
            <a:ext cx="1773393" cy="2216741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352667" y="3117675"/>
            <a:ext cx="93095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HCC1806: Up + Down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5204097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7512" y="2837302"/>
            <a:ext cx="2345334" cy="2403243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0767" y="457694"/>
            <a:ext cx="2334932" cy="236952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3279" y="484317"/>
            <a:ext cx="2320990" cy="2335317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9140" y="2828546"/>
            <a:ext cx="2417969" cy="241199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51080" y="5252720"/>
            <a:ext cx="8077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6: </a:t>
            </a:r>
            <a:r>
              <a:rPr lang="en-US" sz="1200" b="1" dirty="0" smtClean="0"/>
              <a:t>VIP of </a:t>
            </a:r>
            <a:r>
              <a:rPr lang="en-US" sz="1200" b="1" dirty="0" smtClean="0"/>
              <a:t>the top 15 metabolites identified in OPLS-DA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 </a:t>
            </a:r>
            <a:r>
              <a:rPr lang="en-US" altLang="en-US" sz="1200" b="1" dirty="0">
                <a:solidFill>
                  <a:srgbClr val="000000"/>
                </a:solidFill>
                <a:cs typeface="Arial" panose="020B0604020202020204" pitchFamily="34" charset="0"/>
              </a:rPr>
              <a:t>of metabolites from the control (EtOH) and 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AnAc-treated BT-20, MDA-MB-231, and MDA-MB-468 cell lines analyzed by MetaboAnalyst 6.0 software  </a:t>
            </a:r>
            <a:r>
              <a:rPr lang="en-US" altLang="en-US" sz="1200" smtClean="0">
                <a:solidFill>
                  <a:srgbClr val="000000"/>
                </a:solidFill>
                <a:cs typeface="Arial" panose="020B0604020202020204" pitchFamily="34" charset="0"/>
              </a:rPr>
              <a:t>The </a:t>
            </a:r>
            <a:r>
              <a:rPr lang="en-US" altLang="en-US" sz="1200" smtClean="0">
                <a:solidFill>
                  <a:srgbClr val="000000"/>
                </a:solidFill>
                <a:cs typeface="Arial" panose="020B0604020202020204" pitchFamily="34" charset="0"/>
              </a:rPr>
              <a:t>plots (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-F)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re based on component 1 (C1, metabolites increased with AnAc treatment) or component 2 (C2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, metabolites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decreased)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with AnAc treatment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top metabolites contribute more to the model than the bottom ones.  </a:t>
            </a:r>
            <a:endParaRPr lang="en-US" sz="12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080" y="616433"/>
            <a:ext cx="182880" cy="100888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687545" y="2906422"/>
            <a:ext cx="11351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DA-MB-231 </a:t>
            </a:r>
            <a:r>
              <a:rPr lang="en-US" sz="1200" b="1" dirty="0" smtClean="0"/>
              <a:t>C2 DOWN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687545" y="568634"/>
            <a:ext cx="11351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DA-MB-231 C1 UP</a:t>
            </a:r>
            <a:endParaRPr lang="en-US" sz="1200" b="1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463" y="486907"/>
            <a:ext cx="2362503" cy="233625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287" y="2828546"/>
            <a:ext cx="2346853" cy="238741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376964" y="568634"/>
            <a:ext cx="11026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BT-20</a:t>
            </a:r>
          </a:p>
          <a:p>
            <a:r>
              <a:rPr lang="en-US" sz="1200" b="1" dirty="0" smtClean="0"/>
              <a:t>C1 </a:t>
            </a:r>
            <a:r>
              <a:rPr lang="en-US" sz="1200" b="1" dirty="0"/>
              <a:t>U</a:t>
            </a:r>
            <a:r>
              <a:rPr lang="en-US" sz="1200" b="1" dirty="0" smtClean="0"/>
              <a:t>P</a:t>
            </a:r>
            <a:endParaRPr 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309066" y="2941994"/>
            <a:ext cx="105104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BT-20 </a:t>
            </a:r>
          </a:p>
          <a:p>
            <a:r>
              <a:rPr lang="en-US" sz="1200" b="1" dirty="0" smtClean="0"/>
              <a:t>C2 DOWN</a:t>
            </a:r>
            <a:endParaRPr 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52394" y="4310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08150" y="279859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298393" y="4310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298393" y="27881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5722046" y="4310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E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722046" y="279302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6226825" y="568633"/>
            <a:ext cx="11351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DA-MB-468 C1 UP</a:t>
            </a:r>
            <a:endParaRPr lang="en-US" sz="12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6226825" y="2947336"/>
            <a:ext cx="11351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MDA-MB-468 C2 DOWN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2813671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316" y="946258"/>
            <a:ext cx="2829337" cy="352107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6574" y="1264927"/>
            <a:ext cx="2067210" cy="278004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867" y="954531"/>
            <a:ext cx="2841819" cy="351280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82607" y="4956477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7: Enrichment Analysis of metabolites significantly altered by AnAc treatment of BT-20, MDA-MB-231, 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and MDA-MB-468 cell lines analyzed by MetaboAnalyst 6.0 software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Enrichment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analysis (A-C_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included metabolites increased or decreased in each cell line after AnAc versus EtOH (control) treatment (Table 3). </a:t>
            </a:r>
            <a:endParaRPr lang="en-US" sz="1200" dirty="0"/>
          </a:p>
        </p:txBody>
      </p:sp>
      <p:sp>
        <p:nvSpPr>
          <p:cNvPr id="4" name="Rectangle 3"/>
          <p:cNvSpPr/>
          <p:nvPr/>
        </p:nvSpPr>
        <p:spPr>
          <a:xfrm>
            <a:off x="311444" y="864817"/>
            <a:ext cx="102185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BT-20: AnAc Up + Down</a:t>
            </a:r>
            <a:endParaRPr lang="en-US" sz="10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13719" y="8006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061686" y="8006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177100" y="8006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</a:t>
            </a:r>
            <a:endParaRPr lang="en-US" sz="1400" b="1" dirty="0"/>
          </a:p>
        </p:txBody>
      </p:sp>
      <p:sp>
        <p:nvSpPr>
          <p:cNvPr id="8" name="Rectangle 7"/>
          <p:cNvSpPr/>
          <p:nvPr/>
        </p:nvSpPr>
        <p:spPr>
          <a:xfrm>
            <a:off x="3263759" y="864817"/>
            <a:ext cx="129992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MDA-MB-231: AnAc Up + Down</a:t>
            </a:r>
            <a:endParaRPr lang="en-US" sz="1000" b="1" dirty="0"/>
          </a:p>
        </p:txBody>
      </p:sp>
      <p:sp>
        <p:nvSpPr>
          <p:cNvPr id="13" name="Rectangle 12"/>
          <p:cNvSpPr/>
          <p:nvPr/>
        </p:nvSpPr>
        <p:spPr>
          <a:xfrm>
            <a:off x="6383020" y="881392"/>
            <a:ext cx="141431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/>
              <a:t>MDA-MB-468: AnAc Up + Down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9869740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72" y="1184564"/>
            <a:ext cx="3758629" cy="3703701"/>
          </a:xfrm>
          <a:prstGeom prst="rect">
            <a:avLst/>
          </a:prstGeom>
          <a:solidFill>
            <a:schemeClr val="bg1"/>
          </a:solidFill>
        </p:spPr>
      </p:pic>
      <p:cxnSp>
        <p:nvCxnSpPr>
          <p:cNvPr id="5" name="Straight Arrow Connector 4"/>
          <p:cNvCxnSpPr/>
          <p:nvPr/>
        </p:nvCxnSpPr>
        <p:spPr>
          <a:xfrm flipH="1">
            <a:off x="3361367" y="1959345"/>
            <a:ext cx="1055134" cy="36302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3061887" y="2985497"/>
            <a:ext cx="1289826" cy="4715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416501" y="1640693"/>
            <a:ext cx="2467382" cy="90024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b="1" dirty="0"/>
              <a:t>HCC1806 and BT-20</a:t>
            </a:r>
            <a:r>
              <a:rPr lang="en-US" sz="1050" dirty="0"/>
              <a:t>: Mechanisms of drug resistance in multiple myeloma; Influence of bone marrow cell environment on progression of multiple myelom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16500" y="3402645"/>
            <a:ext cx="2360373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b="1" dirty="0"/>
              <a:t>MCF-7, BT-20, and MDA-MB-231</a:t>
            </a:r>
            <a:r>
              <a:rPr lang="en-US" sz="1050" dirty="0"/>
              <a:t>: Signal transduction Amino acid-dependent mTORC1 activatio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416501" y="2592208"/>
            <a:ext cx="2467382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b="1" dirty="0"/>
              <a:t>MCF-7 and BT-20</a:t>
            </a:r>
            <a:r>
              <a:rPr lang="en-US" sz="1050" dirty="0"/>
              <a:t>: Metabolism in pancreatic cancer cells; Immune response: Distinct metabolic pathways in naive and effector CD8+ T cells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3541222" y="2889712"/>
            <a:ext cx="875279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101041" y="1376909"/>
            <a:ext cx="77938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HCC1806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161792" y="1910024"/>
            <a:ext cx="5966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/>
              <a:t>MCF-7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319824" y="4188811"/>
            <a:ext cx="781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MDA-MB-231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829847" y="4188811"/>
            <a:ext cx="78121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MDA-MB-468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36182" y="2261363"/>
            <a:ext cx="7097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BT-20</a:t>
            </a:r>
          </a:p>
        </p:txBody>
      </p:sp>
      <p:sp>
        <p:nvSpPr>
          <p:cNvPr id="15" name="Rectangle 14"/>
          <p:cNvSpPr/>
          <p:nvPr/>
        </p:nvSpPr>
        <p:spPr>
          <a:xfrm>
            <a:off x="582607" y="4956477"/>
            <a:ext cx="8077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8: Venn diagram of Pathway Maps for AnAc-regulated metabolites in the five BC cell lines</a:t>
            </a:r>
            <a:r>
              <a:rPr lang="en-US" altLang="en-US" sz="1200" b="1" dirty="0" smtClean="0">
                <a:solidFill>
                  <a:srgbClr val="000000"/>
                </a:solidFill>
                <a:cs typeface="Arial" panose="020B0604020202020204" pitchFamily="34" charset="0"/>
              </a:rPr>
              <a:t>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top ten Pathway Maps identified by MetaCore for each cell line were analyzed and plotted in </a:t>
            </a:r>
            <a:r>
              <a:rPr lang="en-US" sz="1200" dirty="0" smtClean="0">
                <a:solidFill>
                  <a:srgbClr val="00B0F0"/>
                </a:solidFill>
                <a:hlinkClick r:id="rId3"/>
              </a:rPr>
              <a:t>http</a:t>
            </a:r>
            <a:r>
              <a:rPr lang="en-US" sz="1200" dirty="0">
                <a:solidFill>
                  <a:srgbClr val="00B0F0"/>
                </a:solidFill>
                <a:hlinkClick r:id="rId3"/>
              </a:rPr>
              <a:t>://bioinformatics.psb.ugent.be/webtools/Venn</a:t>
            </a:r>
            <a:r>
              <a:rPr lang="en-US" sz="1200" dirty="0" smtClean="0">
                <a:solidFill>
                  <a:srgbClr val="00B0F0"/>
                </a:solidFill>
                <a:hlinkClick r:id="rId3"/>
              </a:rPr>
              <a:t>/</a:t>
            </a:r>
            <a:r>
              <a:rPr lang="en-US" sz="1200" dirty="0" smtClean="0"/>
              <a:t>.  The overlapping pathways are indicated.</a:t>
            </a:r>
            <a:endParaRPr lang="en-US" sz="1200" dirty="0">
              <a:solidFill>
                <a:srgbClr val="00B0F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066227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5022" y="5244011"/>
            <a:ext cx="80772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9A and B: Top 2 Pathway Maps for metabolites in AnAc-treated MCF-7 cells with AnAc: A) “Signal </a:t>
            </a:r>
            <a:r>
              <a:rPr lang="en-US" sz="1200" b="1" dirty="0"/>
              <a:t>transduction: Amino acid-dependent mTORC1 </a:t>
            </a:r>
            <a:r>
              <a:rPr lang="en-US" sz="1200" b="1" dirty="0" smtClean="0"/>
              <a:t>activation” and </a:t>
            </a:r>
            <a:r>
              <a:rPr lang="en-US" sz="1200" b="1" dirty="0"/>
              <a:t>B) </a:t>
            </a:r>
            <a:r>
              <a:rPr lang="en-US" sz="1200" b="1" dirty="0" smtClean="0"/>
              <a:t>“Glycine </a:t>
            </a:r>
            <a:r>
              <a:rPr lang="en-US" sz="1200" b="1" dirty="0"/>
              <a:t>and L-Serine </a:t>
            </a:r>
            <a:r>
              <a:rPr lang="en-US" sz="1200" b="1" dirty="0" smtClean="0"/>
              <a:t>metabolism”. 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The pathway maps were generated by MetaCore. </a:t>
            </a:r>
            <a:r>
              <a:rPr lang="en-US" altLang="en-US" sz="1200" dirty="0">
                <a:solidFill>
                  <a:srgbClr val="000000"/>
                </a:solidFill>
                <a:cs typeface="Arial" panose="020B0604020202020204" pitchFamily="34" charset="0"/>
              </a:rPr>
              <a:t>The Metabolites with a ‘red thermometer’ and ‘blue thermometer” indicate metabolites increased or decreased by AnAc </a:t>
            </a:r>
            <a:r>
              <a:rPr lang="en-US" altLang="en-US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in MCF-7 cells.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563" y="340575"/>
            <a:ext cx="3741305" cy="469733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3622" y="340575"/>
            <a:ext cx="4458704" cy="385857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7767" y="273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257990" y="273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197884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BCA9329D-D192-4B85-9B7D-AB0F8F5DAC87}" vid="{8367AD2A-BFF1-4023-BEDA-75D11CF27674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cmkArial</Template>
  <TotalTime>6980</TotalTime>
  <Words>2024</Words>
  <Application>Microsoft Office PowerPoint</Application>
  <PresentationFormat>On-screen Show (4:3)</PresentationFormat>
  <Paragraphs>223</Paragraphs>
  <Slides>2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Louisvil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inge,Carolyn M</dc:creator>
  <cp:lastModifiedBy>Klinge, Carolyn</cp:lastModifiedBy>
  <cp:revision>187</cp:revision>
  <dcterms:created xsi:type="dcterms:W3CDTF">2021-07-19T16:03:21Z</dcterms:created>
  <dcterms:modified xsi:type="dcterms:W3CDTF">2024-06-26T14:22:15Z</dcterms:modified>
</cp:coreProperties>
</file>